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2" r:id="rId2"/>
  </p:sldIdLst>
  <p:sldSz cx="9144000" cy="6858000" type="screen4x3"/>
  <p:notesSz cx="6858000" cy="987266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8777" autoAdjust="0"/>
    <p:restoredTop sz="99264" autoAdjust="0"/>
  </p:normalViewPr>
  <p:slideViewPr>
    <p:cSldViewPr>
      <p:cViewPr varScale="1">
        <p:scale>
          <a:sx n="98" d="100"/>
          <a:sy n="98" d="100"/>
        </p:scale>
        <p:origin x="-869" y="-6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5_7.xls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4_4.xls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4_4.xls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4_4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5_7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5_7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5_7.xls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5_7.xls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5_7.xls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4_4.xls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4_4.xls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4_4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DSC FST'!$P$10</c:f>
              <c:strCache>
                <c:ptCount val="1"/>
                <c:pt idx="0">
                  <c:v>ADSC  NORMA1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FST'!$Q$9:$W$9</c:f>
              <c:strCache>
                <c:ptCount val="7"/>
                <c:pt idx="0">
                  <c:v>CD105</c:v>
                </c:pt>
                <c:pt idx="1">
                  <c:v>CD73</c:v>
                </c:pt>
                <c:pt idx="2">
                  <c:v>CD90</c:v>
                </c:pt>
                <c:pt idx="3">
                  <c:v>CD36</c:v>
                </c:pt>
                <c:pt idx="4">
                  <c:v>CD29</c:v>
                </c:pt>
                <c:pt idx="5">
                  <c:v>CD44</c:v>
                </c:pt>
                <c:pt idx="6">
                  <c:v>VIM</c:v>
                </c:pt>
              </c:strCache>
            </c:strRef>
          </c:cat>
          <c:val>
            <c:numRef>
              <c:f>'ADSC FST'!$Q$10:$W$10</c:f>
              <c:numCache>
                <c:formatCode>General</c:formatCode>
                <c:ptCount val="7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FST'!$P$11</c:f>
              <c:strCache>
                <c:ptCount val="1"/>
                <c:pt idx="0">
                  <c:v>HMEC NORMA1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FST'!$Q$17:$W$17</c:f>
                <c:numCache>
                  <c:formatCode>General</c:formatCode>
                  <c:ptCount val="7"/>
                  <c:pt idx="0">
                    <c:v>3.2186845696887539E-3</c:v>
                  </c:pt>
                  <c:pt idx="1">
                    <c:v>2.2237295007655103E-2</c:v>
                  </c:pt>
                  <c:pt idx="2">
                    <c:v>1.4816633194029382E-2</c:v>
                  </c:pt>
                  <c:pt idx="3">
                    <c:v>4.5237079510631173E-5</c:v>
                  </c:pt>
                  <c:pt idx="4">
                    <c:v>0.1200652979303268</c:v>
                  </c:pt>
                  <c:pt idx="5">
                    <c:v>0.22844378624738337</c:v>
                  </c:pt>
                  <c:pt idx="6">
                    <c:v>3.7367851849234517E-2</c:v>
                  </c:pt>
                </c:numCache>
              </c:numRef>
            </c:plus>
            <c:minus>
              <c:numRef>
                <c:f>'ADSC FST'!$Q$17:$W$17</c:f>
                <c:numCache>
                  <c:formatCode>General</c:formatCode>
                  <c:ptCount val="7"/>
                  <c:pt idx="0">
                    <c:v>3.2186845696887539E-3</c:v>
                  </c:pt>
                  <c:pt idx="1">
                    <c:v>2.2237295007655103E-2</c:v>
                  </c:pt>
                  <c:pt idx="2">
                    <c:v>1.4816633194029382E-2</c:v>
                  </c:pt>
                  <c:pt idx="3">
                    <c:v>4.5237079510631173E-5</c:v>
                  </c:pt>
                  <c:pt idx="4">
                    <c:v>0.1200652979303268</c:v>
                  </c:pt>
                  <c:pt idx="5">
                    <c:v>0.22844378624738337</c:v>
                  </c:pt>
                  <c:pt idx="6">
                    <c:v>3.7367851849234517E-2</c:v>
                  </c:pt>
                </c:numCache>
              </c:numRef>
            </c:minus>
          </c:errBars>
          <c:cat>
            <c:strRef>
              <c:f>'ADSC FST'!$Q$9:$W$9</c:f>
              <c:strCache>
                <c:ptCount val="7"/>
                <c:pt idx="0">
                  <c:v>CD105</c:v>
                </c:pt>
                <c:pt idx="1">
                  <c:v>CD73</c:v>
                </c:pt>
                <c:pt idx="2">
                  <c:v>CD90</c:v>
                </c:pt>
                <c:pt idx="3">
                  <c:v>CD36</c:v>
                </c:pt>
                <c:pt idx="4">
                  <c:v>CD29</c:v>
                </c:pt>
                <c:pt idx="5">
                  <c:v>CD44</c:v>
                </c:pt>
                <c:pt idx="6">
                  <c:v>VIM</c:v>
                </c:pt>
              </c:strCache>
            </c:strRef>
          </c:cat>
          <c:val>
            <c:numRef>
              <c:f>'ADSC FST'!$Q$11:$W$11</c:f>
              <c:numCache>
                <c:formatCode>General</c:formatCode>
                <c:ptCount val="7"/>
                <c:pt idx="0">
                  <c:v>3.1818729365804828E-2</c:v>
                </c:pt>
                <c:pt idx="1">
                  <c:v>0.15182399694423696</c:v>
                </c:pt>
                <c:pt idx="2">
                  <c:v>0.10480655012371309</c:v>
                </c:pt>
                <c:pt idx="3">
                  <c:v>9.4679551585245692E-5</c:v>
                </c:pt>
                <c:pt idx="4">
                  <c:v>0.24438353446076433</c:v>
                </c:pt>
                <c:pt idx="5">
                  <c:v>1.0440916347195313</c:v>
                </c:pt>
                <c:pt idx="6">
                  <c:v>0.1428807118740473</c:v>
                </c:pt>
              </c:numCache>
            </c:numRef>
          </c:val>
        </c:ser>
        <c:ser>
          <c:idx val="2"/>
          <c:order val="2"/>
          <c:tx>
            <c:strRef>
              <c:f>'ADSC FST'!$P$12</c:f>
              <c:strCache>
                <c:ptCount val="1"/>
                <c:pt idx="0">
                  <c:v>MES NORMA1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FST'!$Q$18:$W$18</c:f>
                <c:numCache>
                  <c:formatCode>General</c:formatCode>
                  <c:ptCount val="7"/>
                  <c:pt idx="0">
                    <c:v>4.1620352255169091E-4</c:v>
                  </c:pt>
                  <c:pt idx="1">
                    <c:v>1.0087284167384596E-2</c:v>
                  </c:pt>
                  <c:pt idx="2">
                    <c:v>2.156119652212692E-3</c:v>
                  </c:pt>
                  <c:pt idx="3">
                    <c:v>2.2712154876415128E-5</c:v>
                  </c:pt>
                  <c:pt idx="4">
                    <c:v>1.8824808549289793E-2</c:v>
                  </c:pt>
                  <c:pt idx="5">
                    <c:v>2.9445922031044881E-2</c:v>
                  </c:pt>
                  <c:pt idx="6">
                    <c:v>2.1957573922783604E-2</c:v>
                  </c:pt>
                </c:numCache>
              </c:numRef>
            </c:plus>
            <c:minus>
              <c:numRef>
                <c:f>'ADSC FST'!$Q$18:$W$18</c:f>
                <c:numCache>
                  <c:formatCode>General</c:formatCode>
                  <c:ptCount val="7"/>
                  <c:pt idx="0">
                    <c:v>4.1620352255169091E-4</c:v>
                  </c:pt>
                  <c:pt idx="1">
                    <c:v>1.0087284167384596E-2</c:v>
                  </c:pt>
                  <c:pt idx="2">
                    <c:v>2.156119652212692E-3</c:v>
                  </c:pt>
                  <c:pt idx="3">
                    <c:v>2.2712154876415128E-5</c:v>
                  </c:pt>
                  <c:pt idx="4">
                    <c:v>1.8824808549289793E-2</c:v>
                  </c:pt>
                  <c:pt idx="5">
                    <c:v>2.9445922031044881E-2</c:v>
                  </c:pt>
                  <c:pt idx="6">
                    <c:v>2.1957573922783604E-2</c:v>
                  </c:pt>
                </c:numCache>
              </c:numRef>
            </c:minus>
          </c:errBars>
          <c:cat>
            <c:strRef>
              <c:f>'ADSC FST'!$Q$9:$W$9</c:f>
              <c:strCache>
                <c:ptCount val="7"/>
                <c:pt idx="0">
                  <c:v>CD105</c:v>
                </c:pt>
                <c:pt idx="1">
                  <c:v>CD73</c:v>
                </c:pt>
                <c:pt idx="2">
                  <c:v>CD90</c:v>
                </c:pt>
                <c:pt idx="3">
                  <c:v>CD36</c:v>
                </c:pt>
                <c:pt idx="4">
                  <c:v>CD29</c:v>
                </c:pt>
                <c:pt idx="5">
                  <c:v>CD44</c:v>
                </c:pt>
                <c:pt idx="6">
                  <c:v>VIM</c:v>
                </c:pt>
              </c:strCache>
            </c:strRef>
          </c:cat>
          <c:val>
            <c:numRef>
              <c:f>'ADSC FST'!$Q$12:$W$12</c:f>
              <c:numCache>
                <c:formatCode>General</c:formatCode>
                <c:ptCount val="7"/>
                <c:pt idx="0">
                  <c:v>2.2039559538410513E-3</c:v>
                </c:pt>
                <c:pt idx="1">
                  <c:v>9.4971974986379312E-2</c:v>
                </c:pt>
                <c:pt idx="2">
                  <c:v>1.4852511072359244E-2</c:v>
                </c:pt>
                <c:pt idx="3">
                  <c:v>1.7145056809536835E-4</c:v>
                </c:pt>
                <c:pt idx="4">
                  <c:v>3.9319764694945719E-2</c:v>
                </c:pt>
                <c:pt idx="5">
                  <c:v>0.18371440437926359</c:v>
                </c:pt>
                <c:pt idx="6">
                  <c:v>0.1676378694837105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3101184"/>
        <c:axId val="103103104"/>
      </c:barChart>
      <c:catAx>
        <c:axId val="1031011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03103104"/>
        <c:crosses val="autoZero"/>
        <c:auto val="1"/>
        <c:lblAlgn val="ctr"/>
        <c:lblOffset val="100"/>
        <c:noMultiLvlLbl val="0"/>
      </c:catAx>
      <c:valAx>
        <c:axId val="103103104"/>
        <c:scaling>
          <c:orientation val="minMax"/>
          <c:max val="2"/>
          <c:min val="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03101184"/>
        <c:crosses val="autoZero"/>
        <c:crossBetween val="between"/>
        <c:majorUnit val="1"/>
        <c:minorUnit val="4.0000000000000008E-2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DSC MBE'!$P$24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MBE'!$R$23:$V$23</c:f>
              <c:strCache>
                <c:ptCount val="5"/>
                <c:pt idx="0">
                  <c:v>CD14</c:v>
                </c:pt>
                <c:pt idx="1">
                  <c:v>CD19</c:v>
                </c:pt>
                <c:pt idx="2">
                  <c:v>CD34</c:v>
                </c:pt>
                <c:pt idx="3">
                  <c:v>CD45</c:v>
                </c:pt>
                <c:pt idx="4">
                  <c:v>HLA-DR</c:v>
                </c:pt>
              </c:strCache>
            </c:strRef>
          </c:cat>
          <c:val>
            <c:numRef>
              <c:f>'ADSC MBE'!$R$24:$V$24</c:f>
              <c:numCache>
                <c:formatCode>General</c:formatCode>
                <c:ptCount val="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MBE'!$P$25</c:f>
              <c:strCache>
                <c:ptCount val="1"/>
                <c:pt idx="0">
                  <c:v>ADSC  NORMA3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MBE'!$R$31:$V$31</c:f>
                <c:numCache>
                  <c:formatCode>General</c:formatCode>
                  <c:ptCount val="5"/>
                  <c:pt idx="0">
                    <c:v>4.4135575997259436E-3</c:v>
                  </c:pt>
                  <c:pt idx="1">
                    <c:v>2.8276532795799949E-3</c:v>
                  </c:pt>
                  <c:pt idx="2">
                    <c:v>1.2275757671423143E-2</c:v>
                  </c:pt>
                  <c:pt idx="3">
                    <c:v>7.4549805621366776E-4</c:v>
                  </c:pt>
                  <c:pt idx="4">
                    <c:v>1.3164892977154742E-6</c:v>
                  </c:pt>
                </c:numCache>
              </c:numRef>
            </c:plus>
            <c:minus>
              <c:numRef>
                <c:f>'ADSC MBE'!$R$31:$V$31</c:f>
                <c:numCache>
                  <c:formatCode>General</c:formatCode>
                  <c:ptCount val="5"/>
                  <c:pt idx="0">
                    <c:v>4.4135575997259436E-3</c:v>
                  </c:pt>
                  <c:pt idx="1">
                    <c:v>2.8276532795799949E-3</c:v>
                  </c:pt>
                  <c:pt idx="2">
                    <c:v>1.2275757671423143E-2</c:v>
                  </c:pt>
                  <c:pt idx="3">
                    <c:v>7.4549805621366776E-4</c:v>
                  </c:pt>
                  <c:pt idx="4">
                    <c:v>1.3164892977154742E-6</c:v>
                  </c:pt>
                </c:numCache>
              </c:numRef>
            </c:minus>
          </c:errBars>
          <c:cat>
            <c:strRef>
              <c:f>'ADSC MBE'!$R$23:$V$23</c:f>
              <c:strCache>
                <c:ptCount val="5"/>
                <c:pt idx="0">
                  <c:v>CD14</c:v>
                </c:pt>
                <c:pt idx="1">
                  <c:v>CD19</c:v>
                </c:pt>
                <c:pt idx="2">
                  <c:v>CD34</c:v>
                </c:pt>
                <c:pt idx="3">
                  <c:v>CD45</c:v>
                </c:pt>
                <c:pt idx="4">
                  <c:v>HLA-DR</c:v>
                </c:pt>
              </c:strCache>
            </c:strRef>
          </c:cat>
          <c:val>
            <c:numRef>
              <c:f>'ADSC MBE'!$R$25:$V$25</c:f>
              <c:numCache>
                <c:formatCode>General</c:formatCode>
                <c:ptCount val="5"/>
                <c:pt idx="0">
                  <c:v>1.0712632204407428E-2</c:v>
                </c:pt>
                <c:pt idx="1">
                  <c:v>4.5824949483202785E-3</c:v>
                </c:pt>
                <c:pt idx="2">
                  <c:v>2.6820476586236725E-2</c:v>
                </c:pt>
                <c:pt idx="3">
                  <c:v>1.0515271434468614E-3</c:v>
                </c:pt>
                <c:pt idx="4">
                  <c:v>8.2249683610737778E-5</c:v>
                </c:pt>
              </c:numCache>
            </c:numRef>
          </c:val>
        </c:ser>
        <c:ser>
          <c:idx val="2"/>
          <c:order val="2"/>
          <c:tx>
            <c:strRef>
              <c:f>'ADSC MBE'!$P$26</c:f>
              <c:strCache>
                <c:ptCount val="1"/>
                <c:pt idx="0">
                  <c:v>HMEC NORMA3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MBE'!$R$32:$V$32</c:f>
                <c:numCache>
                  <c:formatCode>General</c:formatCode>
                  <c:ptCount val="5"/>
                  <c:pt idx="0">
                    <c:v>8.690914623357991E-4</c:v>
                  </c:pt>
                  <c:pt idx="1">
                    <c:v>2.0146420410138404E-2</c:v>
                  </c:pt>
                  <c:pt idx="2">
                    <c:v>3.2878338321428265E-4</c:v>
                  </c:pt>
                  <c:pt idx="3">
                    <c:v>1.0346982301262929E-5</c:v>
                  </c:pt>
                  <c:pt idx="4">
                    <c:v>2.6151511523279847E-5</c:v>
                  </c:pt>
                </c:numCache>
              </c:numRef>
            </c:plus>
            <c:minus>
              <c:numRef>
                <c:f>'ADSC MBE'!$R$32:$V$32</c:f>
                <c:numCache>
                  <c:formatCode>General</c:formatCode>
                  <c:ptCount val="5"/>
                  <c:pt idx="0">
                    <c:v>8.690914623357991E-4</c:v>
                  </c:pt>
                  <c:pt idx="1">
                    <c:v>2.0146420410138404E-2</c:v>
                  </c:pt>
                  <c:pt idx="2">
                    <c:v>3.2878338321428265E-4</c:v>
                  </c:pt>
                  <c:pt idx="3">
                    <c:v>1.0346982301262929E-5</c:v>
                  </c:pt>
                  <c:pt idx="4">
                    <c:v>2.6151511523279847E-5</c:v>
                  </c:pt>
                </c:numCache>
              </c:numRef>
            </c:minus>
          </c:errBars>
          <c:cat>
            <c:strRef>
              <c:f>'ADSC MBE'!$R$23:$V$23</c:f>
              <c:strCache>
                <c:ptCount val="5"/>
                <c:pt idx="0">
                  <c:v>CD14</c:v>
                </c:pt>
                <c:pt idx="1">
                  <c:v>CD19</c:v>
                </c:pt>
                <c:pt idx="2">
                  <c:v>CD34</c:v>
                </c:pt>
                <c:pt idx="3">
                  <c:v>CD45</c:v>
                </c:pt>
                <c:pt idx="4">
                  <c:v>HLA-DR</c:v>
                </c:pt>
              </c:strCache>
            </c:strRef>
          </c:cat>
          <c:val>
            <c:numRef>
              <c:f>'ADSC MBE'!$R$26:$V$26</c:f>
              <c:numCache>
                <c:formatCode>General</c:formatCode>
                <c:ptCount val="5"/>
                <c:pt idx="0">
                  <c:v>3.6618533416543906E-3</c:v>
                </c:pt>
                <c:pt idx="1">
                  <c:v>2.0498556737118145E-2</c:v>
                </c:pt>
                <c:pt idx="2">
                  <c:v>6.4912198081961629E-4</c:v>
                </c:pt>
                <c:pt idx="3">
                  <c:v>1.8727567146564391E-5</c:v>
                </c:pt>
                <c:pt idx="4">
                  <c:v>5.1938076022976207E-5</c:v>
                </c:pt>
              </c:numCache>
            </c:numRef>
          </c:val>
        </c:ser>
        <c:ser>
          <c:idx val="3"/>
          <c:order val="3"/>
          <c:tx>
            <c:strRef>
              <c:f>'ADSC MBE'!$P$27</c:f>
              <c:strCache>
                <c:ptCount val="1"/>
                <c:pt idx="0">
                  <c:v>MES NORMA3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MBE'!$R$33:$V$33</c:f>
                <c:numCache>
                  <c:formatCode>General</c:formatCode>
                  <c:ptCount val="5"/>
                  <c:pt idx="0">
                    <c:v>5.1830026759189381E-4</c:v>
                  </c:pt>
                  <c:pt idx="1">
                    <c:v>1.0018269878996526E-2</c:v>
                  </c:pt>
                  <c:pt idx="2">
                    <c:v>8.075310684123087E-4</c:v>
                  </c:pt>
                  <c:pt idx="3">
                    <c:v>3.0072178857055157E-4</c:v>
                  </c:pt>
                  <c:pt idx="4">
                    <c:v>2.9096557083518936E-6</c:v>
                  </c:pt>
                </c:numCache>
              </c:numRef>
            </c:plus>
            <c:minus>
              <c:numRef>
                <c:f>'ADSC MBE'!$R$33:$V$33</c:f>
                <c:numCache>
                  <c:formatCode>General</c:formatCode>
                  <c:ptCount val="5"/>
                  <c:pt idx="0">
                    <c:v>5.1830026759189381E-4</c:v>
                  </c:pt>
                  <c:pt idx="1">
                    <c:v>1.0018269878996526E-2</c:v>
                  </c:pt>
                  <c:pt idx="2">
                    <c:v>8.075310684123087E-4</c:v>
                  </c:pt>
                  <c:pt idx="3">
                    <c:v>3.0072178857055157E-4</c:v>
                  </c:pt>
                  <c:pt idx="4">
                    <c:v>2.9096557083518936E-6</c:v>
                  </c:pt>
                </c:numCache>
              </c:numRef>
            </c:minus>
          </c:errBars>
          <c:cat>
            <c:strRef>
              <c:f>'ADSC MBE'!$R$23:$V$23</c:f>
              <c:strCache>
                <c:ptCount val="5"/>
                <c:pt idx="0">
                  <c:v>CD14</c:v>
                </c:pt>
                <c:pt idx="1">
                  <c:v>CD19</c:v>
                </c:pt>
                <c:pt idx="2">
                  <c:v>CD34</c:v>
                </c:pt>
                <c:pt idx="3">
                  <c:v>CD45</c:v>
                </c:pt>
                <c:pt idx="4">
                  <c:v>HLA-DR</c:v>
                </c:pt>
              </c:strCache>
            </c:strRef>
          </c:cat>
          <c:val>
            <c:numRef>
              <c:f>'ADSC MBE'!$R$27:$V$27</c:f>
              <c:numCache>
                <c:formatCode>General</c:formatCode>
                <c:ptCount val="5"/>
                <c:pt idx="0">
                  <c:v>8.7441844533705452E-4</c:v>
                </c:pt>
                <c:pt idx="1">
                  <c:v>1.5375033241818279E-2</c:v>
                </c:pt>
                <c:pt idx="2">
                  <c:v>2.8782410532406967E-3</c:v>
                </c:pt>
                <c:pt idx="3">
                  <c:v>4.9191954862846249E-4</c:v>
                </c:pt>
                <c:pt idx="4">
                  <c:v>1.5715572425822073E-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9014400"/>
        <c:axId val="149065728"/>
      </c:barChart>
      <c:catAx>
        <c:axId val="1490144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49065728"/>
        <c:crosses val="autoZero"/>
        <c:auto val="1"/>
        <c:lblAlgn val="ctr"/>
        <c:lblOffset val="100"/>
        <c:noMultiLvlLbl val="0"/>
      </c:catAx>
      <c:valAx>
        <c:axId val="149065728"/>
        <c:scaling>
          <c:orientation val="minMax"/>
          <c:max val="2.2000000000000002"/>
          <c:min val="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49014400"/>
        <c:crosses val="autoZero"/>
        <c:crossBetween val="between"/>
        <c:majorUnit val="1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DSC FST'!$P$24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FST'!$R$23:$V$23</c:f>
              <c:strCache>
                <c:ptCount val="5"/>
                <c:pt idx="0">
                  <c:v>CD14</c:v>
                </c:pt>
                <c:pt idx="1">
                  <c:v>CD19</c:v>
                </c:pt>
                <c:pt idx="2">
                  <c:v>CD34</c:v>
                </c:pt>
                <c:pt idx="3">
                  <c:v>CD45</c:v>
                </c:pt>
                <c:pt idx="4">
                  <c:v>HLA-DR</c:v>
                </c:pt>
              </c:strCache>
            </c:strRef>
          </c:cat>
          <c:val>
            <c:numRef>
              <c:f>'ADSC FST'!$R$24:$V$24</c:f>
              <c:numCache>
                <c:formatCode>General</c:formatCode>
                <c:ptCount val="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FST'!$P$25</c:f>
              <c:strCache>
                <c:ptCount val="1"/>
                <c:pt idx="0">
                  <c:v>ADSC  NORMA1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FST'!$R$31:$V$31</c:f>
                <c:numCache>
                  <c:formatCode>General</c:formatCode>
                  <c:ptCount val="5"/>
                  <c:pt idx="0">
                    <c:v>6.6431182091684277E-2</c:v>
                  </c:pt>
                  <c:pt idx="1">
                    <c:v>2.6424956331529463E-2</c:v>
                  </c:pt>
                  <c:pt idx="2">
                    <c:v>0.39731872037710803</c:v>
                  </c:pt>
                  <c:pt idx="3">
                    <c:v>4.1570044225022178E-3</c:v>
                  </c:pt>
                  <c:pt idx="4">
                    <c:v>1.00044115099325E-4</c:v>
                  </c:pt>
                </c:numCache>
              </c:numRef>
            </c:plus>
            <c:minus>
              <c:numRef>
                <c:f>'ADSC FST'!$R$31:$V$31</c:f>
                <c:numCache>
                  <c:formatCode>General</c:formatCode>
                  <c:ptCount val="5"/>
                  <c:pt idx="0">
                    <c:v>6.6431182091684277E-2</c:v>
                  </c:pt>
                  <c:pt idx="1">
                    <c:v>2.6424956331529463E-2</c:v>
                  </c:pt>
                  <c:pt idx="2">
                    <c:v>0.39731872037710803</c:v>
                  </c:pt>
                  <c:pt idx="3">
                    <c:v>4.1570044225022178E-3</c:v>
                  </c:pt>
                  <c:pt idx="4">
                    <c:v>1.00044115099325E-4</c:v>
                  </c:pt>
                </c:numCache>
              </c:numRef>
            </c:minus>
          </c:errBars>
          <c:cat>
            <c:strRef>
              <c:f>'ADSC FST'!$R$23:$V$23</c:f>
              <c:strCache>
                <c:ptCount val="5"/>
                <c:pt idx="0">
                  <c:v>CD14</c:v>
                </c:pt>
                <c:pt idx="1">
                  <c:v>CD19</c:v>
                </c:pt>
                <c:pt idx="2">
                  <c:v>CD34</c:v>
                </c:pt>
                <c:pt idx="3">
                  <c:v>CD45</c:v>
                </c:pt>
                <c:pt idx="4">
                  <c:v>HLA-DR</c:v>
                </c:pt>
              </c:strCache>
            </c:strRef>
          </c:cat>
          <c:val>
            <c:numRef>
              <c:f>'ADSC FST'!$R$25:$V$25</c:f>
              <c:numCache>
                <c:formatCode>General</c:formatCode>
                <c:ptCount val="5"/>
                <c:pt idx="0">
                  <c:v>0.1990416727941785</c:v>
                </c:pt>
                <c:pt idx="1">
                  <c:v>4.764944125010781E-2</c:v>
                </c:pt>
                <c:pt idx="2">
                  <c:v>1.2274437723066396</c:v>
                </c:pt>
                <c:pt idx="3">
                  <c:v>4.8394498943878242E-3</c:v>
                </c:pt>
                <c:pt idx="4">
                  <c:v>3.0893000080468381E-4</c:v>
                </c:pt>
              </c:numCache>
            </c:numRef>
          </c:val>
        </c:ser>
        <c:ser>
          <c:idx val="2"/>
          <c:order val="2"/>
          <c:tx>
            <c:strRef>
              <c:f>'ADSC FST'!$P$26</c:f>
              <c:strCache>
                <c:ptCount val="1"/>
                <c:pt idx="0">
                  <c:v>HMEC NORMA1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FST'!$R$32:$V$32</c:f>
                <c:numCache>
                  <c:formatCode>General</c:formatCode>
                  <c:ptCount val="5"/>
                  <c:pt idx="0">
                    <c:v>6.1830786465254866E-3</c:v>
                  </c:pt>
                  <c:pt idx="1">
                    <c:v>1.4006720552243317E-2</c:v>
                  </c:pt>
                  <c:pt idx="2">
                    <c:v>1.4152420383816209E-3</c:v>
                  </c:pt>
                  <c:pt idx="3">
                    <c:v>1.283104383454401E-4</c:v>
                  </c:pt>
                  <c:pt idx="4">
                    <c:v>1.2355724837135806E-5</c:v>
                  </c:pt>
                </c:numCache>
              </c:numRef>
            </c:plus>
            <c:minus>
              <c:numRef>
                <c:f>'ADSC FST'!$R$32:$V$32</c:f>
                <c:numCache>
                  <c:formatCode>General</c:formatCode>
                  <c:ptCount val="5"/>
                  <c:pt idx="0">
                    <c:v>6.1830786465254866E-3</c:v>
                  </c:pt>
                  <c:pt idx="1">
                    <c:v>1.4006720552243317E-2</c:v>
                  </c:pt>
                  <c:pt idx="2">
                    <c:v>1.4152420383816209E-3</c:v>
                  </c:pt>
                  <c:pt idx="3">
                    <c:v>1.283104383454401E-4</c:v>
                  </c:pt>
                  <c:pt idx="4">
                    <c:v>1.2355724837135806E-5</c:v>
                  </c:pt>
                </c:numCache>
              </c:numRef>
            </c:minus>
          </c:errBars>
          <c:cat>
            <c:strRef>
              <c:f>'ADSC FST'!$R$23:$V$23</c:f>
              <c:strCache>
                <c:ptCount val="5"/>
                <c:pt idx="0">
                  <c:v>CD14</c:v>
                </c:pt>
                <c:pt idx="1">
                  <c:v>CD19</c:v>
                </c:pt>
                <c:pt idx="2">
                  <c:v>CD34</c:v>
                </c:pt>
                <c:pt idx="3">
                  <c:v>CD45</c:v>
                </c:pt>
                <c:pt idx="4">
                  <c:v>HLA-DR</c:v>
                </c:pt>
              </c:strCache>
            </c:strRef>
          </c:cat>
          <c:val>
            <c:numRef>
              <c:f>'ADSC FST'!$R$26:$V$26</c:f>
              <c:numCache>
                <c:formatCode>General</c:formatCode>
                <c:ptCount val="5"/>
                <c:pt idx="0">
                  <c:v>2.4635213736005569E-2</c:v>
                </c:pt>
                <c:pt idx="1">
                  <c:v>1.9370446042926471E-2</c:v>
                </c:pt>
                <c:pt idx="2">
                  <c:v>2.9500114234216504E-3</c:v>
                </c:pt>
                <c:pt idx="3">
                  <c:v>1.4559284593510118E-4</c:v>
                </c:pt>
                <c:pt idx="4">
                  <c:v>1.0632917234946401E-4</c:v>
                </c:pt>
              </c:numCache>
            </c:numRef>
          </c:val>
        </c:ser>
        <c:ser>
          <c:idx val="3"/>
          <c:order val="3"/>
          <c:tx>
            <c:strRef>
              <c:f>'ADSC FST'!$P$27</c:f>
              <c:strCache>
                <c:ptCount val="1"/>
                <c:pt idx="0">
                  <c:v>MES NORMA1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FST'!$R$33:$V$33</c:f>
                <c:numCache>
                  <c:formatCode>General</c:formatCode>
                  <c:ptCount val="5"/>
                  <c:pt idx="0">
                    <c:v>4.1156759835167571E-4</c:v>
                  </c:pt>
                  <c:pt idx="1">
                    <c:v>1.1926056267089606E-2</c:v>
                  </c:pt>
                  <c:pt idx="2">
                    <c:v>9.9407557993013546E-4</c:v>
                  </c:pt>
                  <c:pt idx="3">
                    <c:v>3.5790449125772307E-4</c:v>
                  </c:pt>
                  <c:pt idx="4">
                    <c:v>2.7241323165010117E-4</c:v>
                  </c:pt>
                </c:numCache>
              </c:numRef>
            </c:plus>
            <c:minus>
              <c:numRef>
                <c:f>'ADSC FST'!$R$33:$V$33</c:f>
                <c:numCache>
                  <c:formatCode>General</c:formatCode>
                  <c:ptCount val="5"/>
                  <c:pt idx="0">
                    <c:v>4.1156759835167571E-4</c:v>
                  </c:pt>
                  <c:pt idx="1">
                    <c:v>1.1926056267089606E-2</c:v>
                  </c:pt>
                  <c:pt idx="2">
                    <c:v>9.9407557993013546E-4</c:v>
                  </c:pt>
                  <c:pt idx="3">
                    <c:v>3.5790449125772307E-4</c:v>
                  </c:pt>
                  <c:pt idx="4">
                    <c:v>2.7241323165010117E-4</c:v>
                  </c:pt>
                </c:numCache>
              </c:numRef>
            </c:minus>
          </c:errBars>
          <c:cat>
            <c:strRef>
              <c:f>'ADSC FST'!$R$23:$V$23</c:f>
              <c:strCache>
                <c:ptCount val="5"/>
                <c:pt idx="0">
                  <c:v>CD14</c:v>
                </c:pt>
                <c:pt idx="1">
                  <c:v>CD19</c:v>
                </c:pt>
                <c:pt idx="2">
                  <c:v>CD34</c:v>
                </c:pt>
                <c:pt idx="3">
                  <c:v>CD45</c:v>
                </c:pt>
                <c:pt idx="4">
                  <c:v>HLA-DR</c:v>
                </c:pt>
              </c:strCache>
            </c:strRef>
          </c:cat>
          <c:val>
            <c:numRef>
              <c:f>'ADSC FST'!$R$27:$V$27</c:f>
              <c:numCache>
                <c:formatCode>General</c:formatCode>
                <c:ptCount val="5"/>
                <c:pt idx="0">
                  <c:v>1.8793550037312721E-3</c:v>
                </c:pt>
                <c:pt idx="1">
                  <c:v>1.8872006706188601E-2</c:v>
                </c:pt>
                <c:pt idx="2">
                  <c:v>3.636941228077771E-3</c:v>
                </c:pt>
                <c:pt idx="3">
                  <c:v>6.0148834655835619E-4</c:v>
                </c:pt>
                <c:pt idx="4">
                  <c:v>1.0334133828878618E-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9211776"/>
        <c:axId val="149213568"/>
      </c:barChart>
      <c:catAx>
        <c:axId val="1492117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49213568"/>
        <c:crosses val="autoZero"/>
        <c:auto val="1"/>
        <c:lblAlgn val="ctr"/>
        <c:lblOffset val="100"/>
        <c:noMultiLvlLbl val="0"/>
      </c:catAx>
      <c:valAx>
        <c:axId val="149213568"/>
        <c:scaling>
          <c:orientation val="minMax"/>
          <c:max val="2.2000000000000002"/>
          <c:min val="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49211776"/>
        <c:crosses val="autoZero"/>
        <c:crossBetween val="between"/>
        <c:majorUnit val="1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DSC SLA'!$P$28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SLA'!$R$27:$V$27</c:f>
              <c:strCache>
                <c:ptCount val="5"/>
                <c:pt idx="0">
                  <c:v>CD14</c:v>
                </c:pt>
                <c:pt idx="1">
                  <c:v>CD19</c:v>
                </c:pt>
                <c:pt idx="2">
                  <c:v>CD34</c:v>
                </c:pt>
                <c:pt idx="3">
                  <c:v>CD45</c:v>
                </c:pt>
                <c:pt idx="4">
                  <c:v>HLA-DR</c:v>
                </c:pt>
              </c:strCache>
            </c:strRef>
          </c:cat>
          <c:val>
            <c:numRef>
              <c:f>'ADSC SLA'!$R$28:$V$28</c:f>
              <c:numCache>
                <c:formatCode>General</c:formatCode>
                <c:ptCount val="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SLA'!$P$29</c:f>
              <c:strCache>
                <c:ptCount val="1"/>
                <c:pt idx="0">
                  <c:v>ADSC  NORMA2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SLA'!$R$36:$V$36</c:f>
                <c:numCache>
                  <c:formatCode>General</c:formatCode>
                  <c:ptCount val="5"/>
                  <c:pt idx="0">
                    <c:v>1.0303417913784417E-2</c:v>
                  </c:pt>
                  <c:pt idx="1">
                    <c:v>3.8578837415268567E-2</c:v>
                  </c:pt>
                  <c:pt idx="2">
                    <c:v>0.23042091437361997</c:v>
                  </c:pt>
                  <c:pt idx="3">
                    <c:v>1.7312026460833494E-3</c:v>
                  </c:pt>
                  <c:pt idx="4">
                    <c:v>9.3496501598169478E-6</c:v>
                  </c:pt>
                </c:numCache>
              </c:numRef>
            </c:plus>
            <c:minus>
              <c:numRef>
                <c:f>'ADSC SLA'!$R$36:$V$36</c:f>
                <c:numCache>
                  <c:formatCode>General</c:formatCode>
                  <c:ptCount val="5"/>
                  <c:pt idx="0">
                    <c:v>1.0303417913784417E-2</c:v>
                  </c:pt>
                  <c:pt idx="1">
                    <c:v>3.8578837415268567E-2</c:v>
                  </c:pt>
                  <c:pt idx="2">
                    <c:v>0.23042091437361997</c:v>
                  </c:pt>
                  <c:pt idx="3">
                    <c:v>1.7312026460833494E-3</c:v>
                  </c:pt>
                  <c:pt idx="4">
                    <c:v>9.3496501598169478E-6</c:v>
                  </c:pt>
                </c:numCache>
              </c:numRef>
            </c:minus>
          </c:errBars>
          <c:cat>
            <c:strRef>
              <c:f>'ADSC SLA'!$R$27:$V$27</c:f>
              <c:strCache>
                <c:ptCount val="5"/>
                <c:pt idx="0">
                  <c:v>CD14</c:v>
                </c:pt>
                <c:pt idx="1">
                  <c:v>CD19</c:v>
                </c:pt>
                <c:pt idx="2">
                  <c:v>CD34</c:v>
                </c:pt>
                <c:pt idx="3">
                  <c:v>CD45</c:v>
                </c:pt>
                <c:pt idx="4">
                  <c:v>HLA-DR</c:v>
                </c:pt>
              </c:strCache>
            </c:strRef>
          </c:cat>
          <c:val>
            <c:numRef>
              <c:f>'ADSC SLA'!$R$29:$V$29</c:f>
              <c:numCache>
                <c:formatCode>General</c:formatCode>
                <c:ptCount val="5"/>
                <c:pt idx="0">
                  <c:v>5.1935214679005463E-2</c:v>
                </c:pt>
                <c:pt idx="1">
                  <c:v>5.5851138592878193E-2</c:v>
                </c:pt>
                <c:pt idx="2">
                  <c:v>0.47726692430661272</c:v>
                </c:pt>
                <c:pt idx="3">
                  <c:v>3.5539276360104194E-3</c:v>
                </c:pt>
                <c:pt idx="4">
                  <c:v>6.1254959607761695E-5</c:v>
                </c:pt>
              </c:numCache>
            </c:numRef>
          </c:val>
        </c:ser>
        <c:ser>
          <c:idx val="2"/>
          <c:order val="2"/>
          <c:tx>
            <c:strRef>
              <c:f>'ADSC SLA'!$P$30</c:f>
              <c:strCache>
                <c:ptCount val="1"/>
                <c:pt idx="0">
                  <c:v>HMEC NORMA2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SLA'!$R$37:$V$37</c:f>
                <c:numCache>
                  <c:formatCode>General</c:formatCode>
                  <c:ptCount val="5"/>
                  <c:pt idx="0">
                    <c:v>1.0882879941042608E-3</c:v>
                  </c:pt>
                  <c:pt idx="1">
                    <c:v>2.8844639657294124E-4</c:v>
                  </c:pt>
                  <c:pt idx="2">
                    <c:v>1.2483553096328565E-3</c:v>
                  </c:pt>
                  <c:pt idx="3">
                    <c:v>7.5968989107139728E-5</c:v>
                  </c:pt>
                  <c:pt idx="4">
                    <c:v>7.0810476715593509E-5</c:v>
                  </c:pt>
                </c:numCache>
              </c:numRef>
            </c:plus>
            <c:minus>
              <c:numRef>
                <c:f>'ADSC SLA'!$R$37:$V$37</c:f>
                <c:numCache>
                  <c:formatCode>General</c:formatCode>
                  <c:ptCount val="5"/>
                  <c:pt idx="0">
                    <c:v>1.0882879941042608E-3</c:v>
                  </c:pt>
                  <c:pt idx="1">
                    <c:v>2.8844639657294124E-4</c:v>
                  </c:pt>
                  <c:pt idx="2">
                    <c:v>1.2483553096328565E-3</c:v>
                  </c:pt>
                  <c:pt idx="3">
                    <c:v>7.5968989107139728E-5</c:v>
                  </c:pt>
                  <c:pt idx="4">
                    <c:v>7.0810476715593509E-5</c:v>
                  </c:pt>
                </c:numCache>
              </c:numRef>
            </c:minus>
          </c:errBars>
          <c:cat>
            <c:strRef>
              <c:f>'ADSC SLA'!$R$27:$V$27</c:f>
              <c:strCache>
                <c:ptCount val="5"/>
                <c:pt idx="0">
                  <c:v>CD14</c:v>
                </c:pt>
                <c:pt idx="1">
                  <c:v>CD19</c:v>
                </c:pt>
                <c:pt idx="2">
                  <c:v>CD34</c:v>
                </c:pt>
                <c:pt idx="3">
                  <c:v>CD45</c:v>
                </c:pt>
                <c:pt idx="4">
                  <c:v>HLA-DR</c:v>
                </c:pt>
              </c:strCache>
            </c:strRef>
          </c:cat>
          <c:val>
            <c:numRef>
              <c:f>'ADSC SLA'!$R$30:$V$30</c:f>
              <c:numCache>
                <c:formatCode>General</c:formatCode>
                <c:ptCount val="5"/>
                <c:pt idx="0">
                  <c:v>3.3574782011901176E-3</c:v>
                </c:pt>
                <c:pt idx="1">
                  <c:v>6.4222343819129383E-4</c:v>
                </c:pt>
                <c:pt idx="2">
                  <c:v>2.3093191179932404E-3</c:v>
                </c:pt>
                <c:pt idx="3">
                  <c:v>8.2280970371286598E-5</c:v>
                </c:pt>
                <c:pt idx="4">
                  <c:v>2.4933152565432258E-4</c:v>
                </c:pt>
              </c:numCache>
            </c:numRef>
          </c:val>
        </c:ser>
        <c:ser>
          <c:idx val="3"/>
          <c:order val="3"/>
          <c:tx>
            <c:strRef>
              <c:f>'ADSC SLA'!$P$31</c:f>
              <c:strCache>
                <c:ptCount val="1"/>
                <c:pt idx="0">
                  <c:v>Mes NORMA2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SLA'!$R$38:$V$38</c:f>
                <c:numCache>
                  <c:formatCode>General</c:formatCode>
                  <c:ptCount val="5"/>
                  <c:pt idx="0">
                    <c:v>5.0728097819492397E-4</c:v>
                  </c:pt>
                  <c:pt idx="1">
                    <c:v>9.9531471356102186E-2</c:v>
                  </c:pt>
                  <c:pt idx="2">
                    <c:v>1.4493401929112618E-3</c:v>
                  </c:pt>
                  <c:pt idx="3">
                    <c:v>2.0992286429770841E-4</c:v>
                  </c:pt>
                  <c:pt idx="4">
                    <c:v>5.1472547931061014E-4</c:v>
                  </c:pt>
                </c:numCache>
              </c:numRef>
            </c:plus>
            <c:minus>
              <c:numRef>
                <c:f>'ADSC SLA'!$R$38:$V$38</c:f>
                <c:numCache>
                  <c:formatCode>General</c:formatCode>
                  <c:ptCount val="5"/>
                  <c:pt idx="0">
                    <c:v>5.0728097819492397E-4</c:v>
                  </c:pt>
                  <c:pt idx="1">
                    <c:v>9.9531471356102186E-2</c:v>
                  </c:pt>
                  <c:pt idx="2">
                    <c:v>1.4493401929112618E-3</c:v>
                  </c:pt>
                  <c:pt idx="3">
                    <c:v>2.0992286429770841E-4</c:v>
                  </c:pt>
                  <c:pt idx="4">
                    <c:v>5.1472547931061014E-4</c:v>
                  </c:pt>
                </c:numCache>
              </c:numRef>
            </c:minus>
          </c:errBars>
          <c:cat>
            <c:strRef>
              <c:f>'ADSC SLA'!$R$27:$V$27</c:f>
              <c:strCache>
                <c:ptCount val="5"/>
                <c:pt idx="0">
                  <c:v>CD14</c:v>
                </c:pt>
                <c:pt idx="1">
                  <c:v>CD19</c:v>
                </c:pt>
                <c:pt idx="2">
                  <c:v>CD34</c:v>
                </c:pt>
                <c:pt idx="3">
                  <c:v>CD45</c:v>
                </c:pt>
                <c:pt idx="4">
                  <c:v>HLA-DR</c:v>
                </c:pt>
              </c:strCache>
            </c:strRef>
          </c:cat>
          <c:val>
            <c:numRef>
              <c:f>'ADSC SLA'!$R$31:$V$31</c:f>
              <c:numCache>
                <c:formatCode>General</c:formatCode>
                <c:ptCount val="5"/>
                <c:pt idx="0">
                  <c:v>7.3397269763449916E-4</c:v>
                </c:pt>
                <c:pt idx="1">
                  <c:v>0.10448672052385004</c:v>
                </c:pt>
                <c:pt idx="2">
                  <c:v>4.7229005093173586E-3</c:v>
                </c:pt>
                <c:pt idx="3">
                  <c:v>4.2351995627939039E-4</c:v>
                </c:pt>
                <c:pt idx="4">
                  <c:v>2.3565364194167711E-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0315008"/>
        <c:axId val="150316544"/>
      </c:barChart>
      <c:catAx>
        <c:axId val="1503150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50316544"/>
        <c:crosses val="autoZero"/>
        <c:auto val="1"/>
        <c:lblAlgn val="ctr"/>
        <c:lblOffset val="100"/>
        <c:noMultiLvlLbl val="0"/>
      </c:catAx>
      <c:valAx>
        <c:axId val="150316544"/>
        <c:scaling>
          <c:orientation val="minMax"/>
          <c:max val="2.2000000000000002"/>
          <c:min val="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50315008"/>
        <c:crosses val="autoZero"/>
        <c:crossBetween val="between"/>
        <c:majorUnit val="1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DSC PS'!$P$10</c:f>
              <c:strCache>
                <c:ptCount val="1"/>
                <c:pt idx="0">
                  <c:v>ADSC  IFDUC1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PS'!$Q$9:$W$9</c:f>
              <c:strCache>
                <c:ptCount val="7"/>
                <c:pt idx="0">
                  <c:v>CD105</c:v>
                </c:pt>
                <c:pt idx="1">
                  <c:v>CD73</c:v>
                </c:pt>
                <c:pt idx="2">
                  <c:v>CD90</c:v>
                </c:pt>
                <c:pt idx="3">
                  <c:v>CD36</c:v>
                </c:pt>
                <c:pt idx="4">
                  <c:v>CD29</c:v>
                </c:pt>
                <c:pt idx="5">
                  <c:v>CD44</c:v>
                </c:pt>
                <c:pt idx="6">
                  <c:v>VIM</c:v>
                </c:pt>
              </c:strCache>
            </c:strRef>
          </c:cat>
          <c:val>
            <c:numRef>
              <c:f>'ADSC PS'!$Q$10:$W$10</c:f>
              <c:numCache>
                <c:formatCode>General</c:formatCode>
                <c:ptCount val="7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PS'!$P$11</c:f>
              <c:strCache>
                <c:ptCount val="1"/>
                <c:pt idx="0">
                  <c:v>HMEC IFDUC1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PS'!$Q$17:$W$17</c:f>
                <c:numCache>
                  <c:formatCode>General</c:formatCode>
                  <c:ptCount val="7"/>
                  <c:pt idx="0">
                    <c:v>1.6033422496603937E-2</c:v>
                  </c:pt>
                  <c:pt idx="1">
                    <c:v>3.0019768865997949E-2</c:v>
                  </c:pt>
                  <c:pt idx="2">
                    <c:v>3.8428933321709028E-3</c:v>
                  </c:pt>
                  <c:pt idx="3">
                    <c:v>2.1764867134068834E-4</c:v>
                  </c:pt>
                  <c:pt idx="4">
                    <c:v>1.555883341326071E-2</c:v>
                  </c:pt>
                  <c:pt idx="5">
                    <c:v>0.45325824056862168</c:v>
                  </c:pt>
                  <c:pt idx="6">
                    <c:v>2.4007958679526327E-2</c:v>
                  </c:pt>
                </c:numCache>
              </c:numRef>
            </c:plus>
            <c:minus>
              <c:numRef>
                <c:f>'ADSC PS'!$Q$17:$W$17</c:f>
                <c:numCache>
                  <c:formatCode>General</c:formatCode>
                  <c:ptCount val="7"/>
                  <c:pt idx="0">
                    <c:v>1.6033422496603937E-2</c:v>
                  </c:pt>
                  <c:pt idx="1">
                    <c:v>3.0019768865997949E-2</c:v>
                  </c:pt>
                  <c:pt idx="2">
                    <c:v>3.8428933321709028E-3</c:v>
                  </c:pt>
                  <c:pt idx="3">
                    <c:v>2.1764867134068834E-4</c:v>
                  </c:pt>
                  <c:pt idx="4">
                    <c:v>1.555883341326071E-2</c:v>
                  </c:pt>
                  <c:pt idx="5">
                    <c:v>0.45325824056862168</c:v>
                  </c:pt>
                  <c:pt idx="6">
                    <c:v>2.4007958679526327E-2</c:v>
                  </c:pt>
                </c:numCache>
              </c:numRef>
            </c:minus>
          </c:errBars>
          <c:cat>
            <c:strRef>
              <c:f>'ADSC PS'!$Q$9:$W$9</c:f>
              <c:strCache>
                <c:ptCount val="7"/>
                <c:pt idx="0">
                  <c:v>CD105</c:v>
                </c:pt>
                <c:pt idx="1">
                  <c:v>CD73</c:v>
                </c:pt>
                <c:pt idx="2">
                  <c:v>CD90</c:v>
                </c:pt>
                <c:pt idx="3">
                  <c:v>CD36</c:v>
                </c:pt>
                <c:pt idx="4">
                  <c:v>CD29</c:v>
                </c:pt>
                <c:pt idx="5">
                  <c:v>CD44</c:v>
                </c:pt>
                <c:pt idx="6">
                  <c:v>VIM</c:v>
                </c:pt>
              </c:strCache>
            </c:strRef>
          </c:cat>
          <c:val>
            <c:numRef>
              <c:f>'ADSC PS'!$Q$11:$W$11</c:f>
              <c:numCache>
                <c:formatCode>General</c:formatCode>
                <c:ptCount val="7"/>
                <c:pt idx="0">
                  <c:v>8.0840922535996007E-2</c:v>
                </c:pt>
                <c:pt idx="1">
                  <c:v>6.9668999575279625E-2</c:v>
                </c:pt>
                <c:pt idx="2">
                  <c:v>8.4647037375781432E-3</c:v>
                </c:pt>
                <c:pt idx="3">
                  <c:v>7.7384812514253679E-4</c:v>
                </c:pt>
                <c:pt idx="4">
                  <c:v>4.3188956213680463E-2</c:v>
                </c:pt>
                <c:pt idx="5">
                  <c:v>3.1739402272591311</c:v>
                </c:pt>
                <c:pt idx="6">
                  <c:v>9.9632017733472786E-2</c:v>
                </c:pt>
              </c:numCache>
            </c:numRef>
          </c:val>
        </c:ser>
        <c:ser>
          <c:idx val="2"/>
          <c:order val="2"/>
          <c:tx>
            <c:strRef>
              <c:f>'ADSC PS'!$P$12</c:f>
              <c:strCache>
                <c:ptCount val="1"/>
                <c:pt idx="0">
                  <c:v>MES IFDUC1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PS'!$Q$18:$W$18</c:f>
                <c:numCache>
                  <c:formatCode>General</c:formatCode>
                  <c:ptCount val="7"/>
                  <c:pt idx="0">
                    <c:v>3.7648369930302156E-2</c:v>
                  </c:pt>
                  <c:pt idx="1">
                    <c:v>6.4602953193758444E-2</c:v>
                  </c:pt>
                  <c:pt idx="2">
                    <c:v>1.4348328247345523E-2</c:v>
                  </c:pt>
                  <c:pt idx="3">
                    <c:v>9.2533864086431966E-2</c:v>
                  </c:pt>
                  <c:pt idx="4">
                    <c:v>1.299371734336691E-2</c:v>
                  </c:pt>
                  <c:pt idx="5">
                    <c:v>1.2790927518199515</c:v>
                  </c:pt>
                  <c:pt idx="6">
                    <c:v>0.83327959842053279</c:v>
                  </c:pt>
                </c:numCache>
              </c:numRef>
            </c:plus>
            <c:minus>
              <c:numRef>
                <c:f>'ADSC PS'!$Q$18:$W$18</c:f>
                <c:numCache>
                  <c:formatCode>General</c:formatCode>
                  <c:ptCount val="7"/>
                  <c:pt idx="0">
                    <c:v>3.7648369930302156E-2</c:v>
                  </c:pt>
                  <c:pt idx="1">
                    <c:v>6.4602953193758444E-2</c:v>
                  </c:pt>
                  <c:pt idx="2">
                    <c:v>1.4348328247345523E-2</c:v>
                  </c:pt>
                  <c:pt idx="3">
                    <c:v>9.2533864086431966E-2</c:v>
                  </c:pt>
                  <c:pt idx="4">
                    <c:v>1.299371734336691E-2</c:v>
                  </c:pt>
                  <c:pt idx="5">
                    <c:v>1.2790927518199515</c:v>
                  </c:pt>
                  <c:pt idx="6">
                    <c:v>0.83327959842053279</c:v>
                  </c:pt>
                </c:numCache>
              </c:numRef>
            </c:minus>
          </c:errBars>
          <c:cat>
            <c:strRef>
              <c:f>'ADSC PS'!$Q$9:$W$9</c:f>
              <c:strCache>
                <c:ptCount val="7"/>
                <c:pt idx="0">
                  <c:v>CD105</c:v>
                </c:pt>
                <c:pt idx="1">
                  <c:v>CD73</c:v>
                </c:pt>
                <c:pt idx="2">
                  <c:v>CD90</c:v>
                </c:pt>
                <c:pt idx="3">
                  <c:v>CD36</c:v>
                </c:pt>
                <c:pt idx="4">
                  <c:v>CD29</c:v>
                </c:pt>
                <c:pt idx="5">
                  <c:v>CD44</c:v>
                </c:pt>
                <c:pt idx="6">
                  <c:v>VIM</c:v>
                </c:pt>
              </c:strCache>
            </c:strRef>
          </c:cat>
          <c:val>
            <c:numRef>
              <c:f>'ADSC PS'!$Q$12:$W$12</c:f>
              <c:numCache>
                <c:formatCode>General</c:formatCode>
                <c:ptCount val="7"/>
                <c:pt idx="0">
                  <c:v>0.18173392467560232</c:v>
                </c:pt>
                <c:pt idx="1">
                  <c:v>0.11103958970443217</c:v>
                </c:pt>
                <c:pt idx="2">
                  <c:v>3.1494718646732485E-2</c:v>
                </c:pt>
                <c:pt idx="3">
                  <c:v>0.32265637403957131</c:v>
                </c:pt>
                <c:pt idx="4">
                  <c:v>3.0372732647076656E-2</c:v>
                </c:pt>
                <c:pt idx="5">
                  <c:v>11.271491595737464</c:v>
                </c:pt>
                <c:pt idx="6">
                  <c:v>3.761342101030737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6388096"/>
        <c:axId val="106424192"/>
      </c:barChart>
      <c:catAx>
        <c:axId val="1063880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06424192"/>
        <c:crosses val="autoZero"/>
        <c:auto val="1"/>
        <c:lblAlgn val="ctr"/>
        <c:lblOffset val="100"/>
        <c:noMultiLvlLbl val="0"/>
      </c:catAx>
      <c:valAx>
        <c:axId val="106424192"/>
        <c:scaling>
          <c:orientation val="minMax"/>
          <c:max val="15"/>
          <c:min val="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0638809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DSC EJ'!$P$10</c:f>
              <c:strCache>
                <c:ptCount val="1"/>
                <c:pt idx="0">
                  <c:v>ADSC TRIDUC1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EJ'!$Q$9:$W$9</c:f>
              <c:strCache>
                <c:ptCount val="7"/>
                <c:pt idx="0">
                  <c:v>CD105</c:v>
                </c:pt>
                <c:pt idx="1">
                  <c:v>CD73</c:v>
                </c:pt>
                <c:pt idx="2">
                  <c:v>CD90</c:v>
                </c:pt>
                <c:pt idx="3">
                  <c:v>CD36</c:v>
                </c:pt>
                <c:pt idx="4">
                  <c:v>CD29</c:v>
                </c:pt>
                <c:pt idx="5">
                  <c:v>CD44</c:v>
                </c:pt>
                <c:pt idx="6">
                  <c:v>VIM</c:v>
                </c:pt>
              </c:strCache>
            </c:strRef>
          </c:cat>
          <c:val>
            <c:numRef>
              <c:f>'ADSC EJ'!$Q$10:$W$10</c:f>
              <c:numCache>
                <c:formatCode>General</c:formatCode>
                <c:ptCount val="7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EJ'!$P$11</c:f>
              <c:strCache>
                <c:ptCount val="1"/>
                <c:pt idx="0">
                  <c:v>MES TRIDUC1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EJ'!$Q$17:$W$17</c:f>
                <c:numCache>
                  <c:formatCode>General</c:formatCode>
                  <c:ptCount val="7"/>
                  <c:pt idx="0">
                    <c:v>1.1405317045146563E-2</c:v>
                  </c:pt>
                  <c:pt idx="1">
                    <c:v>0.24196563410759406</c:v>
                  </c:pt>
                  <c:pt idx="2">
                    <c:v>0.16969243779796567</c:v>
                  </c:pt>
                  <c:pt idx="3">
                    <c:v>5.9909059616416356E-2</c:v>
                  </c:pt>
                  <c:pt idx="4">
                    <c:v>0.47258021441844589</c:v>
                  </c:pt>
                  <c:pt idx="5">
                    <c:v>8.9574299117288181</c:v>
                  </c:pt>
                  <c:pt idx="6">
                    <c:v>3.4301709781778866</c:v>
                  </c:pt>
                </c:numCache>
              </c:numRef>
            </c:plus>
            <c:minus>
              <c:numRef>
                <c:f>'ADSC EJ'!$Q$17:$W$17</c:f>
                <c:numCache>
                  <c:formatCode>General</c:formatCode>
                  <c:ptCount val="7"/>
                  <c:pt idx="0">
                    <c:v>1.1405317045146563E-2</c:v>
                  </c:pt>
                  <c:pt idx="1">
                    <c:v>0.24196563410759406</c:v>
                  </c:pt>
                  <c:pt idx="2">
                    <c:v>0.16969243779796567</c:v>
                  </c:pt>
                  <c:pt idx="3">
                    <c:v>5.9909059616416356E-2</c:v>
                  </c:pt>
                  <c:pt idx="4">
                    <c:v>0.47258021441844589</c:v>
                  </c:pt>
                  <c:pt idx="5">
                    <c:v>8.9574299117288181</c:v>
                  </c:pt>
                  <c:pt idx="6">
                    <c:v>3.4301709781778866</c:v>
                  </c:pt>
                </c:numCache>
              </c:numRef>
            </c:minus>
          </c:errBars>
          <c:cat>
            <c:strRef>
              <c:f>'ADSC EJ'!$Q$9:$W$9</c:f>
              <c:strCache>
                <c:ptCount val="7"/>
                <c:pt idx="0">
                  <c:v>CD105</c:v>
                </c:pt>
                <c:pt idx="1">
                  <c:v>CD73</c:v>
                </c:pt>
                <c:pt idx="2">
                  <c:v>CD90</c:v>
                </c:pt>
                <c:pt idx="3">
                  <c:v>CD36</c:v>
                </c:pt>
                <c:pt idx="4">
                  <c:v>CD29</c:v>
                </c:pt>
                <c:pt idx="5">
                  <c:v>CD44</c:v>
                </c:pt>
                <c:pt idx="6">
                  <c:v>VIM</c:v>
                </c:pt>
              </c:strCache>
            </c:strRef>
          </c:cat>
          <c:val>
            <c:numRef>
              <c:f>'ADSC EJ'!$Q$11:$W$11</c:f>
              <c:numCache>
                <c:formatCode>General</c:formatCode>
                <c:ptCount val="7"/>
                <c:pt idx="0">
                  <c:v>7.3256155809894544E-2</c:v>
                </c:pt>
                <c:pt idx="1">
                  <c:v>1.4769599757040153</c:v>
                </c:pt>
                <c:pt idx="2">
                  <c:v>0.86596287425294605</c:v>
                </c:pt>
                <c:pt idx="3">
                  <c:v>0.13385902866742996</c:v>
                </c:pt>
                <c:pt idx="4">
                  <c:v>1.4550865894066567</c:v>
                </c:pt>
                <c:pt idx="5">
                  <c:v>43.453800281303039</c:v>
                </c:pt>
                <c:pt idx="6">
                  <c:v>5.695938748769485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7132800"/>
        <c:axId val="107134336"/>
      </c:barChart>
      <c:catAx>
        <c:axId val="1071328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07134336"/>
        <c:crosses val="autoZero"/>
        <c:auto val="1"/>
        <c:lblAlgn val="ctr"/>
        <c:lblOffset val="100"/>
        <c:noMultiLvlLbl val="0"/>
      </c:catAx>
      <c:valAx>
        <c:axId val="107134336"/>
        <c:scaling>
          <c:orientation val="minMax"/>
          <c:max val="53"/>
          <c:min val="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07132800"/>
        <c:crosses val="autoZero"/>
        <c:crossBetween val="between"/>
        <c:majorUnit val="25"/>
        <c:minorUnit val="10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DSC KB'!$P$10</c:f>
              <c:strCache>
                <c:ptCount val="1"/>
                <c:pt idx="0">
                  <c:v>ADSC  NORMA4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KB'!$Q$9:$W$9</c:f>
              <c:strCache>
                <c:ptCount val="7"/>
                <c:pt idx="0">
                  <c:v>CD105</c:v>
                </c:pt>
                <c:pt idx="1">
                  <c:v>CD73</c:v>
                </c:pt>
                <c:pt idx="2">
                  <c:v>CD90</c:v>
                </c:pt>
                <c:pt idx="3">
                  <c:v>CD36</c:v>
                </c:pt>
                <c:pt idx="4">
                  <c:v>CD29</c:v>
                </c:pt>
                <c:pt idx="5">
                  <c:v>CD44</c:v>
                </c:pt>
                <c:pt idx="6">
                  <c:v>VIM</c:v>
                </c:pt>
              </c:strCache>
            </c:strRef>
          </c:cat>
          <c:val>
            <c:numRef>
              <c:f>'ADSC KB'!$Q$10:$W$10</c:f>
              <c:numCache>
                <c:formatCode>General</c:formatCode>
                <c:ptCount val="7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KB'!$P$11</c:f>
              <c:strCache>
                <c:ptCount val="1"/>
                <c:pt idx="0">
                  <c:v>HMEC NORMA4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KB'!$Q$17:$W$17</c:f>
                <c:numCache>
                  <c:formatCode>General</c:formatCode>
                  <c:ptCount val="7"/>
                  <c:pt idx="0">
                    <c:v>8.9862995073803475E-3</c:v>
                  </c:pt>
                  <c:pt idx="1">
                    <c:v>2.429123316723797E-3</c:v>
                  </c:pt>
                  <c:pt idx="2">
                    <c:v>2.6705724632614678E-4</c:v>
                  </c:pt>
                  <c:pt idx="3">
                    <c:v>3.3216501602955826E-3</c:v>
                  </c:pt>
                  <c:pt idx="4">
                    <c:v>3.1814205478476007E-2</c:v>
                  </c:pt>
                  <c:pt idx="5">
                    <c:v>0.14931967337667187</c:v>
                  </c:pt>
                  <c:pt idx="6">
                    <c:v>5.347698808673482E-3</c:v>
                  </c:pt>
                </c:numCache>
              </c:numRef>
            </c:plus>
            <c:minus>
              <c:numRef>
                <c:f>'ADSC KB'!$Q$17:$W$17</c:f>
                <c:numCache>
                  <c:formatCode>General</c:formatCode>
                  <c:ptCount val="7"/>
                  <c:pt idx="0">
                    <c:v>8.9862995073803475E-3</c:v>
                  </c:pt>
                  <c:pt idx="1">
                    <c:v>2.429123316723797E-3</c:v>
                  </c:pt>
                  <c:pt idx="2">
                    <c:v>2.6705724632614678E-4</c:v>
                  </c:pt>
                  <c:pt idx="3">
                    <c:v>3.3216501602955826E-3</c:v>
                  </c:pt>
                  <c:pt idx="4">
                    <c:v>3.1814205478476007E-2</c:v>
                  </c:pt>
                  <c:pt idx="5">
                    <c:v>0.14931967337667187</c:v>
                  </c:pt>
                  <c:pt idx="6">
                    <c:v>5.347698808673482E-3</c:v>
                  </c:pt>
                </c:numCache>
              </c:numRef>
            </c:minus>
          </c:errBars>
          <c:cat>
            <c:strRef>
              <c:f>'ADSC KB'!$Q$9:$W$9</c:f>
              <c:strCache>
                <c:ptCount val="7"/>
                <c:pt idx="0">
                  <c:v>CD105</c:v>
                </c:pt>
                <c:pt idx="1">
                  <c:v>CD73</c:v>
                </c:pt>
                <c:pt idx="2">
                  <c:v>CD90</c:v>
                </c:pt>
                <c:pt idx="3">
                  <c:v>CD36</c:v>
                </c:pt>
                <c:pt idx="4">
                  <c:v>CD29</c:v>
                </c:pt>
                <c:pt idx="5">
                  <c:v>CD44</c:v>
                </c:pt>
                <c:pt idx="6">
                  <c:v>VIM</c:v>
                </c:pt>
              </c:strCache>
            </c:strRef>
          </c:cat>
          <c:val>
            <c:numRef>
              <c:f>'ADSC KB'!$Q$11:$W$11</c:f>
              <c:numCache>
                <c:formatCode>General</c:formatCode>
                <c:ptCount val="7"/>
                <c:pt idx="0">
                  <c:v>5.3830964591755015E-2</c:v>
                </c:pt>
                <c:pt idx="1">
                  <c:v>1.1547662481461241E-2</c:v>
                </c:pt>
                <c:pt idx="2">
                  <c:v>1.5637000471008487E-3</c:v>
                </c:pt>
                <c:pt idx="3">
                  <c:v>3.737243714068755E-3</c:v>
                </c:pt>
                <c:pt idx="4">
                  <c:v>0.1420637059215612</c:v>
                </c:pt>
                <c:pt idx="5">
                  <c:v>0.42222500679489494</c:v>
                </c:pt>
                <c:pt idx="6">
                  <c:v>2.8866124830886287E-2</c:v>
                </c:pt>
              </c:numCache>
            </c:numRef>
          </c:val>
        </c:ser>
        <c:ser>
          <c:idx val="2"/>
          <c:order val="2"/>
          <c:tx>
            <c:strRef>
              <c:f>'ADSC KB'!$P$12</c:f>
              <c:strCache>
                <c:ptCount val="1"/>
                <c:pt idx="0">
                  <c:v>Mes NORMA4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KB'!$Q$18:$W$18</c:f>
                <c:numCache>
                  <c:formatCode>General</c:formatCode>
                  <c:ptCount val="7"/>
                  <c:pt idx="0">
                    <c:v>3.9217757096877467E-3</c:v>
                  </c:pt>
                  <c:pt idx="1">
                    <c:v>0.31159207001479045</c:v>
                  </c:pt>
                  <c:pt idx="2">
                    <c:v>5.2018116600533381E-3</c:v>
                  </c:pt>
                  <c:pt idx="3">
                    <c:v>7.9662499290706137E-2</c:v>
                  </c:pt>
                  <c:pt idx="4">
                    <c:v>0.40287023249002396</c:v>
                  </c:pt>
                  <c:pt idx="5">
                    <c:v>0.37246413231844927</c:v>
                  </c:pt>
                  <c:pt idx="6">
                    <c:v>0.25605148663416832</c:v>
                  </c:pt>
                </c:numCache>
              </c:numRef>
            </c:plus>
            <c:minus>
              <c:numRef>
                <c:f>'ADSC KB'!$Q$18:$W$18</c:f>
                <c:numCache>
                  <c:formatCode>General</c:formatCode>
                  <c:ptCount val="7"/>
                  <c:pt idx="0">
                    <c:v>3.9217757096877467E-3</c:v>
                  </c:pt>
                  <c:pt idx="1">
                    <c:v>0.31159207001479045</c:v>
                  </c:pt>
                  <c:pt idx="2">
                    <c:v>5.2018116600533381E-3</c:v>
                  </c:pt>
                  <c:pt idx="3">
                    <c:v>7.9662499290706137E-2</c:v>
                  </c:pt>
                  <c:pt idx="4">
                    <c:v>0.40287023249002396</c:v>
                  </c:pt>
                  <c:pt idx="5">
                    <c:v>0.37246413231844927</c:v>
                  </c:pt>
                  <c:pt idx="6">
                    <c:v>0.25605148663416832</c:v>
                  </c:pt>
                </c:numCache>
              </c:numRef>
            </c:minus>
          </c:errBars>
          <c:cat>
            <c:strRef>
              <c:f>'ADSC KB'!$Q$9:$W$9</c:f>
              <c:strCache>
                <c:ptCount val="7"/>
                <c:pt idx="0">
                  <c:v>CD105</c:v>
                </c:pt>
                <c:pt idx="1">
                  <c:v>CD73</c:v>
                </c:pt>
                <c:pt idx="2">
                  <c:v>CD90</c:v>
                </c:pt>
                <c:pt idx="3">
                  <c:v>CD36</c:v>
                </c:pt>
                <c:pt idx="4">
                  <c:v>CD29</c:v>
                </c:pt>
                <c:pt idx="5">
                  <c:v>CD44</c:v>
                </c:pt>
                <c:pt idx="6">
                  <c:v>VIM</c:v>
                </c:pt>
              </c:strCache>
            </c:strRef>
          </c:cat>
          <c:val>
            <c:numRef>
              <c:f>'ADSC KB'!$Q$12:$W$12</c:f>
              <c:numCache>
                <c:formatCode>General</c:formatCode>
                <c:ptCount val="7"/>
                <c:pt idx="0">
                  <c:v>7.5569320475232613E-2</c:v>
                </c:pt>
                <c:pt idx="1">
                  <c:v>0.99273488780073482</c:v>
                </c:pt>
                <c:pt idx="2">
                  <c:v>1.3562825783096852E-2</c:v>
                </c:pt>
                <c:pt idx="3">
                  <c:v>0.32361437526728215</c:v>
                </c:pt>
                <c:pt idx="4">
                  <c:v>1.7453661218664804</c:v>
                </c:pt>
                <c:pt idx="5">
                  <c:v>1.0520469043415115</c:v>
                </c:pt>
                <c:pt idx="6">
                  <c:v>1.201311391162699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0277376"/>
        <c:axId val="118903936"/>
      </c:barChart>
      <c:catAx>
        <c:axId val="1102773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18903936"/>
        <c:crosses val="autoZero"/>
        <c:auto val="1"/>
        <c:lblAlgn val="ctr"/>
        <c:lblOffset val="100"/>
        <c:noMultiLvlLbl val="0"/>
      </c:catAx>
      <c:valAx>
        <c:axId val="118903936"/>
        <c:scaling>
          <c:orientation val="minMax"/>
          <c:max val="2.2000000000000002"/>
          <c:min val="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10277376"/>
        <c:crosses val="autoZero"/>
        <c:crossBetween val="between"/>
        <c:majorUnit val="1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DSC MBE'!$P$10</c:f>
              <c:strCache>
                <c:ptCount val="1"/>
                <c:pt idx="0">
                  <c:v>ADSC  NORMA3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MBE'!$Q$9:$W$9</c:f>
              <c:strCache>
                <c:ptCount val="7"/>
                <c:pt idx="0">
                  <c:v>CD105</c:v>
                </c:pt>
                <c:pt idx="1">
                  <c:v>CD73</c:v>
                </c:pt>
                <c:pt idx="2">
                  <c:v>CD90</c:v>
                </c:pt>
                <c:pt idx="3">
                  <c:v>CD36</c:v>
                </c:pt>
                <c:pt idx="4">
                  <c:v>CD29</c:v>
                </c:pt>
                <c:pt idx="5">
                  <c:v>CD44</c:v>
                </c:pt>
                <c:pt idx="6">
                  <c:v>VIM</c:v>
                </c:pt>
              </c:strCache>
            </c:strRef>
          </c:cat>
          <c:val>
            <c:numRef>
              <c:f>'ADSC MBE'!$Q$10:$W$10</c:f>
              <c:numCache>
                <c:formatCode>General</c:formatCode>
                <c:ptCount val="7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MBE'!$P$11</c:f>
              <c:strCache>
                <c:ptCount val="1"/>
                <c:pt idx="0">
                  <c:v>HMEC NORMA3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MBE'!$Q$17:$W$17</c:f>
                <c:numCache>
                  <c:formatCode>General</c:formatCode>
                  <c:ptCount val="7"/>
                  <c:pt idx="0">
                    <c:v>4.0213730672437218E-3</c:v>
                  </c:pt>
                  <c:pt idx="1">
                    <c:v>1.3786732674299374E-2</c:v>
                  </c:pt>
                  <c:pt idx="2">
                    <c:v>3.1782782418943905E-3</c:v>
                  </c:pt>
                  <c:pt idx="3">
                    <c:v>4.3129068246266474E-3</c:v>
                  </c:pt>
                  <c:pt idx="4">
                    <c:v>0.3113632037992996</c:v>
                  </c:pt>
                  <c:pt idx="5">
                    <c:v>0.29558411067264728</c:v>
                  </c:pt>
                  <c:pt idx="6">
                    <c:v>2.3977041483834928E-2</c:v>
                  </c:pt>
                </c:numCache>
              </c:numRef>
            </c:plus>
            <c:minus>
              <c:numRef>
                <c:f>'ADSC MBE'!$Q$17:$W$17</c:f>
                <c:numCache>
                  <c:formatCode>General</c:formatCode>
                  <c:ptCount val="7"/>
                  <c:pt idx="0">
                    <c:v>4.0213730672437218E-3</c:v>
                  </c:pt>
                  <c:pt idx="1">
                    <c:v>1.3786732674299374E-2</c:v>
                  </c:pt>
                  <c:pt idx="2">
                    <c:v>3.1782782418943905E-3</c:v>
                  </c:pt>
                  <c:pt idx="3">
                    <c:v>4.3129068246266474E-3</c:v>
                  </c:pt>
                  <c:pt idx="4">
                    <c:v>0.3113632037992996</c:v>
                  </c:pt>
                  <c:pt idx="5">
                    <c:v>0.29558411067264728</c:v>
                  </c:pt>
                  <c:pt idx="6">
                    <c:v>2.3977041483834928E-2</c:v>
                  </c:pt>
                </c:numCache>
              </c:numRef>
            </c:minus>
          </c:errBars>
          <c:cat>
            <c:strRef>
              <c:f>'ADSC MBE'!$Q$9:$W$9</c:f>
              <c:strCache>
                <c:ptCount val="7"/>
                <c:pt idx="0">
                  <c:v>CD105</c:v>
                </c:pt>
                <c:pt idx="1">
                  <c:v>CD73</c:v>
                </c:pt>
                <c:pt idx="2">
                  <c:v>CD90</c:v>
                </c:pt>
                <c:pt idx="3">
                  <c:v>CD36</c:v>
                </c:pt>
                <c:pt idx="4">
                  <c:v>CD29</c:v>
                </c:pt>
                <c:pt idx="5">
                  <c:v>CD44</c:v>
                </c:pt>
                <c:pt idx="6">
                  <c:v>VIM</c:v>
                </c:pt>
              </c:strCache>
            </c:strRef>
          </c:cat>
          <c:val>
            <c:numRef>
              <c:f>'ADSC MBE'!$Q$11:$W$11</c:f>
              <c:numCache>
                <c:formatCode>General</c:formatCode>
                <c:ptCount val="7"/>
                <c:pt idx="0">
                  <c:v>6.0235741098760488E-2</c:v>
                </c:pt>
                <c:pt idx="1">
                  <c:v>0.56027210963402596</c:v>
                </c:pt>
                <c:pt idx="2">
                  <c:v>0.34550763834570714</c:v>
                </c:pt>
                <c:pt idx="3">
                  <c:v>8.673579525535562E-3</c:v>
                </c:pt>
                <c:pt idx="4">
                  <c:v>0.69601645279632229</c:v>
                </c:pt>
                <c:pt idx="5">
                  <c:v>1.7393166508670383</c:v>
                </c:pt>
                <c:pt idx="6">
                  <c:v>0.34082638215370559</c:v>
                </c:pt>
              </c:numCache>
            </c:numRef>
          </c:val>
        </c:ser>
        <c:ser>
          <c:idx val="2"/>
          <c:order val="2"/>
          <c:tx>
            <c:strRef>
              <c:f>'ADSC MBE'!$P$12</c:f>
              <c:strCache>
                <c:ptCount val="1"/>
                <c:pt idx="0">
                  <c:v>MES NORMA3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MBE'!$Q$18:$W$18</c:f>
                <c:numCache>
                  <c:formatCode>General</c:formatCode>
                  <c:ptCount val="7"/>
                  <c:pt idx="0">
                    <c:v>4.2928459032776948E-3</c:v>
                  </c:pt>
                  <c:pt idx="1">
                    <c:v>5.8557351105237465E-2</c:v>
                  </c:pt>
                  <c:pt idx="2">
                    <c:v>4.1392101412369819E-2</c:v>
                  </c:pt>
                  <c:pt idx="3">
                    <c:v>5.5709403318769521E-3</c:v>
                  </c:pt>
                  <c:pt idx="4">
                    <c:v>0.1122201101842622</c:v>
                  </c:pt>
                  <c:pt idx="5">
                    <c:v>1.890301422413251E-2</c:v>
                  </c:pt>
                  <c:pt idx="6">
                    <c:v>8.664601170496937E-2</c:v>
                  </c:pt>
                </c:numCache>
              </c:numRef>
            </c:plus>
            <c:minus>
              <c:numRef>
                <c:f>'ADSC MBE'!$Q$18:$W$18</c:f>
                <c:numCache>
                  <c:formatCode>General</c:formatCode>
                  <c:ptCount val="7"/>
                  <c:pt idx="0">
                    <c:v>4.2928459032776948E-3</c:v>
                  </c:pt>
                  <c:pt idx="1">
                    <c:v>5.8557351105237465E-2</c:v>
                  </c:pt>
                  <c:pt idx="2">
                    <c:v>4.1392101412369819E-2</c:v>
                  </c:pt>
                  <c:pt idx="3">
                    <c:v>5.5709403318769521E-3</c:v>
                  </c:pt>
                  <c:pt idx="4">
                    <c:v>0.1122201101842622</c:v>
                  </c:pt>
                  <c:pt idx="5">
                    <c:v>1.890301422413251E-2</c:v>
                  </c:pt>
                  <c:pt idx="6">
                    <c:v>8.664601170496937E-2</c:v>
                  </c:pt>
                </c:numCache>
              </c:numRef>
            </c:minus>
          </c:errBars>
          <c:cat>
            <c:strRef>
              <c:f>'ADSC MBE'!$Q$9:$W$9</c:f>
              <c:strCache>
                <c:ptCount val="7"/>
                <c:pt idx="0">
                  <c:v>CD105</c:v>
                </c:pt>
                <c:pt idx="1">
                  <c:v>CD73</c:v>
                </c:pt>
                <c:pt idx="2">
                  <c:v>CD90</c:v>
                </c:pt>
                <c:pt idx="3">
                  <c:v>CD36</c:v>
                </c:pt>
                <c:pt idx="4">
                  <c:v>CD29</c:v>
                </c:pt>
                <c:pt idx="5">
                  <c:v>CD44</c:v>
                </c:pt>
                <c:pt idx="6">
                  <c:v>VIM</c:v>
                </c:pt>
              </c:strCache>
            </c:strRef>
          </c:cat>
          <c:val>
            <c:numRef>
              <c:f>'ADSC MBE'!$Q$12:$W$12</c:f>
              <c:numCache>
                <c:formatCode>General</c:formatCode>
                <c:ptCount val="7"/>
                <c:pt idx="0">
                  <c:v>2.0663433704537933E-2</c:v>
                </c:pt>
                <c:pt idx="1">
                  <c:v>0.32289431550547659</c:v>
                </c:pt>
                <c:pt idx="2">
                  <c:v>0.30024113402272823</c:v>
                </c:pt>
                <c:pt idx="3">
                  <c:v>8.7530963663634928E-2</c:v>
                </c:pt>
                <c:pt idx="4">
                  <c:v>0.87177001776071805</c:v>
                </c:pt>
                <c:pt idx="5">
                  <c:v>0.62907860329098275</c:v>
                </c:pt>
                <c:pt idx="6">
                  <c:v>0.8461802816236989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1454592"/>
        <c:axId val="121456512"/>
      </c:barChart>
      <c:catAx>
        <c:axId val="1214545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21456512"/>
        <c:crosses val="autoZero"/>
        <c:auto val="1"/>
        <c:lblAlgn val="ctr"/>
        <c:lblOffset val="100"/>
        <c:noMultiLvlLbl val="0"/>
      </c:catAx>
      <c:valAx>
        <c:axId val="121456512"/>
        <c:scaling>
          <c:orientation val="minMax"/>
          <c:max val="2.2999999999999998"/>
          <c:min val="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21454592"/>
        <c:crosses val="autoZero"/>
        <c:crossBetween val="between"/>
        <c:majorUnit val="1"/>
        <c:minorUnit val="1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DSC SLA'!$P$10</c:f>
              <c:strCache>
                <c:ptCount val="1"/>
                <c:pt idx="0">
                  <c:v>ADSC  NORMA2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SLA'!$Q$9:$W$9</c:f>
              <c:strCache>
                <c:ptCount val="7"/>
                <c:pt idx="0">
                  <c:v>CD105</c:v>
                </c:pt>
                <c:pt idx="1">
                  <c:v>CD73</c:v>
                </c:pt>
                <c:pt idx="2">
                  <c:v>CD90</c:v>
                </c:pt>
                <c:pt idx="3">
                  <c:v>CD36</c:v>
                </c:pt>
                <c:pt idx="4">
                  <c:v>CD29</c:v>
                </c:pt>
                <c:pt idx="5">
                  <c:v>CD44</c:v>
                </c:pt>
                <c:pt idx="6">
                  <c:v>VIM</c:v>
                </c:pt>
              </c:strCache>
            </c:strRef>
          </c:cat>
          <c:val>
            <c:numRef>
              <c:f>'ADSC SLA'!$Q$10:$W$10</c:f>
              <c:numCache>
                <c:formatCode>General</c:formatCode>
                <c:ptCount val="7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SLA'!$P$11</c:f>
              <c:strCache>
                <c:ptCount val="1"/>
                <c:pt idx="0">
                  <c:v>HMEC NORMA2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SLA'!$Q$18:$Y$18</c:f>
                <c:numCache>
                  <c:formatCode>General</c:formatCode>
                  <c:ptCount val="9"/>
                  <c:pt idx="0">
                    <c:v>5.1921719062711742E-3</c:v>
                  </c:pt>
                  <c:pt idx="1">
                    <c:v>4.0501335245566997E-2</c:v>
                  </c:pt>
                  <c:pt idx="2">
                    <c:v>3.6696144145985377E-3</c:v>
                  </c:pt>
                  <c:pt idx="3">
                    <c:v>6.5780514049365476E-5</c:v>
                  </c:pt>
                  <c:pt idx="4">
                    <c:v>4.25450753185398E-2</c:v>
                  </c:pt>
                  <c:pt idx="5">
                    <c:v>0.16212408024914376</c:v>
                  </c:pt>
                  <c:pt idx="6">
                    <c:v>1.3768557885567544E-2</c:v>
                  </c:pt>
                </c:numCache>
              </c:numRef>
            </c:plus>
            <c:minus>
              <c:numRef>
                <c:f>'ADSC SLA'!$Q$18:$Y$18</c:f>
                <c:numCache>
                  <c:formatCode>General</c:formatCode>
                  <c:ptCount val="9"/>
                  <c:pt idx="0">
                    <c:v>5.1921719062711742E-3</c:v>
                  </c:pt>
                  <c:pt idx="1">
                    <c:v>4.0501335245566997E-2</c:v>
                  </c:pt>
                  <c:pt idx="2">
                    <c:v>3.6696144145985377E-3</c:v>
                  </c:pt>
                  <c:pt idx="3">
                    <c:v>6.5780514049365476E-5</c:v>
                  </c:pt>
                  <c:pt idx="4">
                    <c:v>4.25450753185398E-2</c:v>
                  </c:pt>
                  <c:pt idx="5">
                    <c:v>0.16212408024914376</c:v>
                  </c:pt>
                  <c:pt idx="6">
                    <c:v>1.3768557885567544E-2</c:v>
                  </c:pt>
                </c:numCache>
              </c:numRef>
            </c:minus>
          </c:errBars>
          <c:cat>
            <c:strRef>
              <c:f>'ADSC SLA'!$Q$9:$W$9</c:f>
              <c:strCache>
                <c:ptCount val="7"/>
                <c:pt idx="0">
                  <c:v>CD105</c:v>
                </c:pt>
                <c:pt idx="1">
                  <c:v>CD73</c:v>
                </c:pt>
                <c:pt idx="2">
                  <c:v>CD90</c:v>
                </c:pt>
                <c:pt idx="3">
                  <c:v>CD36</c:v>
                </c:pt>
                <c:pt idx="4">
                  <c:v>CD29</c:v>
                </c:pt>
                <c:pt idx="5">
                  <c:v>CD44</c:v>
                </c:pt>
                <c:pt idx="6">
                  <c:v>VIM</c:v>
                </c:pt>
              </c:strCache>
            </c:strRef>
          </c:cat>
          <c:val>
            <c:numRef>
              <c:f>'ADSC SLA'!$Q$11:$W$11</c:f>
              <c:numCache>
                <c:formatCode>General</c:formatCode>
                <c:ptCount val="7"/>
                <c:pt idx="0">
                  <c:v>2.4015517210350949E-2</c:v>
                </c:pt>
                <c:pt idx="1">
                  <c:v>0.26990630614405392</c:v>
                </c:pt>
                <c:pt idx="2">
                  <c:v>2.7375924962761412E-2</c:v>
                </c:pt>
                <c:pt idx="3">
                  <c:v>1.2405671119825217E-4</c:v>
                </c:pt>
                <c:pt idx="4">
                  <c:v>0.45784961934871271</c:v>
                </c:pt>
                <c:pt idx="5">
                  <c:v>0.52913037931753892</c:v>
                </c:pt>
                <c:pt idx="6">
                  <c:v>5.9886417798569548E-2</c:v>
                </c:pt>
              </c:numCache>
            </c:numRef>
          </c:val>
        </c:ser>
        <c:ser>
          <c:idx val="2"/>
          <c:order val="2"/>
          <c:tx>
            <c:strRef>
              <c:f>'ADSC SLA'!$P$12</c:f>
              <c:strCache>
                <c:ptCount val="1"/>
                <c:pt idx="0">
                  <c:v>Mes NORMA2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SLA'!$Q$19:$Y$19</c:f>
                <c:numCache>
                  <c:formatCode>General</c:formatCode>
                  <c:ptCount val="9"/>
                  <c:pt idx="0">
                    <c:v>2.6106493464481354E-3</c:v>
                  </c:pt>
                  <c:pt idx="1">
                    <c:v>0.20667604509434467</c:v>
                  </c:pt>
                  <c:pt idx="2">
                    <c:v>1.0189163887778432E-2</c:v>
                  </c:pt>
                  <c:pt idx="3">
                    <c:v>5.3372480118742092E-3</c:v>
                  </c:pt>
                  <c:pt idx="4">
                    <c:v>6.8034263519293134E-2</c:v>
                  </c:pt>
                  <c:pt idx="5">
                    <c:v>0.13753877813707452</c:v>
                  </c:pt>
                  <c:pt idx="6">
                    <c:v>0.11546937780332182</c:v>
                  </c:pt>
                </c:numCache>
              </c:numRef>
            </c:plus>
            <c:minus>
              <c:numRef>
                <c:f>'ADSC SLA'!$Q$19:$Y$19</c:f>
                <c:numCache>
                  <c:formatCode>General</c:formatCode>
                  <c:ptCount val="9"/>
                  <c:pt idx="0">
                    <c:v>2.6106493464481354E-3</c:v>
                  </c:pt>
                  <c:pt idx="1">
                    <c:v>0.20667604509434467</c:v>
                  </c:pt>
                  <c:pt idx="2">
                    <c:v>1.0189163887778432E-2</c:v>
                  </c:pt>
                  <c:pt idx="3">
                    <c:v>5.3372480118742092E-3</c:v>
                  </c:pt>
                  <c:pt idx="4">
                    <c:v>6.8034263519293134E-2</c:v>
                  </c:pt>
                  <c:pt idx="5">
                    <c:v>0.13753877813707452</c:v>
                  </c:pt>
                  <c:pt idx="6">
                    <c:v>0.11546937780332182</c:v>
                  </c:pt>
                </c:numCache>
              </c:numRef>
            </c:minus>
          </c:errBars>
          <c:cat>
            <c:strRef>
              <c:f>'ADSC SLA'!$Q$9:$W$9</c:f>
              <c:strCache>
                <c:ptCount val="7"/>
                <c:pt idx="0">
                  <c:v>CD105</c:v>
                </c:pt>
                <c:pt idx="1">
                  <c:v>CD73</c:v>
                </c:pt>
                <c:pt idx="2">
                  <c:v>CD90</c:v>
                </c:pt>
                <c:pt idx="3">
                  <c:v>CD36</c:v>
                </c:pt>
                <c:pt idx="4">
                  <c:v>CD29</c:v>
                </c:pt>
                <c:pt idx="5">
                  <c:v>CD44</c:v>
                </c:pt>
                <c:pt idx="6">
                  <c:v>VIM</c:v>
                </c:pt>
              </c:strCache>
            </c:strRef>
          </c:cat>
          <c:val>
            <c:numRef>
              <c:f>'ADSC SLA'!$Q$12:$W$12</c:f>
              <c:numCache>
                <c:formatCode>General</c:formatCode>
                <c:ptCount val="7"/>
                <c:pt idx="0">
                  <c:v>1.3812311593685607E-2</c:v>
                </c:pt>
                <c:pt idx="1">
                  <c:v>0.43455292786495253</c:v>
                </c:pt>
                <c:pt idx="2">
                  <c:v>4.1790096097699431E-2</c:v>
                </c:pt>
                <c:pt idx="3">
                  <c:v>1.2320867964584302E-2</c:v>
                </c:pt>
                <c:pt idx="4">
                  <c:v>0.3061839346422463</c:v>
                </c:pt>
                <c:pt idx="5">
                  <c:v>0.5565090223167023</c:v>
                </c:pt>
                <c:pt idx="6">
                  <c:v>0.360116228924615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1191168"/>
        <c:axId val="131192704"/>
      </c:barChart>
      <c:catAx>
        <c:axId val="1311911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31192704"/>
        <c:crosses val="autoZero"/>
        <c:auto val="1"/>
        <c:lblAlgn val="ctr"/>
        <c:lblOffset val="100"/>
        <c:noMultiLvlLbl val="0"/>
      </c:catAx>
      <c:valAx>
        <c:axId val="13119270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3119116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DSC PS'!$P$24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PS'!$R$23:$V$23</c:f>
              <c:strCache>
                <c:ptCount val="5"/>
                <c:pt idx="0">
                  <c:v>CD14</c:v>
                </c:pt>
                <c:pt idx="1">
                  <c:v>CD19</c:v>
                </c:pt>
                <c:pt idx="2">
                  <c:v>CD34</c:v>
                </c:pt>
                <c:pt idx="3">
                  <c:v>CD45</c:v>
                </c:pt>
                <c:pt idx="4">
                  <c:v>HLA-DR</c:v>
                </c:pt>
              </c:strCache>
            </c:strRef>
          </c:cat>
          <c:val>
            <c:numRef>
              <c:f>'ADSC PS'!$R$24:$V$24</c:f>
              <c:numCache>
                <c:formatCode>General</c:formatCode>
                <c:ptCount val="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PS'!$P$25</c:f>
              <c:strCache>
                <c:ptCount val="1"/>
                <c:pt idx="0">
                  <c:v>ADSC  IFDUC1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PS'!$R$31:$W$31</c:f>
                <c:numCache>
                  <c:formatCode>General</c:formatCode>
                  <c:ptCount val="6"/>
                  <c:pt idx="0">
                    <c:v>1.3385987697768183E-3</c:v>
                  </c:pt>
                  <c:pt idx="1">
                    <c:v>7.0099543130702505E-2</c:v>
                  </c:pt>
                  <c:pt idx="2">
                    <c:v>0.32473914816518068</c:v>
                  </c:pt>
                  <c:pt idx="3">
                    <c:v>7.9926929045526826E-4</c:v>
                  </c:pt>
                  <c:pt idx="4">
                    <c:v>4.7283519810113398E-7</c:v>
                  </c:pt>
                </c:numCache>
              </c:numRef>
            </c:plus>
            <c:minus>
              <c:numRef>
                <c:f>'ADSC PS'!$R$31:$W$31</c:f>
                <c:numCache>
                  <c:formatCode>General</c:formatCode>
                  <c:ptCount val="6"/>
                  <c:pt idx="0">
                    <c:v>1.3385987697768183E-3</c:v>
                  </c:pt>
                  <c:pt idx="1">
                    <c:v>7.0099543130702505E-2</c:v>
                  </c:pt>
                  <c:pt idx="2">
                    <c:v>0.32473914816518068</c:v>
                  </c:pt>
                  <c:pt idx="3">
                    <c:v>7.9926929045526826E-4</c:v>
                  </c:pt>
                  <c:pt idx="4">
                    <c:v>4.7283519810113398E-7</c:v>
                  </c:pt>
                </c:numCache>
              </c:numRef>
            </c:minus>
          </c:errBars>
          <c:cat>
            <c:strRef>
              <c:f>'ADSC PS'!$R$23:$V$23</c:f>
              <c:strCache>
                <c:ptCount val="5"/>
                <c:pt idx="0">
                  <c:v>CD14</c:v>
                </c:pt>
                <c:pt idx="1">
                  <c:v>CD19</c:v>
                </c:pt>
                <c:pt idx="2">
                  <c:v>CD34</c:v>
                </c:pt>
                <c:pt idx="3">
                  <c:v>CD45</c:v>
                </c:pt>
                <c:pt idx="4">
                  <c:v>HLA-DR</c:v>
                </c:pt>
              </c:strCache>
            </c:strRef>
          </c:cat>
          <c:val>
            <c:numRef>
              <c:f>'ADSC PS'!$R$25:$V$25</c:f>
              <c:numCache>
                <c:formatCode>General</c:formatCode>
                <c:ptCount val="5"/>
                <c:pt idx="0">
                  <c:v>5.5896687114984954E-3</c:v>
                </c:pt>
                <c:pt idx="1">
                  <c:v>7.1487266533303159E-2</c:v>
                </c:pt>
                <c:pt idx="2">
                  <c:v>0.76712943971317726</c:v>
                </c:pt>
                <c:pt idx="3">
                  <c:v>1.3954250802517404E-3</c:v>
                </c:pt>
                <c:pt idx="4">
                  <c:v>3.8167115637313782E-6</c:v>
                </c:pt>
              </c:numCache>
            </c:numRef>
          </c:val>
        </c:ser>
        <c:ser>
          <c:idx val="2"/>
          <c:order val="2"/>
          <c:tx>
            <c:strRef>
              <c:f>'ADSC PS'!$P$26</c:f>
              <c:strCache>
                <c:ptCount val="1"/>
                <c:pt idx="0">
                  <c:v>HMEC IFDUC1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PS'!$R$32:$V$32</c:f>
                <c:numCache>
                  <c:formatCode>General</c:formatCode>
                  <c:ptCount val="5"/>
                  <c:pt idx="0">
                    <c:v>3.1848297653501532E-3</c:v>
                  </c:pt>
                  <c:pt idx="1">
                    <c:v>1.4543850182747176E-2</c:v>
                  </c:pt>
                  <c:pt idx="2">
                    <c:v>1.053456063537383E-2</c:v>
                  </c:pt>
                  <c:pt idx="3">
                    <c:v>6.2595256927966647E-5</c:v>
                  </c:pt>
                  <c:pt idx="4">
                    <c:v>4.008358880770986E-5</c:v>
                  </c:pt>
                </c:numCache>
              </c:numRef>
            </c:plus>
            <c:minus>
              <c:numRef>
                <c:f>'ADSC PS'!$R$32:$V$32</c:f>
                <c:numCache>
                  <c:formatCode>General</c:formatCode>
                  <c:ptCount val="5"/>
                  <c:pt idx="0">
                    <c:v>3.1848297653501532E-3</c:v>
                  </c:pt>
                  <c:pt idx="1">
                    <c:v>1.4543850182747176E-2</c:v>
                  </c:pt>
                  <c:pt idx="2">
                    <c:v>1.053456063537383E-2</c:v>
                  </c:pt>
                  <c:pt idx="3">
                    <c:v>6.2595256927966647E-5</c:v>
                  </c:pt>
                  <c:pt idx="4">
                    <c:v>4.008358880770986E-5</c:v>
                  </c:pt>
                </c:numCache>
              </c:numRef>
            </c:minus>
          </c:errBars>
          <c:cat>
            <c:strRef>
              <c:f>'ADSC PS'!$R$23:$V$23</c:f>
              <c:strCache>
                <c:ptCount val="5"/>
                <c:pt idx="0">
                  <c:v>CD14</c:v>
                </c:pt>
                <c:pt idx="1">
                  <c:v>CD19</c:v>
                </c:pt>
                <c:pt idx="2">
                  <c:v>CD34</c:v>
                </c:pt>
                <c:pt idx="3">
                  <c:v>CD45</c:v>
                </c:pt>
                <c:pt idx="4">
                  <c:v>HLA-DR</c:v>
                </c:pt>
              </c:strCache>
            </c:strRef>
          </c:cat>
          <c:val>
            <c:numRef>
              <c:f>'ADSC PS'!$R$26:$V$26</c:f>
              <c:numCache>
                <c:formatCode>General</c:formatCode>
                <c:ptCount val="5"/>
                <c:pt idx="0">
                  <c:v>7.4928966243612664E-3</c:v>
                </c:pt>
                <c:pt idx="1">
                  <c:v>1.4801204205364146E-2</c:v>
                </c:pt>
                <c:pt idx="2">
                  <c:v>1.1063300248025281E-2</c:v>
                </c:pt>
                <c:pt idx="3">
                  <c:v>1.925242193189103E-4</c:v>
                </c:pt>
                <c:pt idx="4">
                  <c:v>1.5397921765741756E-4</c:v>
                </c:pt>
              </c:numCache>
            </c:numRef>
          </c:val>
        </c:ser>
        <c:ser>
          <c:idx val="3"/>
          <c:order val="3"/>
          <c:tx>
            <c:strRef>
              <c:f>'ADSC PS'!$P$27</c:f>
              <c:strCache>
                <c:ptCount val="1"/>
                <c:pt idx="0">
                  <c:v>MES IFDUC1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PS'!$R$33:$V$33</c:f>
                <c:numCache>
                  <c:formatCode>General</c:formatCode>
                  <c:ptCount val="5"/>
                  <c:pt idx="0">
                    <c:v>2.0743395627202135E-2</c:v>
                  </c:pt>
                  <c:pt idx="1">
                    <c:v>0.12476394439861443</c:v>
                  </c:pt>
                  <c:pt idx="2">
                    <c:v>7.6310069874271219E-2</c:v>
                  </c:pt>
                  <c:pt idx="3">
                    <c:v>3.7210450446560897E-3</c:v>
                  </c:pt>
                  <c:pt idx="4">
                    <c:v>3.1654316695391691E-5</c:v>
                  </c:pt>
                </c:numCache>
              </c:numRef>
            </c:plus>
            <c:minus>
              <c:numRef>
                <c:f>'ADSC PS'!$R$33:$V$33</c:f>
                <c:numCache>
                  <c:formatCode>General</c:formatCode>
                  <c:ptCount val="5"/>
                  <c:pt idx="0">
                    <c:v>2.0743395627202135E-2</c:v>
                  </c:pt>
                  <c:pt idx="1">
                    <c:v>0.12476394439861443</c:v>
                  </c:pt>
                  <c:pt idx="2">
                    <c:v>7.6310069874271219E-2</c:v>
                  </c:pt>
                  <c:pt idx="3">
                    <c:v>3.7210450446560897E-3</c:v>
                  </c:pt>
                  <c:pt idx="4">
                    <c:v>3.1654316695391691E-5</c:v>
                  </c:pt>
                </c:numCache>
              </c:numRef>
            </c:minus>
          </c:errBars>
          <c:cat>
            <c:strRef>
              <c:f>'ADSC PS'!$R$23:$V$23</c:f>
              <c:strCache>
                <c:ptCount val="5"/>
                <c:pt idx="0">
                  <c:v>CD14</c:v>
                </c:pt>
                <c:pt idx="1">
                  <c:v>CD19</c:v>
                </c:pt>
                <c:pt idx="2">
                  <c:v>CD34</c:v>
                </c:pt>
                <c:pt idx="3">
                  <c:v>CD45</c:v>
                </c:pt>
                <c:pt idx="4">
                  <c:v>HLA-DR</c:v>
                </c:pt>
              </c:strCache>
            </c:strRef>
          </c:cat>
          <c:val>
            <c:numRef>
              <c:f>'ADSC PS'!$R$27:$V$27</c:f>
              <c:numCache>
                <c:formatCode>General</c:formatCode>
                <c:ptCount val="5"/>
                <c:pt idx="0">
                  <c:v>7.7353898719807121E-2</c:v>
                </c:pt>
                <c:pt idx="1">
                  <c:v>0.21428205148222704</c:v>
                </c:pt>
                <c:pt idx="2">
                  <c:v>0.11781276570202691</c:v>
                </c:pt>
                <c:pt idx="3">
                  <c:v>6.8649826901169267E-3</c:v>
                </c:pt>
                <c:pt idx="4">
                  <c:v>2.3776326268229233E-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3539200"/>
        <c:axId val="143586048"/>
      </c:barChart>
      <c:catAx>
        <c:axId val="1435392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43586048"/>
        <c:crosses val="autoZero"/>
        <c:auto val="1"/>
        <c:lblAlgn val="ctr"/>
        <c:lblOffset val="100"/>
        <c:noMultiLvlLbl val="0"/>
      </c:catAx>
      <c:valAx>
        <c:axId val="143586048"/>
        <c:scaling>
          <c:orientation val="minMax"/>
          <c:max val="2.2000000000000002"/>
          <c:min val="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43539200"/>
        <c:crosses val="autoZero"/>
        <c:crossBetween val="between"/>
        <c:majorUnit val="1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DSC EJ'!$P$21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EJ'!$R$20:$V$20</c:f>
              <c:strCache>
                <c:ptCount val="5"/>
                <c:pt idx="0">
                  <c:v>CD14</c:v>
                </c:pt>
                <c:pt idx="1">
                  <c:v>CD19</c:v>
                </c:pt>
                <c:pt idx="2">
                  <c:v>CD34</c:v>
                </c:pt>
                <c:pt idx="3">
                  <c:v>CD45</c:v>
                </c:pt>
                <c:pt idx="4">
                  <c:v>HLA-DR</c:v>
                </c:pt>
              </c:strCache>
            </c:strRef>
          </c:cat>
          <c:val>
            <c:numRef>
              <c:f>'ADSC EJ'!$R$21:$V$21</c:f>
              <c:numCache>
                <c:formatCode>General</c:formatCode>
                <c:ptCount val="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EJ'!$P$22</c:f>
              <c:strCache>
                <c:ptCount val="1"/>
                <c:pt idx="0">
                  <c:v>ADSC TRIDUC1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EJ'!$R$31:$V$31</c:f>
                <c:numCache>
                  <c:formatCode>General</c:formatCode>
                  <c:ptCount val="5"/>
                  <c:pt idx="0">
                    <c:v>7.5741018313100106E-4</c:v>
                  </c:pt>
                  <c:pt idx="1">
                    <c:v>8.9080391166097995E-3</c:v>
                  </c:pt>
                  <c:pt idx="2">
                    <c:v>0.11918463520429237</c:v>
                  </c:pt>
                  <c:pt idx="3">
                    <c:v>1.0336168141593428E-3</c:v>
                  </c:pt>
                  <c:pt idx="4">
                    <c:v>4.5509974707274066E-8</c:v>
                  </c:pt>
                </c:numCache>
              </c:numRef>
            </c:plus>
            <c:minus>
              <c:numRef>
                <c:f>'ADSC EJ'!$R$31:$V$31</c:f>
                <c:numCache>
                  <c:formatCode>General</c:formatCode>
                  <c:ptCount val="5"/>
                  <c:pt idx="0">
                    <c:v>7.5741018313100106E-4</c:v>
                  </c:pt>
                  <c:pt idx="1">
                    <c:v>8.9080391166097995E-3</c:v>
                  </c:pt>
                  <c:pt idx="2">
                    <c:v>0.11918463520429237</c:v>
                  </c:pt>
                  <c:pt idx="3">
                    <c:v>1.0336168141593428E-3</c:v>
                  </c:pt>
                  <c:pt idx="4">
                    <c:v>4.5509974707274066E-8</c:v>
                  </c:pt>
                </c:numCache>
              </c:numRef>
            </c:minus>
          </c:errBars>
          <c:cat>
            <c:strRef>
              <c:f>'ADSC EJ'!$R$20:$V$20</c:f>
              <c:strCache>
                <c:ptCount val="5"/>
                <c:pt idx="0">
                  <c:v>CD14</c:v>
                </c:pt>
                <c:pt idx="1">
                  <c:v>CD19</c:v>
                </c:pt>
                <c:pt idx="2">
                  <c:v>CD34</c:v>
                </c:pt>
                <c:pt idx="3">
                  <c:v>CD45</c:v>
                </c:pt>
                <c:pt idx="4">
                  <c:v>HLA-DR</c:v>
                </c:pt>
              </c:strCache>
            </c:strRef>
          </c:cat>
          <c:val>
            <c:numRef>
              <c:f>'ADSC EJ'!$R$22:$V$22</c:f>
              <c:numCache>
                <c:formatCode>General</c:formatCode>
                <c:ptCount val="5"/>
                <c:pt idx="0">
                  <c:v>3.2866520196053683E-3</c:v>
                </c:pt>
                <c:pt idx="1">
                  <c:v>1.9493185593356346E-2</c:v>
                </c:pt>
                <c:pt idx="2">
                  <c:v>0.29432554882470613</c:v>
                </c:pt>
                <c:pt idx="3">
                  <c:v>1.5457852002136582E-3</c:v>
                </c:pt>
                <c:pt idx="4">
                  <c:v>1.117734839727578E-6</c:v>
                </c:pt>
              </c:numCache>
            </c:numRef>
          </c:val>
        </c:ser>
        <c:ser>
          <c:idx val="2"/>
          <c:order val="2"/>
          <c:tx>
            <c:strRef>
              <c:f>'ADSC EJ'!$P$23</c:f>
              <c:strCache>
                <c:ptCount val="1"/>
                <c:pt idx="0">
                  <c:v>MES TRIDUC1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EJ'!$R$32:$V$32</c:f>
                <c:numCache>
                  <c:formatCode>General</c:formatCode>
                  <c:ptCount val="5"/>
                  <c:pt idx="0">
                    <c:v>5.8001068134449739E-3</c:v>
                  </c:pt>
                  <c:pt idx="1">
                    <c:v>5.9993174814250531E-2</c:v>
                  </c:pt>
                  <c:pt idx="2">
                    <c:v>2.5606275336188195E-3</c:v>
                  </c:pt>
                  <c:pt idx="3">
                    <c:v>1.1606270098349499E-3</c:v>
                  </c:pt>
                  <c:pt idx="4">
                    <c:v>7.989605032331927E-7</c:v>
                  </c:pt>
                </c:numCache>
              </c:numRef>
            </c:plus>
            <c:minus>
              <c:numRef>
                <c:f>'ADSC EJ'!$R$32:$V$32</c:f>
                <c:numCache>
                  <c:formatCode>General</c:formatCode>
                  <c:ptCount val="5"/>
                  <c:pt idx="0">
                    <c:v>5.8001068134449739E-3</c:v>
                  </c:pt>
                  <c:pt idx="1">
                    <c:v>5.9993174814250531E-2</c:v>
                  </c:pt>
                  <c:pt idx="2">
                    <c:v>2.5606275336188195E-3</c:v>
                  </c:pt>
                  <c:pt idx="3">
                    <c:v>1.1606270098349499E-3</c:v>
                  </c:pt>
                  <c:pt idx="4">
                    <c:v>7.989605032331927E-7</c:v>
                  </c:pt>
                </c:numCache>
              </c:numRef>
            </c:minus>
          </c:errBars>
          <c:cat>
            <c:strRef>
              <c:f>'ADSC EJ'!$R$20:$V$20</c:f>
              <c:strCache>
                <c:ptCount val="5"/>
                <c:pt idx="0">
                  <c:v>CD14</c:v>
                </c:pt>
                <c:pt idx="1">
                  <c:v>CD19</c:v>
                </c:pt>
                <c:pt idx="2">
                  <c:v>CD34</c:v>
                </c:pt>
                <c:pt idx="3">
                  <c:v>CD45</c:v>
                </c:pt>
                <c:pt idx="4">
                  <c:v>HLA-DR</c:v>
                </c:pt>
              </c:strCache>
            </c:strRef>
          </c:cat>
          <c:val>
            <c:numRef>
              <c:f>'ADSC EJ'!$R$23:$V$23</c:f>
              <c:numCache>
                <c:formatCode>General</c:formatCode>
                <c:ptCount val="5"/>
                <c:pt idx="0">
                  <c:v>1.557478455158935E-2</c:v>
                </c:pt>
                <c:pt idx="1">
                  <c:v>8.1716829311159284E-2</c:v>
                </c:pt>
                <c:pt idx="2">
                  <c:v>8.8657584272961772E-3</c:v>
                </c:pt>
                <c:pt idx="3">
                  <c:v>1.6778923859648428E-3</c:v>
                </c:pt>
                <c:pt idx="4">
                  <c:v>4.7188956375159862E-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3698176"/>
        <c:axId val="143701888"/>
      </c:barChart>
      <c:catAx>
        <c:axId val="1436981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43701888"/>
        <c:crosses val="autoZero"/>
        <c:auto val="1"/>
        <c:lblAlgn val="ctr"/>
        <c:lblOffset val="100"/>
        <c:noMultiLvlLbl val="0"/>
      </c:catAx>
      <c:valAx>
        <c:axId val="143701888"/>
        <c:scaling>
          <c:orientation val="minMax"/>
          <c:max val="2.2000000000000002"/>
          <c:min val="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43698176"/>
        <c:crosses val="autoZero"/>
        <c:crossBetween val="between"/>
        <c:majorUnit val="1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DSC KB'!$P$24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KB'!$R$23:$V$23</c:f>
              <c:strCache>
                <c:ptCount val="5"/>
                <c:pt idx="0">
                  <c:v>CD14</c:v>
                </c:pt>
                <c:pt idx="1">
                  <c:v>CD19</c:v>
                </c:pt>
                <c:pt idx="2">
                  <c:v>CD34</c:v>
                </c:pt>
                <c:pt idx="3">
                  <c:v>CD45</c:v>
                </c:pt>
                <c:pt idx="4">
                  <c:v>HLA-DR</c:v>
                </c:pt>
              </c:strCache>
            </c:strRef>
          </c:cat>
          <c:val>
            <c:numRef>
              <c:f>'ADSC KB'!$R$24:$V$24</c:f>
              <c:numCache>
                <c:formatCode>General</c:formatCode>
                <c:ptCount val="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KB'!$P$25</c:f>
              <c:strCache>
                <c:ptCount val="1"/>
                <c:pt idx="0">
                  <c:v>ADSC  NORMA4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KB'!$R$31:$V$31</c:f>
                <c:numCache>
                  <c:formatCode>General</c:formatCode>
                  <c:ptCount val="5"/>
                  <c:pt idx="0">
                    <c:v>1.8252210993521634E-3</c:v>
                  </c:pt>
                  <c:pt idx="1">
                    <c:v>8.5981048252418996E-3</c:v>
                  </c:pt>
                  <c:pt idx="2">
                    <c:v>6.7366730505471456E-2</c:v>
                  </c:pt>
                  <c:pt idx="3">
                    <c:v>5.4090409656801003E-4</c:v>
                  </c:pt>
                  <c:pt idx="4">
                    <c:v>2.8997805971506877E-7</c:v>
                  </c:pt>
                </c:numCache>
              </c:numRef>
            </c:plus>
            <c:minus>
              <c:numRef>
                <c:f>'ADSC KB'!$R$31:$V$31</c:f>
                <c:numCache>
                  <c:formatCode>General</c:formatCode>
                  <c:ptCount val="5"/>
                  <c:pt idx="0">
                    <c:v>1.8252210993521634E-3</c:v>
                  </c:pt>
                  <c:pt idx="1">
                    <c:v>8.5981048252418996E-3</c:v>
                  </c:pt>
                  <c:pt idx="2">
                    <c:v>6.7366730505471456E-2</c:v>
                  </c:pt>
                  <c:pt idx="3">
                    <c:v>5.4090409656801003E-4</c:v>
                  </c:pt>
                  <c:pt idx="4">
                    <c:v>2.8997805971506877E-7</c:v>
                  </c:pt>
                </c:numCache>
              </c:numRef>
            </c:minus>
          </c:errBars>
          <c:cat>
            <c:strRef>
              <c:f>'ADSC KB'!$R$23:$V$23</c:f>
              <c:strCache>
                <c:ptCount val="5"/>
                <c:pt idx="0">
                  <c:v>CD14</c:v>
                </c:pt>
                <c:pt idx="1">
                  <c:v>CD19</c:v>
                </c:pt>
                <c:pt idx="2">
                  <c:v>CD34</c:v>
                </c:pt>
                <c:pt idx="3">
                  <c:v>CD45</c:v>
                </c:pt>
                <c:pt idx="4">
                  <c:v>HLA-DR</c:v>
                </c:pt>
              </c:strCache>
            </c:strRef>
          </c:cat>
          <c:val>
            <c:numRef>
              <c:f>'ADSC KB'!$R$25:$V$25</c:f>
              <c:numCache>
                <c:formatCode>General</c:formatCode>
                <c:ptCount val="5"/>
                <c:pt idx="0">
                  <c:v>4.9526156596876782E-3</c:v>
                </c:pt>
                <c:pt idx="1">
                  <c:v>1.1560062696443463E-2</c:v>
                </c:pt>
                <c:pt idx="2">
                  <c:v>0.14420989316526311</c:v>
                </c:pt>
                <c:pt idx="3">
                  <c:v>7.9645571195944512E-4</c:v>
                </c:pt>
                <c:pt idx="4">
                  <c:v>2.250914921217594E-6</c:v>
                </c:pt>
              </c:numCache>
            </c:numRef>
          </c:val>
        </c:ser>
        <c:ser>
          <c:idx val="2"/>
          <c:order val="2"/>
          <c:tx>
            <c:strRef>
              <c:f>'ADSC KB'!$P$26</c:f>
              <c:strCache>
                <c:ptCount val="1"/>
                <c:pt idx="0">
                  <c:v>HMEC NORMA4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KB'!$R$32:$V$32</c:f>
                <c:numCache>
                  <c:formatCode>General</c:formatCode>
                  <c:ptCount val="5"/>
                  <c:pt idx="0">
                    <c:v>2.6647420223813926E-3</c:v>
                  </c:pt>
                  <c:pt idx="1">
                    <c:v>6.0620615345166834E-4</c:v>
                  </c:pt>
                  <c:pt idx="2">
                    <c:v>5.4576327997286E-4</c:v>
                  </c:pt>
                  <c:pt idx="3">
                    <c:v>2.8307283081596603E-6</c:v>
                  </c:pt>
                  <c:pt idx="4">
                    <c:v>2.0315247220389034E-6</c:v>
                  </c:pt>
                </c:numCache>
              </c:numRef>
            </c:plus>
            <c:minus>
              <c:numRef>
                <c:f>'ADSC KB'!$R$32:$V$32</c:f>
                <c:numCache>
                  <c:formatCode>General</c:formatCode>
                  <c:ptCount val="5"/>
                  <c:pt idx="0">
                    <c:v>2.6647420223813926E-3</c:v>
                  </c:pt>
                  <c:pt idx="1">
                    <c:v>6.0620615345166834E-4</c:v>
                  </c:pt>
                  <c:pt idx="2">
                    <c:v>5.4576327997286E-4</c:v>
                  </c:pt>
                  <c:pt idx="3">
                    <c:v>2.8307283081596603E-6</c:v>
                  </c:pt>
                  <c:pt idx="4">
                    <c:v>2.0315247220389034E-6</c:v>
                  </c:pt>
                </c:numCache>
              </c:numRef>
            </c:minus>
          </c:errBars>
          <c:cat>
            <c:strRef>
              <c:f>'ADSC KB'!$R$23:$V$23</c:f>
              <c:strCache>
                <c:ptCount val="5"/>
                <c:pt idx="0">
                  <c:v>CD14</c:v>
                </c:pt>
                <c:pt idx="1">
                  <c:v>CD19</c:v>
                </c:pt>
                <c:pt idx="2">
                  <c:v>CD34</c:v>
                </c:pt>
                <c:pt idx="3">
                  <c:v>CD45</c:v>
                </c:pt>
                <c:pt idx="4">
                  <c:v>HLA-DR</c:v>
                </c:pt>
              </c:strCache>
            </c:strRef>
          </c:cat>
          <c:val>
            <c:numRef>
              <c:f>'ADSC KB'!$R$26:$V$26</c:f>
              <c:numCache>
                <c:formatCode>General</c:formatCode>
                <c:ptCount val="5"/>
                <c:pt idx="0">
                  <c:v>9.6931506892686502E-3</c:v>
                </c:pt>
                <c:pt idx="1">
                  <c:v>6.8730456100976752E-4</c:v>
                </c:pt>
                <c:pt idx="2">
                  <c:v>2.0229757290963404E-3</c:v>
                </c:pt>
                <c:pt idx="3">
                  <c:v>5.7821564294965846E-6</c:v>
                </c:pt>
                <c:pt idx="4">
                  <c:v>3.5338572999843469E-5</c:v>
                </c:pt>
              </c:numCache>
            </c:numRef>
          </c:val>
        </c:ser>
        <c:ser>
          <c:idx val="3"/>
          <c:order val="3"/>
          <c:tx>
            <c:strRef>
              <c:f>'ADSC KB'!$P$27</c:f>
              <c:strCache>
                <c:ptCount val="1"/>
                <c:pt idx="0">
                  <c:v>MES NORMA4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KB'!$R$33:$V$33</c:f>
                <c:numCache>
                  <c:formatCode>General</c:formatCode>
                  <c:ptCount val="5"/>
                  <c:pt idx="0">
                    <c:v>5.5214495703020422E-2</c:v>
                  </c:pt>
                  <c:pt idx="1">
                    <c:v>7.753871051563542E-2</c:v>
                  </c:pt>
                  <c:pt idx="2">
                    <c:v>9.2422769324136886E-3</c:v>
                  </c:pt>
                  <c:pt idx="3">
                    <c:v>2.1677314729107752E-3</c:v>
                  </c:pt>
                  <c:pt idx="4">
                    <c:v>1.4559622875118675E-5</c:v>
                  </c:pt>
                </c:numCache>
              </c:numRef>
            </c:plus>
            <c:minus>
              <c:numRef>
                <c:f>'ADSC KB'!$R$33:$V$33</c:f>
                <c:numCache>
                  <c:formatCode>General</c:formatCode>
                  <c:ptCount val="5"/>
                  <c:pt idx="0">
                    <c:v>5.5214495703020422E-2</c:v>
                  </c:pt>
                  <c:pt idx="1">
                    <c:v>7.753871051563542E-2</c:v>
                  </c:pt>
                  <c:pt idx="2">
                    <c:v>9.2422769324136886E-3</c:v>
                  </c:pt>
                  <c:pt idx="3">
                    <c:v>2.1677314729107752E-3</c:v>
                  </c:pt>
                  <c:pt idx="4">
                    <c:v>1.4559622875118675E-5</c:v>
                  </c:pt>
                </c:numCache>
              </c:numRef>
            </c:minus>
          </c:errBars>
          <c:cat>
            <c:strRef>
              <c:f>'ADSC KB'!$R$23:$V$23</c:f>
              <c:strCache>
                <c:ptCount val="5"/>
                <c:pt idx="0">
                  <c:v>CD14</c:v>
                </c:pt>
                <c:pt idx="1">
                  <c:v>CD19</c:v>
                </c:pt>
                <c:pt idx="2">
                  <c:v>CD34</c:v>
                </c:pt>
                <c:pt idx="3">
                  <c:v>CD45</c:v>
                </c:pt>
                <c:pt idx="4">
                  <c:v>HLA-DR</c:v>
                </c:pt>
              </c:strCache>
            </c:strRef>
          </c:cat>
          <c:val>
            <c:numRef>
              <c:f>'ADSC KB'!$R$27:$V$27</c:f>
              <c:numCache>
                <c:formatCode>General</c:formatCode>
                <c:ptCount val="5"/>
                <c:pt idx="0">
                  <c:v>0.13908377438831163</c:v>
                </c:pt>
                <c:pt idx="1">
                  <c:v>0.20143830102901639</c:v>
                </c:pt>
                <c:pt idx="2">
                  <c:v>2.5701557781745103E-2</c:v>
                </c:pt>
                <c:pt idx="3">
                  <c:v>3.9221425299672636E-3</c:v>
                </c:pt>
                <c:pt idx="4">
                  <c:v>1.2997169813961165E-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7596416"/>
        <c:axId val="147608320"/>
      </c:barChart>
      <c:catAx>
        <c:axId val="1475964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47608320"/>
        <c:crosses val="autoZero"/>
        <c:auto val="1"/>
        <c:lblAlgn val="ctr"/>
        <c:lblOffset val="100"/>
        <c:noMultiLvlLbl val="0"/>
      </c:catAx>
      <c:valAx>
        <c:axId val="147608320"/>
        <c:scaling>
          <c:orientation val="minMax"/>
          <c:max val="2.2000000000000002"/>
          <c:min val="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47596416"/>
        <c:crosses val="autoZero"/>
        <c:crossBetween val="between"/>
        <c:majorUnit val="1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363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363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4BD3008-0BE9-4A41-9510-3695C8385C78}" type="datetimeFigureOut">
              <a:rPr lang="de-DE" smtClean="0"/>
              <a:t>29.09.2015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960438" y="739775"/>
            <a:ext cx="4937125" cy="37036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689515"/>
            <a:ext cx="5486400" cy="444269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377316"/>
            <a:ext cx="2971800" cy="4936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9377316"/>
            <a:ext cx="2971800" cy="4936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44BE97-5C19-44A2-85E8-B9DD929E20C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948137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C913-2F9E-49E4-8047-720020B0768F}" type="datetimeFigureOut">
              <a:rPr lang="de-DE" smtClean="0"/>
              <a:t>29.09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09724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C913-2F9E-49E4-8047-720020B0768F}" type="datetimeFigureOut">
              <a:rPr lang="de-DE" smtClean="0"/>
              <a:t>29.09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39100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C913-2F9E-49E4-8047-720020B0768F}" type="datetimeFigureOut">
              <a:rPr lang="de-DE" smtClean="0"/>
              <a:t>29.09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62119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C913-2F9E-49E4-8047-720020B0768F}" type="datetimeFigureOut">
              <a:rPr lang="de-DE" smtClean="0"/>
              <a:t>29.09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956503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C913-2F9E-49E4-8047-720020B0768F}" type="datetimeFigureOut">
              <a:rPr lang="de-DE" smtClean="0"/>
              <a:t>29.09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06582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C913-2F9E-49E4-8047-720020B0768F}" type="datetimeFigureOut">
              <a:rPr lang="de-DE" smtClean="0"/>
              <a:t>29.09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218748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2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2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C913-2F9E-49E4-8047-720020B0768F}" type="datetimeFigureOut">
              <a:rPr lang="de-DE" smtClean="0"/>
              <a:t>29.09.201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15663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C913-2F9E-49E4-8047-720020B0768F}" type="datetimeFigureOut">
              <a:rPr lang="de-DE" smtClean="0"/>
              <a:t>29.09.201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864847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C913-2F9E-49E4-8047-720020B0768F}" type="datetimeFigureOut">
              <a:rPr lang="de-DE" smtClean="0"/>
              <a:t>29.09.201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933306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1" y="273052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C913-2F9E-49E4-8047-720020B0768F}" type="datetimeFigureOut">
              <a:rPr lang="de-DE" smtClean="0"/>
              <a:t>29.09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538939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C913-2F9E-49E4-8047-720020B0768F}" type="datetimeFigureOut">
              <a:rPr lang="de-DE" smtClean="0"/>
              <a:t>29.09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05836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00C913-2F9E-49E4-8047-720020B0768F}" type="datetimeFigureOut">
              <a:rPr lang="de-DE" smtClean="0"/>
              <a:t>29.09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325289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33" name="Gruppieren 532"/>
          <p:cNvGrpSpPr/>
          <p:nvPr/>
        </p:nvGrpSpPr>
        <p:grpSpPr>
          <a:xfrm>
            <a:off x="35496" y="44624"/>
            <a:ext cx="8784976" cy="6700519"/>
            <a:chOff x="35496" y="44624"/>
            <a:chExt cx="8784976" cy="6700519"/>
          </a:xfrm>
        </p:grpSpPr>
        <p:graphicFrame>
          <p:nvGraphicFramePr>
            <p:cNvPr id="524" name="Diagramm 52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03401666"/>
                </p:ext>
              </p:extLst>
            </p:nvPr>
          </p:nvGraphicFramePr>
          <p:xfrm>
            <a:off x="612000" y="475200"/>
            <a:ext cx="4176000" cy="93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267" name="Textfeld 266"/>
            <p:cNvSpPr txBox="1"/>
            <p:nvPr/>
          </p:nvSpPr>
          <p:spPr>
            <a:xfrm>
              <a:off x="6372200" y="6237312"/>
              <a:ext cx="1705344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endParaRPr lang="de-DE" sz="9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50000"/>
                </a:lnSpc>
              </a:pP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BC/BEC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268" name="Diagramm 26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573598"/>
                </p:ext>
              </p:extLst>
            </p:nvPr>
          </p:nvGraphicFramePr>
          <p:xfrm>
            <a:off x="576000" y="5547600"/>
            <a:ext cx="4140000" cy="93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269" name="Diagramm 26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21420248"/>
                </p:ext>
              </p:extLst>
            </p:nvPr>
          </p:nvGraphicFramePr>
          <p:xfrm>
            <a:off x="576000" y="4464000"/>
            <a:ext cx="4140000" cy="93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270" name="Diagramm 26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94907405"/>
                </p:ext>
              </p:extLst>
            </p:nvPr>
          </p:nvGraphicFramePr>
          <p:xfrm>
            <a:off x="514800" y="3528000"/>
            <a:ext cx="4212000" cy="93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271" name="Diagramm 27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54911349"/>
                </p:ext>
              </p:extLst>
            </p:nvPr>
          </p:nvGraphicFramePr>
          <p:xfrm>
            <a:off x="540000" y="2520000"/>
            <a:ext cx="4248000" cy="93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272" name="Diagramm 27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10357817"/>
                </p:ext>
              </p:extLst>
            </p:nvPr>
          </p:nvGraphicFramePr>
          <p:xfrm>
            <a:off x="612000" y="1483200"/>
            <a:ext cx="4176000" cy="93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273" name="Diagramm 27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46495520"/>
                </p:ext>
              </p:extLst>
            </p:nvPr>
          </p:nvGraphicFramePr>
          <p:xfrm>
            <a:off x="4896324" y="5548430"/>
            <a:ext cx="3564188" cy="93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aphicFrame>
          <p:nvGraphicFramePr>
            <p:cNvPr id="274" name="Diagramm 27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158364823"/>
                </p:ext>
              </p:extLst>
            </p:nvPr>
          </p:nvGraphicFramePr>
          <p:xfrm>
            <a:off x="4896324" y="4495901"/>
            <a:ext cx="3564108" cy="93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aphicFrame>
          <p:nvGraphicFramePr>
            <p:cNvPr id="275" name="Diagramm 27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55626053"/>
                </p:ext>
              </p:extLst>
            </p:nvPr>
          </p:nvGraphicFramePr>
          <p:xfrm>
            <a:off x="4896324" y="3501112"/>
            <a:ext cx="3564108" cy="93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graphicFrame>
          <p:nvGraphicFramePr>
            <p:cNvPr id="276" name="Diagramm 27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32944294"/>
                </p:ext>
              </p:extLst>
            </p:nvPr>
          </p:nvGraphicFramePr>
          <p:xfrm>
            <a:off x="4896323" y="2510082"/>
            <a:ext cx="3564109" cy="93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  <p:graphicFrame>
          <p:nvGraphicFramePr>
            <p:cNvPr id="277" name="Diagramm 27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07723254"/>
                </p:ext>
              </p:extLst>
            </p:nvPr>
          </p:nvGraphicFramePr>
          <p:xfrm>
            <a:off x="4896323" y="476672"/>
            <a:ext cx="3545677" cy="93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2"/>
            </a:graphicData>
          </a:graphic>
        </p:graphicFrame>
        <p:graphicFrame>
          <p:nvGraphicFramePr>
            <p:cNvPr id="278" name="Diagramm 27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86151925"/>
                </p:ext>
              </p:extLst>
            </p:nvPr>
          </p:nvGraphicFramePr>
          <p:xfrm>
            <a:off x="4896324" y="1448776"/>
            <a:ext cx="3563676" cy="100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3"/>
            </a:graphicData>
          </a:graphic>
        </p:graphicFrame>
        <p:sp>
          <p:nvSpPr>
            <p:cNvPr id="279" name="Textfeld 278"/>
            <p:cNvSpPr txBox="1"/>
            <p:nvPr/>
          </p:nvSpPr>
          <p:spPr>
            <a:xfrm rot="16200000">
              <a:off x="-455350" y="561891"/>
              <a:ext cx="129614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RMA1</a:t>
              </a:r>
              <a:endParaRPr lang="de-DE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0" name="Textfeld 279"/>
            <p:cNvSpPr txBox="1"/>
            <p:nvPr/>
          </p:nvSpPr>
          <p:spPr>
            <a:xfrm rot="16200000">
              <a:off x="-423882" y="2506107"/>
              <a:ext cx="129614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RMA3</a:t>
              </a:r>
            </a:p>
          </p:txBody>
        </p:sp>
        <p:sp>
          <p:nvSpPr>
            <p:cNvPr id="281" name="Textfeld 280"/>
            <p:cNvSpPr txBox="1"/>
            <p:nvPr/>
          </p:nvSpPr>
          <p:spPr>
            <a:xfrm rot="16200000">
              <a:off x="-423882" y="3514219"/>
              <a:ext cx="129614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RMA4</a:t>
              </a:r>
            </a:p>
          </p:txBody>
        </p:sp>
        <p:sp>
          <p:nvSpPr>
            <p:cNvPr id="282" name="Textfeld 281"/>
            <p:cNvSpPr txBox="1"/>
            <p:nvPr/>
          </p:nvSpPr>
          <p:spPr>
            <a:xfrm rot="16200000">
              <a:off x="-423882" y="4522331"/>
              <a:ext cx="129614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RIDUC1</a:t>
              </a:r>
              <a:endParaRPr lang="de-DE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3" name="Textfeld 282"/>
            <p:cNvSpPr txBox="1"/>
            <p:nvPr/>
          </p:nvSpPr>
          <p:spPr>
            <a:xfrm rot="16200000">
              <a:off x="-423882" y="5458435"/>
              <a:ext cx="129614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FDUC1</a:t>
              </a:r>
              <a:endParaRPr lang="de-DE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4" name="Textfeld 283"/>
            <p:cNvSpPr txBox="1"/>
            <p:nvPr/>
          </p:nvSpPr>
          <p:spPr>
            <a:xfrm>
              <a:off x="395536" y="404666"/>
              <a:ext cx="2154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5" name="Textfeld 284"/>
            <p:cNvSpPr txBox="1"/>
            <p:nvPr/>
          </p:nvSpPr>
          <p:spPr>
            <a:xfrm>
              <a:off x="395536" y="1412770"/>
              <a:ext cx="2154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6" name="Textfeld 285"/>
            <p:cNvSpPr txBox="1"/>
            <p:nvPr/>
          </p:nvSpPr>
          <p:spPr>
            <a:xfrm>
              <a:off x="395536" y="2409529"/>
              <a:ext cx="2154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287" name="Textfeld 286"/>
            <p:cNvSpPr txBox="1"/>
            <p:nvPr/>
          </p:nvSpPr>
          <p:spPr>
            <a:xfrm>
              <a:off x="395537" y="3416027"/>
              <a:ext cx="2154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288" name="Textfeld 287"/>
            <p:cNvSpPr txBox="1"/>
            <p:nvPr/>
          </p:nvSpPr>
          <p:spPr>
            <a:xfrm>
              <a:off x="395537" y="4412734"/>
              <a:ext cx="2154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9" name="Textfeld 288"/>
            <p:cNvSpPr txBox="1"/>
            <p:nvPr/>
          </p:nvSpPr>
          <p:spPr>
            <a:xfrm>
              <a:off x="395537" y="5435968"/>
              <a:ext cx="2154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grpSp>
          <p:nvGrpSpPr>
            <p:cNvPr id="290" name="Gruppieren 289"/>
            <p:cNvGrpSpPr/>
            <p:nvPr/>
          </p:nvGrpSpPr>
          <p:grpSpPr>
            <a:xfrm>
              <a:off x="1547664" y="908720"/>
              <a:ext cx="533152" cy="261610"/>
              <a:chOff x="1321200" y="1177588"/>
              <a:chExt cx="533152" cy="261610"/>
            </a:xfrm>
          </p:grpSpPr>
          <p:sp>
            <p:nvSpPr>
              <p:cNvPr id="291" name="Textfeld 290"/>
              <p:cNvSpPr txBox="1"/>
              <p:nvPr/>
            </p:nvSpPr>
            <p:spPr>
              <a:xfrm>
                <a:off x="1321200" y="117758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292" name="Textfeld 291"/>
              <p:cNvSpPr txBox="1"/>
              <p:nvPr/>
            </p:nvSpPr>
            <p:spPr>
              <a:xfrm>
                <a:off x="1458000" y="117758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293" name="Gruppieren 292"/>
            <p:cNvGrpSpPr/>
            <p:nvPr/>
          </p:nvGrpSpPr>
          <p:grpSpPr>
            <a:xfrm>
              <a:off x="2094632" y="908720"/>
              <a:ext cx="533152" cy="272639"/>
              <a:chOff x="1321200" y="1105580"/>
              <a:chExt cx="533152" cy="272639"/>
            </a:xfrm>
          </p:grpSpPr>
          <p:sp>
            <p:nvSpPr>
              <p:cNvPr id="294" name="Textfeld 293"/>
              <p:cNvSpPr txBox="1"/>
              <p:nvPr/>
            </p:nvSpPr>
            <p:spPr>
              <a:xfrm>
                <a:off x="1321200" y="110558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295" name="Textfeld 294"/>
              <p:cNvSpPr txBox="1"/>
              <p:nvPr/>
            </p:nvSpPr>
            <p:spPr>
              <a:xfrm>
                <a:off x="1458000" y="1116609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296" name="Gruppieren 295"/>
            <p:cNvGrpSpPr/>
            <p:nvPr/>
          </p:nvGrpSpPr>
          <p:grpSpPr>
            <a:xfrm>
              <a:off x="2627784" y="935142"/>
              <a:ext cx="533152" cy="261610"/>
              <a:chOff x="1321200" y="1105580"/>
              <a:chExt cx="533152" cy="261610"/>
            </a:xfrm>
          </p:grpSpPr>
          <p:sp>
            <p:nvSpPr>
              <p:cNvPr id="297" name="Textfeld 296"/>
              <p:cNvSpPr txBox="1"/>
              <p:nvPr/>
            </p:nvSpPr>
            <p:spPr>
              <a:xfrm>
                <a:off x="1321200" y="110558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298" name="Textfeld 297"/>
              <p:cNvSpPr txBox="1"/>
              <p:nvPr/>
            </p:nvSpPr>
            <p:spPr>
              <a:xfrm>
                <a:off x="1458000" y="110558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299" name="Gruppieren 298"/>
            <p:cNvGrpSpPr/>
            <p:nvPr/>
          </p:nvGrpSpPr>
          <p:grpSpPr>
            <a:xfrm>
              <a:off x="3167536" y="836712"/>
              <a:ext cx="522816" cy="322586"/>
              <a:chOff x="1313984" y="1234206"/>
              <a:chExt cx="522816" cy="322586"/>
            </a:xfrm>
          </p:grpSpPr>
          <p:sp>
            <p:nvSpPr>
              <p:cNvPr id="300" name="Textfeld 299"/>
              <p:cNvSpPr txBox="1"/>
              <p:nvPr/>
            </p:nvSpPr>
            <p:spPr>
              <a:xfrm>
                <a:off x="1313984" y="1234206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01" name="Textfeld 300"/>
              <p:cNvSpPr txBox="1"/>
              <p:nvPr/>
            </p:nvSpPr>
            <p:spPr>
              <a:xfrm>
                <a:off x="1440448" y="129518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302" name="Gruppieren 301"/>
            <p:cNvGrpSpPr/>
            <p:nvPr/>
          </p:nvGrpSpPr>
          <p:grpSpPr>
            <a:xfrm>
              <a:off x="4254872" y="908720"/>
              <a:ext cx="515480" cy="261610"/>
              <a:chOff x="1321200" y="1204010"/>
              <a:chExt cx="515480" cy="261610"/>
            </a:xfrm>
          </p:grpSpPr>
          <p:sp>
            <p:nvSpPr>
              <p:cNvPr id="303" name="Textfeld 302"/>
              <p:cNvSpPr txBox="1"/>
              <p:nvPr/>
            </p:nvSpPr>
            <p:spPr>
              <a:xfrm>
                <a:off x="1321200" y="120401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04" name="Textfeld 303"/>
              <p:cNvSpPr txBox="1"/>
              <p:nvPr/>
            </p:nvSpPr>
            <p:spPr>
              <a:xfrm>
                <a:off x="1440328" y="120401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305" name="Gruppieren 304"/>
            <p:cNvGrpSpPr/>
            <p:nvPr/>
          </p:nvGrpSpPr>
          <p:grpSpPr>
            <a:xfrm>
              <a:off x="1014512" y="1943254"/>
              <a:ext cx="533152" cy="261610"/>
              <a:chOff x="1321200" y="1105580"/>
              <a:chExt cx="533152" cy="261610"/>
            </a:xfrm>
          </p:grpSpPr>
          <p:sp>
            <p:nvSpPr>
              <p:cNvPr id="306" name="Textfeld 305"/>
              <p:cNvSpPr txBox="1"/>
              <p:nvPr/>
            </p:nvSpPr>
            <p:spPr>
              <a:xfrm>
                <a:off x="1321200" y="110558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07" name="Textfeld 306"/>
              <p:cNvSpPr txBox="1"/>
              <p:nvPr/>
            </p:nvSpPr>
            <p:spPr>
              <a:xfrm>
                <a:off x="1458000" y="110558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308" name="Gruppieren 307"/>
            <p:cNvGrpSpPr/>
            <p:nvPr/>
          </p:nvGrpSpPr>
          <p:grpSpPr>
            <a:xfrm>
              <a:off x="1547664" y="1800000"/>
              <a:ext cx="519088" cy="332856"/>
              <a:chOff x="1321184" y="1663242"/>
              <a:chExt cx="519088" cy="332856"/>
            </a:xfrm>
          </p:grpSpPr>
          <p:sp>
            <p:nvSpPr>
              <p:cNvPr id="309" name="Textfeld 308"/>
              <p:cNvSpPr txBox="1"/>
              <p:nvPr/>
            </p:nvSpPr>
            <p:spPr>
              <a:xfrm>
                <a:off x="1321184" y="173448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10" name="Textfeld 309"/>
              <p:cNvSpPr txBox="1"/>
              <p:nvPr/>
            </p:nvSpPr>
            <p:spPr>
              <a:xfrm>
                <a:off x="1443920" y="166324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311" name="Gruppieren 310"/>
            <p:cNvGrpSpPr/>
            <p:nvPr/>
          </p:nvGrpSpPr>
          <p:grpSpPr>
            <a:xfrm>
              <a:off x="2094632" y="1943254"/>
              <a:ext cx="515720" cy="261610"/>
              <a:chOff x="1321200" y="1105580"/>
              <a:chExt cx="515720" cy="261610"/>
            </a:xfrm>
          </p:grpSpPr>
          <p:sp>
            <p:nvSpPr>
              <p:cNvPr id="312" name="Textfeld 311"/>
              <p:cNvSpPr txBox="1"/>
              <p:nvPr/>
            </p:nvSpPr>
            <p:spPr>
              <a:xfrm>
                <a:off x="1321200" y="110558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13" name="Textfeld 312"/>
              <p:cNvSpPr txBox="1"/>
              <p:nvPr/>
            </p:nvSpPr>
            <p:spPr>
              <a:xfrm>
                <a:off x="1440568" y="110558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314" name="Gruppieren 313"/>
            <p:cNvGrpSpPr/>
            <p:nvPr/>
          </p:nvGrpSpPr>
          <p:grpSpPr>
            <a:xfrm>
              <a:off x="2627784" y="1943254"/>
              <a:ext cx="533152" cy="261610"/>
              <a:chOff x="1321200" y="1105580"/>
              <a:chExt cx="533152" cy="261610"/>
            </a:xfrm>
          </p:grpSpPr>
          <p:sp>
            <p:nvSpPr>
              <p:cNvPr id="315" name="Textfeld 314"/>
              <p:cNvSpPr txBox="1"/>
              <p:nvPr/>
            </p:nvSpPr>
            <p:spPr>
              <a:xfrm>
                <a:off x="1321200" y="110558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16" name="Textfeld 315"/>
              <p:cNvSpPr txBox="1"/>
              <p:nvPr/>
            </p:nvSpPr>
            <p:spPr>
              <a:xfrm>
                <a:off x="1458000" y="110558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317" name="Gruppieren 316"/>
            <p:cNvGrpSpPr/>
            <p:nvPr/>
          </p:nvGrpSpPr>
          <p:grpSpPr>
            <a:xfrm>
              <a:off x="3174752" y="1799238"/>
              <a:ext cx="515600" cy="333618"/>
              <a:chOff x="1321200" y="1132002"/>
              <a:chExt cx="515600" cy="333618"/>
            </a:xfrm>
          </p:grpSpPr>
          <p:sp>
            <p:nvSpPr>
              <p:cNvPr id="318" name="Textfeld 317"/>
              <p:cNvSpPr txBox="1"/>
              <p:nvPr/>
            </p:nvSpPr>
            <p:spPr>
              <a:xfrm>
                <a:off x="1321200" y="113200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19" name="Textfeld 318"/>
              <p:cNvSpPr txBox="1"/>
              <p:nvPr/>
            </p:nvSpPr>
            <p:spPr>
              <a:xfrm>
                <a:off x="1440448" y="120401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320" name="Gruppieren 319"/>
            <p:cNvGrpSpPr/>
            <p:nvPr/>
          </p:nvGrpSpPr>
          <p:grpSpPr>
            <a:xfrm>
              <a:off x="4247656" y="1836000"/>
              <a:ext cx="522696" cy="368864"/>
              <a:chOff x="1321200" y="1672820"/>
              <a:chExt cx="522696" cy="368864"/>
            </a:xfrm>
          </p:grpSpPr>
          <p:sp>
            <p:nvSpPr>
              <p:cNvPr id="321" name="Textfeld 320"/>
              <p:cNvSpPr txBox="1"/>
              <p:nvPr/>
            </p:nvSpPr>
            <p:spPr>
              <a:xfrm>
                <a:off x="1321200" y="1780074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22" name="Textfeld 321"/>
              <p:cNvSpPr txBox="1"/>
              <p:nvPr/>
            </p:nvSpPr>
            <p:spPr>
              <a:xfrm>
                <a:off x="1447544" y="16728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323" name="Gruppieren 322"/>
            <p:cNvGrpSpPr/>
            <p:nvPr/>
          </p:nvGrpSpPr>
          <p:grpSpPr>
            <a:xfrm>
              <a:off x="1026000" y="2970000"/>
              <a:ext cx="521664" cy="261610"/>
              <a:chOff x="1332688" y="1105580"/>
              <a:chExt cx="521664" cy="261610"/>
            </a:xfrm>
          </p:grpSpPr>
          <p:sp>
            <p:nvSpPr>
              <p:cNvPr id="324" name="Textfeld 323"/>
              <p:cNvSpPr txBox="1"/>
              <p:nvPr/>
            </p:nvSpPr>
            <p:spPr>
              <a:xfrm>
                <a:off x="1332688" y="110558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25" name="Textfeld 324"/>
              <p:cNvSpPr txBox="1"/>
              <p:nvPr/>
            </p:nvSpPr>
            <p:spPr>
              <a:xfrm>
                <a:off x="1458000" y="110558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326" name="Gruppieren 325"/>
            <p:cNvGrpSpPr/>
            <p:nvPr/>
          </p:nvGrpSpPr>
          <p:grpSpPr>
            <a:xfrm>
              <a:off x="1566000" y="2844000"/>
              <a:ext cx="514816" cy="333610"/>
              <a:chOff x="1339536" y="1168652"/>
              <a:chExt cx="514816" cy="333610"/>
            </a:xfrm>
          </p:grpSpPr>
          <p:sp>
            <p:nvSpPr>
              <p:cNvPr id="327" name="Textfeld 326"/>
              <p:cNvSpPr txBox="1"/>
              <p:nvPr/>
            </p:nvSpPr>
            <p:spPr>
              <a:xfrm>
                <a:off x="1339536" y="116865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28" name="Textfeld 327"/>
              <p:cNvSpPr txBox="1"/>
              <p:nvPr/>
            </p:nvSpPr>
            <p:spPr>
              <a:xfrm>
                <a:off x="1458000" y="124065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329" name="Gruppieren 328"/>
            <p:cNvGrpSpPr/>
            <p:nvPr/>
          </p:nvGrpSpPr>
          <p:grpSpPr>
            <a:xfrm>
              <a:off x="2094632" y="2898000"/>
              <a:ext cx="522920" cy="261610"/>
              <a:chOff x="1321200" y="1105580"/>
              <a:chExt cx="522920" cy="261610"/>
            </a:xfrm>
          </p:grpSpPr>
          <p:sp>
            <p:nvSpPr>
              <p:cNvPr id="330" name="Textfeld 329"/>
              <p:cNvSpPr txBox="1"/>
              <p:nvPr/>
            </p:nvSpPr>
            <p:spPr>
              <a:xfrm>
                <a:off x="1321200" y="110558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31" name="Textfeld 330"/>
              <p:cNvSpPr txBox="1"/>
              <p:nvPr/>
            </p:nvSpPr>
            <p:spPr>
              <a:xfrm>
                <a:off x="1447768" y="110558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332" name="Gruppieren 331"/>
            <p:cNvGrpSpPr/>
            <p:nvPr/>
          </p:nvGrpSpPr>
          <p:grpSpPr>
            <a:xfrm>
              <a:off x="2627784" y="2970000"/>
              <a:ext cx="533152" cy="261610"/>
              <a:chOff x="1321200" y="1132002"/>
              <a:chExt cx="533152" cy="261610"/>
            </a:xfrm>
          </p:grpSpPr>
          <p:sp>
            <p:nvSpPr>
              <p:cNvPr id="333" name="Textfeld 332"/>
              <p:cNvSpPr txBox="1"/>
              <p:nvPr/>
            </p:nvSpPr>
            <p:spPr>
              <a:xfrm>
                <a:off x="1321200" y="113200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34" name="Textfeld 333"/>
              <p:cNvSpPr txBox="1"/>
              <p:nvPr/>
            </p:nvSpPr>
            <p:spPr>
              <a:xfrm>
                <a:off x="1458000" y="113200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335" name="Gruppieren 334"/>
            <p:cNvGrpSpPr/>
            <p:nvPr/>
          </p:nvGrpSpPr>
          <p:grpSpPr>
            <a:xfrm>
              <a:off x="4254872" y="2780928"/>
              <a:ext cx="515480" cy="360040"/>
              <a:chOff x="1321200" y="1420040"/>
              <a:chExt cx="515480" cy="360040"/>
            </a:xfrm>
          </p:grpSpPr>
          <p:sp>
            <p:nvSpPr>
              <p:cNvPr id="336" name="Textfeld 335"/>
              <p:cNvSpPr txBox="1"/>
              <p:nvPr/>
            </p:nvSpPr>
            <p:spPr>
              <a:xfrm>
                <a:off x="1321200" y="151847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37" name="Textfeld 336"/>
              <p:cNvSpPr txBox="1"/>
              <p:nvPr/>
            </p:nvSpPr>
            <p:spPr>
              <a:xfrm>
                <a:off x="1440328" y="142004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338" name="Gruppieren 337"/>
            <p:cNvGrpSpPr/>
            <p:nvPr/>
          </p:nvGrpSpPr>
          <p:grpSpPr>
            <a:xfrm>
              <a:off x="1014512" y="3946875"/>
              <a:ext cx="533152" cy="261610"/>
              <a:chOff x="1321200" y="1204010"/>
              <a:chExt cx="533152" cy="261610"/>
            </a:xfrm>
          </p:grpSpPr>
          <p:sp>
            <p:nvSpPr>
              <p:cNvPr id="339" name="Textfeld 338"/>
              <p:cNvSpPr txBox="1"/>
              <p:nvPr/>
            </p:nvSpPr>
            <p:spPr>
              <a:xfrm>
                <a:off x="1321200" y="120401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40" name="Textfeld 339"/>
              <p:cNvSpPr txBox="1"/>
              <p:nvPr/>
            </p:nvSpPr>
            <p:spPr>
              <a:xfrm>
                <a:off x="1458000" y="120401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sp>
          <p:nvSpPr>
            <p:cNvPr id="341" name="Textfeld 340"/>
            <p:cNvSpPr txBox="1"/>
            <p:nvPr/>
          </p:nvSpPr>
          <p:spPr>
            <a:xfrm>
              <a:off x="1547664" y="3933056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sp>
          <p:nvSpPr>
            <p:cNvPr id="342" name="Textfeld 341"/>
            <p:cNvSpPr txBox="1"/>
            <p:nvPr/>
          </p:nvSpPr>
          <p:spPr>
            <a:xfrm>
              <a:off x="3131840" y="3920457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sp>
          <p:nvSpPr>
            <p:cNvPr id="343" name="Textfeld 342"/>
            <p:cNvSpPr txBox="1"/>
            <p:nvPr/>
          </p:nvSpPr>
          <p:spPr>
            <a:xfrm>
              <a:off x="4204800" y="3960000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grpSp>
          <p:nvGrpSpPr>
            <p:cNvPr id="344" name="Gruppieren 343"/>
            <p:cNvGrpSpPr/>
            <p:nvPr/>
          </p:nvGrpSpPr>
          <p:grpSpPr>
            <a:xfrm>
              <a:off x="2070000" y="3946875"/>
              <a:ext cx="514872" cy="261610"/>
              <a:chOff x="1339480" y="1204010"/>
              <a:chExt cx="514872" cy="261610"/>
            </a:xfrm>
          </p:grpSpPr>
          <p:sp>
            <p:nvSpPr>
              <p:cNvPr id="345" name="Textfeld 344"/>
              <p:cNvSpPr txBox="1"/>
              <p:nvPr/>
            </p:nvSpPr>
            <p:spPr>
              <a:xfrm>
                <a:off x="1339480" y="120401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46" name="Textfeld 345"/>
              <p:cNvSpPr txBox="1"/>
              <p:nvPr/>
            </p:nvSpPr>
            <p:spPr>
              <a:xfrm>
                <a:off x="1458000" y="120401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347" name="Gruppieren 346"/>
            <p:cNvGrpSpPr/>
            <p:nvPr/>
          </p:nvGrpSpPr>
          <p:grpSpPr>
            <a:xfrm>
              <a:off x="2598688" y="3888000"/>
              <a:ext cx="515664" cy="320486"/>
              <a:chOff x="1321200" y="1243564"/>
              <a:chExt cx="515664" cy="320486"/>
            </a:xfrm>
          </p:grpSpPr>
          <p:sp>
            <p:nvSpPr>
              <p:cNvPr id="348" name="Textfeld 347"/>
              <p:cNvSpPr txBox="1"/>
              <p:nvPr/>
            </p:nvSpPr>
            <p:spPr>
              <a:xfrm>
                <a:off x="1321200" y="130244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49" name="Textfeld 348"/>
              <p:cNvSpPr txBox="1"/>
              <p:nvPr/>
            </p:nvSpPr>
            <p:spPr>
              <a:xfrm>
                <a:off x="1440512" y="1243564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sp>
          <p:nvSpPr>
            <p:cNvPr id="350" name="Textfeld 349"/>
            <p:cNvSpPr txBox="1"/>
            <p:nvPr/>
          </p:nvSpPr>
          <p:spPr>
            <a:xfrm>
              <a:off x="1079304" y="4941168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sp>
          <p:nvSpPr>
            <p:cNvPr id="351" name="Textfeld 350"/>
            <p:cNvSpPr txBox="1"/>
            <p:nvPr/>
          </p:nvSpPr>
          <p:spPr>
            <a:xfrm>
              <a:off x="1619672" y="4895582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sp>
          <p:nvSpPr>
            <p:cNvPr id="352" name="Textfeld 351"/>
            <p:cNvSpPr txBox="1"/>
            <p:nvPr/>
          </p:nvSpPr>
          <p:spPr>
            <a:xfrm>
              <a:off x="2663480" y="4941168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grpSp>
          <p:nvGrpSpPr>
            <p:cNvPr id="353" name="Gruppieren 352"/>
            <p:cNvGrpSpPr/>
            <p:nvPr/>
          </p:nvGrpSpPr>
          <p:grpSpPr>
            <a:xfrm>
              <a:off x="1014512" y="5994000"/>
              <a:ext cx="533152" cy="261610"/>
              <a:chOff x="1321200" y="1204010"/>
              <a:chExt cx="533152" cy="261610"/>
            </a:xfrm>
          </p:grpSpPr>
          <p:sp>
            <p:nvSpPr>
              <p:cNvPr id="354" name="Textfeld 353"/>
              <p:cNvSpPr txBox="1"/>
              <p:nvPr/>
            </p:nvSpPr>
            <p:spPr>
              <a:xfrm>
                <a:off x="1321200" y="120401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55" name="Textfeld 354"/>
              <p:cNvSpPr txBox="1"/>
              <p:nvPr/>
            </p:nvSpPr>
            <p:spPr>
              <a:xfrm>
                <a:off x="1458000" y="120401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356" name="Gruppieren 355"/>
            <p:cNvGrpSpPr/>
            <p:nvPr/>
          </p:nvGrpSpPr>
          <p:grpSpPr>
            <a:xfrm>
              <a:off x="1547664" y="5994000"/>
              <a:ext cx="533152" cy="261610"/>
              <a:chOff x="1321200" y="1204010"/>
              <a:chExt cx="533152" cy="261610"/>
            </a:xfrm>
          </p:grpSpPr>
          <p:sp>
            <p:nvSpPr>
              <p:cNvPr id="357" name="Textfeld 356"/>
              <p:cNvSpPr txBox="1"/>
              <p:nvPr/>
            </p:nvSpPr>
            <p:spPr>
              <a:xfrm>
                <a:off x="1321200" y="120401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58" name="Textfeld 357"/>
              <p:cNvSpPr txBox="1"/>
              <p:nvPr/>
            </p:nvSpPr>
            <p:spPr>
              <a:xfrm>
                <a:off x="1458000" y="120401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359" name="Gruppieren 358"/>
            <p:cNvGrpSpPr/>
            <p:nvPr/>
          </p:nvGrpSpPr>
          <p:grpSpPr>
            <a:xfrm>
              <a:off x="2077200" y="5994000"/>
              <a:ext cx="525952" cy="261610"/>
              <a:chOff x="1303768" y="1204010"/>
              <a:chExt cx="525952" cy="261610"/>
            </a:xfrm>
          </p:grpSpPr>
          <p:sp>
            <p:nvSpPr>
              <p:cNvPr id="360" name="Textfeld 359"/>
              <p:cNvSpPr txBox="1"/>
              <p:nvPr/>
            </p:nvSpPr>
            <p:spPr>
              <a:xfrm>
                <a:off x="1303768" y="120401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61" name="Textfeld 360"/>
              <p:cNvSpPr txBox="1"/>
              <p:nvPr/>
            </p:nvSpPr>
            <p:spPr>
              <a:xfrm>
                <a:off x="1433368" y="120401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362" name="Gruppieren 361"/>
            <p:cNvGrpSpPr/>
            <p:nvPr/>
          </p:nvGrpSpPr>
          <p:grpSpPr>
            <a:xfrm>
              <a:off x="2609488" y="5975702"/>
              <a:ext cx="522352" cy="261908"/>
              <a:chOff x="1320896" y="1158424"/>
              <a:chExt cx="522352" cy="261908"/>
            </a:xfrm>
          </p:grpSpPr>
          <p:sp>
            <p:nvSpPr>
              <p:cNvPr id="363" name="Textfeld 362"/>
              <p:cNvSpPr txBox="1"/>
              <p:nvPr/>
            </p:nvSpPr>
            <p:spPr>
              <a:xfrm>
                <a:off x="1320896" y="1158424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64" name="Textfeld 363"/>
              <p:cNvSpPr txBox="1"/>
              <p:nvPr/>
            </p:nvSpPr>
            <p:spPr>
              <a:xfrm>
                <a:off x="1446896" y="115872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365" name="Gruppieren 364"/>
            <p:cNvGrpSpPr/>
            <p:nvPr/>
          </p:nvGrpSpPr>
          <p:grpSpPr>
            <a:xfrm>
              <a:off x="3132000" y="5994000"/>
              <a:ext cx="503896" cy="261610"/>
              <a:chOff x="1350456" y="1276018"/>
              <a:chExt cx="503896" cy="261610"/>
            </a:xfrm>
          </p:grpSpPr>
          <p:sp>
            <p:nvSpPr>
              <p:cNvPr id="366" name="Textfeld 365"/>
              <p:cNvSpPr txBox="1"/>
              <p:nvPr/>
            </p:nvSpPr>
            <p:spPr>
              <a:xfrm>
                <a:off x="1350456" y="127601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67" name="Textfeld 366"/>
              <p:cNvSpPr txBox="1"/>
              <p:nvPr/>
            </p:nvSpPr>
            <p:spPr>
              <a:xfrm>
                <a:off x="1458000" y="127601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368" name="Gruppieren 367"/>
            <p:cNvGrpSpPr/>
            <p:nvPr/>
          </p:nvGrpSpPr>
          <p:grpSpPr>
            <a:xfrm>
              <a:off x="4175648" y="5868000"/>
              <a:ext cx="522704" cy="414898"/>
              <a:chOff x="1339576" y="1096308"/>
              <a:chExt cx="522704" cy="414898"/>
            </a:xfrm>
          </p:grpSpPr>
          <p:sp>
            <p:nvSpPr>
              <p:cNvPr id="369" name="Textfeld 368"/>
              <p:cNvSpPr txBox="1"/>
              <p:nvPr/>
            </p:nvSpPr>
            <p:spPr>
              <a:xfrm>
                <a:off x="1339576" y="1249596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70" name="Textfeld 369"/>
              <p:cNvSpPr txBox="1"/>
              <p:nvPr/>
            </p:nvSpPr>
            <p:spPr>
              <a:xfrm>
                <a:off x="1465928" y="109630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sp>
          <p:nvSpPr>
            <p:cNvPr id="371" name="Textfeld 370"/>
            <p:cNvSpPr txBox="1"/>
            <p:nvPr/>
          </p:nvSpPr>
          <p:spPr>
            <a:xfrm rot="16200000">
              <a:off x="146605" y="869621"/>
              <a:ext cx="8727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ld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2" name="Textfeld 371"/>
            <p:cNvSpPr txBox="1"/>
            <p:nvPr/>
          </p:nvSpPr>
          <p:spPr>
            <a:xfrm rot="16200000">
              <a:off x="146605" y="1871523"/>
              <a:ext cx="8727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ld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3" name="Textfeld 372"/>
            <p:cNvSpPr txBox="1"/>
            <p:nvPr/>
          </p:nvSpPr>
          <p:spPr>
            <a:xfrm rot="16200000">
              <a:off x="146605" y="2915584"/>
              <a:ext cx="8727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ld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4" name="Textfeld 373"/>
            <p:cNvSpPr txBox="1"/>
            <p:nvPr/>
          </p:nvSpPr>
          <p:spPr>
            <a:xfrm rot="16200000">
              <a:off x="146605" y="5901564"/>
              <a:ext cx="8727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ld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5" name="Textfeld 374"/>
            <p:cNvSpPr txBox="1"/>
            <p:nvPr/>
          </p:nvSpPr>
          <p:spPr>
            <a:xfrm rot="16200000">
              <a:off x="146605" y="4914210"/>
              <a:ext cx="8727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ld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6" name="Textfeld 375"/>
            <p:cNvSpPr txBox="1"/>
            <p:nvPr/>
          </p:nvSpPr>
          <p:spPr>
            <a:xfrm rot="16200000">
              <a:off x="146605" y="3911038"/>
              <a:ext cx="8727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ld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7" name="Textfeld 376"/>
            <p:cNvSpPr txBox="1"/>
            <p:nvPr/>
          </p:nvSpPr>
          <p:spPr>
            <a:xfrm rot="16200000">
              <a:off x="4539092" y="861004"/>
              <a:ext cx="8727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ld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8" name="Textfeld 377"/>
            <p:cNvSpPr txBox="1"/>
            <p:nvPr/>
          </p:nvSpPr>
          <p:spPr>
            <a:xfrm rot="16200000">
              <a:off x="4539092" y="1880139"/>
              <a:ext cx="8727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ld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9" name="Textfeld 378"/>
            <p:cNvSpPr txBox="1"/>
            <p:nvPr/>
          </p:nvSpPr>
          <p:spPr>
            <a:xfrm rot="16200000">
              <a:off x="4539092" y="2838748"/>
              <a:ext cx="8727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ld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80" name="Gruppieren 379"/>
            <p:cNvGrpSpPr/>
            <p:nvPr/>
          </p:nvGrpSpPr>
          <p:grpSpPr>
            <a:xfrm>
              <a:off x="7236296" y="2951366"/>
              <a:ext cx="612376" cy="261610"/>
              <a:chOff x="2735488" y="4077072"/>
              <a:chExt cx="612376" cy="261610"/>
            </a:xfrm>
          </p:grpSpPr>
          <p:sp>
            <p:nvSpPr>
              <p:cNvPr id="381" name="Textfeld 380"/>
              <p:cNvSpPr txBox="1"/>
              <p:nvPr/>
            </p:nvSpPr>
            <p:spPr>
              <a:xfrm>
                <a:off x="2843192" y="407707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82" name="Textfeld 381"/>
              <p:cNvSpPr txBox="1"/>
              <p:nvPr/>
            </p:nvSpPr>
            <p:spPr>
              <a:xfrm>
                <a:off x="2951512" y="407707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83" name="Textfeld 382"/>
              <p:cNvSpPr txBox="1"/>
              <p:nvPr/>
            </p:nvSpPr>
            <p:spPr>
              <a:xfrm>
                <a:off x="2735488" y="407707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384" name="Gruppieren 383"/>
            <p:cNvGrpSpPr/>
            <p:nvPr/>
          </p:nvGrpSpPr>
          <p:grpSpPr>
            <a:xfrm>
              <a:off x="6623920" y="2951366"/>
              <a:ext cx="612376" cy="261610"/>
              <a:chOff x="2735488" y="4077072"/>
              <a:chExt cx="612376" cy="261610"/>
            </a:xfrm>
          </p:grpSpPr>
          <p:sp>
            <p:nvSpPr>
              <p:cNvPr id="385" name="Textfeld 384"/>
              <p:cNvSpPr txBox="1"/>
              <p:nvPr/>
            </p:nvSpPr>
            <p:spPr>
              <a:xfrm>
                <a:off x="2843192" y="407707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86" name="Textfeld 385"/>
              <p:cNvSpPr txBox="1"/>
              <p:nvPr/>
            </p:nvSpPr>
            <p:spPr>
              <a:xfrm>
                <a:off x="2951512" y="407707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87" name="Textfeld 386"/>
              <p:cNvSpPr txBox="1"/>
              <p:nvPr/>
            </p:nvSpPr>
            <p:spPr>
              <a:xfrm>
                <a:off x="2735488" y="407707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388" name="Gruppieren 387"/>
            <p:cNvGrpSpPr/>
            <p:nvPr/>
          </p:nvGrpSpPr>
          <p:grpSpPr>
            <a:xfrm>
              <a:off x="5975848" y="2951366"/>
              <a:ext cx="612376" cy="261610"/>
              <a:chOff x="2735488" y="4077072"/>
              <a:chExt cx="612376" cy="261610"/>
            </a:xfrm>
          </p:grpSpPr>
          <p:sp>
            <p:nvSpPr>
              <p:cNvPr id="389" name="Textfeld 388"/>
              <p:cNvSpPr txBox="1"/>
              <p:nvPr/>
            </p:nvSpPr>
            <p:spPr>
              <a:xfrm>
                <a:off x="2843192" y="407707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90" name="Textfeld 389"/>
              <p:cNvSpPr txBox="1"/>
              <p:nvPr/>
            </p:nvSpPr>
            <p:spPr>
              <a:xfrm>
                <a:off x="2951512" y="407707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91" name="Textfeld 390"/>
              <p:cNvSpPr txBox="1"/>
              <p:nvPr/>
            </p:nvSpPr>
            <p:spPr>
              <a:xfrm>
                <a:off x="2735488" y="407707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392" name="Gruppieren 391"/>
            <p:cNvGrpSpPr/>
            <p:nvPr/>
          </p:nvGrpSpPr>
          <p:grpSpPr>
            <a:xfrm>
              <a:off x="5364088" y="2951366"/>
              <a:ext cx="612376" cy="261610"/>
              <a:chOff x="2735488" y="4077072"/>
              <a:chExt cx="612376" cy="261610"/>
            </a:xfrm>
          </p:grpSpPr>
          <p:sp>
            <p:nvSpPr>
              <p:cNvPr id="393" name="Textfeld 392"/>
              <p:cNvSpPr txBox="1"/>
              <p:nvPr/>
            </p:nvSpPr>
            <p:spPr>
              <a:xfrm>
                <a:off x="2843192" y="407707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94" name="Textfeld 393"/>
              <p:cNvSpPr txBox="1"/>
              <p:nvPr/>
            </p:nvSpPr>
            <p:spPr>
              <a:xfrm>
                <a:off x="2951512" y="407707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95" name="Textfeld 394"/>
              <p:cNvSpPr txBox="1"/>
              <p:nvPr/>
            </p:nvSpPr>
            <p:spPr>
              <a:xfrm>
                <a:off x="2735488" y="407707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sp>
          <p:nvSpPr>
            <p:cNvPr id="396" name="Textfeld 395"/>
            <p:cNvSpPr txBox="1"/>
            <p:nvPr/>
          </p:nvSpPr>
          <p:spPr>
            <a:xfrm>
              <a:off x="6210000" y="1943254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sp>
          <p:nvSpPr>
            <p:cNvPr id="397" name="Textfeld 396"/>
            <p:cNvSpPr txBox="1"/>
            <p:nvPr/>
          </p:nvSpPr>
          <p:spPr>
            <a:xfrm>
              <a:off x="6084168" y="1988840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sp>
          <p:nvSpPr>
            <p:cNvPr id="398" name="Textfeld 397"/>
            <p:cNvSpPr txBox="1"/>
            <p:nvPr/>
          </p:nvSpPr>
          <p:spPr>
            <a:xfrm>
              <a:off x="5994000" y="1943254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grpSp>
          <p:nvGrpSpPr>
            <p:cNvPr id="399" name="Gruppieren 398"/>
            <p:cNvGrpSpPr/>
            <p:nvPr/>
          </p:nvGrpSpPr>
          <p:grpSpPr>
            <a:xfrm>
              <a:off x="7855749" y="1988840"/>
              <a:ext cx="612376" cy="261610"/>
              <a:chOff x="3311552" y="2708920"/>
              <a:chExt cx="612376" cy="261610"/>
            </a:xfrm>
          </p:grpSpPr>
          <p:sp>
            <p:nvSpPr>
              <p:cNvPr id="400" name="Textfeld 399"/>
              <p:cNvSpPr txBox="1"/>
              <p:nvPr/>
            </p:nvSpPr>
            <p:spPr>
              <a:xfrm>
                <a:off x="3311552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01" name="Textfeld 400"/>
              <p:cNvSpPr txBox="1"/>
              <p:nvPr/>
            </p:nvSpPr>
            <p:spPr>
              <a:xfrm>
                <a:off x="3419872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02" name="Textfeld 401"/>
              <p:cNvSpPr txBox="1"/>
              <p:nvPr/>
            </p:nvSpPr>
            <p:spPr>
              <a:xfrm>
                <a:off x="3527576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403" name="Gruppieren 402"/>
            <p:cNvGrpSpPr/>
            <p:nvPr/>
          </p:nvGrpSpPr>
          <p:grpSpPr>
            <a:xfrm>
              <a:off x="7848056" y="935142"/>
              <a:ext cx="612376" cy="261610"/>
              <a:chOff x="3311552" y="2708920"/>
              <a:chExt cx="612376" cy="261610"/>
            </a:xfrm>
          </p:grpSpPr>
          <p:sp>
            <p:nvSpPr>
              <p:cNvPr id="404" name="Textfeld 403"/>
              <p:cNvSpPr txBox="1"/>
              <p:nvPr/>
            </p:nvSpPr>
            <p:spPr>
              <a:xfrm>
                <a:off x="3311552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05" name="Textfeld 404"/>
              <p:cNvSpPr txBox="1"/>
              <p:nvPr/>
            </p:nvSpPr>
            <p:spPr>
              <a:xfrm>
                <a:off x="3419872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06" name="Textfeld 405"/>
              <p:cNvSpPr txBox="1"/>
              <p:nvPr/>
            </p:nvSpPr>
            <p:spPr>
              <a:xfrm>
                <a:off x="3527576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407" name="Gruppieren 406"/>
            <p:cNvGrpSpPr/>
            <p:nvPr/>
          </p:nvGrpSpPr>
          <p:grpSpPr>
            <a:xfrm>
              <a:off x="7236296" y="935142"/>
              <a:ext cx="612376" cy="261610"/>
              <a:chOff x="3311552" y="2708920"/>
              <a:chExt cx="612376" cy="261610"/>
            </a:xfrm>
          </p:grpSpPr>
          <p:sp>
            <p:nvSpPr>
              <p:cNvPr id="408" name="Textfeld 407"/>
              <p:cNvSpPr txBox="1"/>
              <p:nvPr/>
            </p:nvSpPr>
            <p:spPr>
              <a:xfrm>
                <a:off x="3311552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09" name="Textfeld 408"/>
              <p:cNvSpPr txBox="1"/>
              <p:nvPr/>
            </p:nvSpPr>
            <p:spPr>
              <a:xfrm>
                <a:off x="3419872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10" name="Textfeld 409"/>
              <p:cNvSpPr txBox="1"/>
              <p:nvPr/>
            </p:nvSpPr>
            <p:spPr>
              <a:xfrm>
                <a:off x="3527576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411" name="Gruppieren 410"/>
            <p:cNvGrpSpPr/>
            <p:nvPr/>
          </p:nvGrpSpPr>
          <p:grpSpPr>
            <a:xfrm>
              <a:off x="5975848" y="935142"/>
              <a:ext cx="612376" cy="261610"/>
              <a:chOff x="3311552" y="2708920"/>
              <a:chExt cx="612376" cy="261610"/>
            </a:xfrm>
          </p:grpSpPr>
          <p:sp>
            <p:nvSpPr>
              <p:cNvPr id="412" name="Textfeld 411"/>
              <p:cNvSpPr txBox="1"/>
              <p:nvPr/>
            </p:nvSpPr>
            <p:spPr>
              <a:xfrm>
                <a:off x="3311552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13" name="Textfeld 412"/>
              <p:cNvSpPr txBox="1"/>
              <p:nvPr/>
            </p:nvSpPr>
            <p:spPr>
              <a:xfrm>
                <a:off x="3419872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14" name="Textfeld 413"/>
              <p:cNvSpPr txBox="1"/>
              <p:nvPr/>
            </p:nvSpPr>
            <p:spPr>
              <a:xfrm>
                <a:off x="3527576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415" name="Gruppieren 414"/>
            <p:cNvGrpSpPr/>
            <p:nvPr/>
          </p:nvGrpSpPr>
          <p:grpSpPr>
            <a:xfrm>
              <a:off x="5364088" y="863134"/>
              <a:ext cx="648072" cy="333618"/>
              <a:chOff x="3240120" y="2807350"/>
              <a:chExt cx="648072" cy="333618"/>
            </a:xfrm>
          </p:grpSpPr>
          <p:sp>
            <p:nvSpPr>
              <p:cNvPr id="416" name="Textfeld 415"/>
              <p:cNvSpPr txBox="1"/>
              <p:nvPr/>
            </p:nvSpPr>
            <p:spPr>
              <a:xfrm>
                <a:off x="3240120" y="280735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17" name="Textfeld 416"/>
              <p:cNvSpPr txBox="1"/>
              <p:nvPr/>
            </p:nvSpPr>
            <p:spPr>
              <a:xfrm>
                <a:off x="3384136" y="287935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18" name="Textfeld 417"/>
              <p:cNvSpPr txBox="1"/>
              <p:nvPr/>
            </p:nvSpPr>
            <p:spPr>
              <a:xfrm>
                <a:off x="3491840" y="287935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419" name="Gruppieren 418"/>
            <p:cNvGrpSpPr/>
            <p:nvPr/>
          </p:nvGrpSpPr>
          <p:grpSpPr>
            <a:xfrm>
              <a:off x="6732240" y="935142"/>
              <a:ext cx="504056" cy="261610"/>
              <a:chOff x="3419872" y="2708920"/>
              <a:chExt cx="504056" cy="261610"/>
            </a:xfrm>
          </p:grpSpPr>
          <p:sp>
            <p:nvSpPr>
              <p:cNvPr id="420" name="Textfeld 419"/>
              <p:cNvSpPr txBox="1"/>
              <p:nvPr/>
            </p:nvSpPr>
            <p:spPr>
              <a:xfrm>
                <a:off x="3419872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21" name="Textfeld 420"/>
              <p:cNvSpPr txBox="1"/>
              <p:nvPr/>
            </p:nvSpPr>
            <p:spPr>
              <a:xfrm>
                <a:off x="3527576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sp>
          <p:nvSpPr>
            <p:cNvPr id="422" name="Rechteck 421"/>
            <p:cNvSpPr/>
            <p:nvPr/>
          </p:nvSpPr>
          <p:spPr>
            <a:xfrm>
              <a:off x="6359452" y="6563409"/>
              <a:ext cx="84756" cy="792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23" name="Textfeld 422"/>
            <p:cNvSpPr txBox="1"/>
            <p:nvPr/>
          </p:nvSpPr>
          <p:spPr>
            <a:xfrm rot="16200000">
              <a:off x="4539092" y="5901564"/>
              <a:ext cx="8727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ld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4" name="Textfeld 423"/>
            <p:cNvSpPr txBox="1"/>
            <p:nvPr/>
          </p:nvSpPr>
          <p:spPr>
            <a:xfrm rot="16200000">
              <a:off x="4539092" y="4914210"/>
              <a:ext cx="8727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ld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5" name="Textfeld 424"/>
            <p:cNvSpPr txBox="1"/>
            <p:nvPr/>
          </p:nvSpPr>
          <p:spPr>
            <a:xfrm rot="16200000">
              <a:off x="4539092" y="3881375"/>
              <a:ext cx="8727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ld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26" name="Gruppieren 425"/>
            <p:cNvGrpSpPr/>
            <p:nvPr/>
          </p:nvGrpSpPr>
          <p:grpSpPr>
            <a:xfrm>
              <a:off x="7812360" y="3959478"/>
              <a:ext cx="612376" cy="261610"/>
              <a:chOff x="3311552" y="2708920"/>
              <a:chExt cx="612376" cy="261610"/>
            </a:xfrm>
          </p:grpSpPr>
          <p:sp>
            <p:nvSpPr>
              <p:cNvPr id="427" name="Textfeld 426"/>
              <p:cNvSpPr txBox="1"/>
              <p:nvPr/>
            </p:nvSpPr>
            <p:spPr>
              <a:xfrm>
                <a:off x="3311552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28" name="Textfeld 427"/>
              <p:cNvSpPr txBox="1"/>
              <p:nvPr/>
            </p:nvSpPr>
            <p:spPr>
              <a:xfrm>
                <a:off x="3419872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29" name="Textfeld 428"/>
              <p:cNvSpPr txBox="1"/>
              <p:nvPr/>
            </p:nvSpPr>
            <p:spPr>
              <a:xfrm>
                <a:off x="3527576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430" name="Gruppieren 429"/>
            <p:cNvGrpSpPr/>
            <p:nvPr/>
          </p:nvGrpSpPr>
          <p:grpSpPr>
            <a:xfrm>
              <a:off x="7199984" y="3959478"/>
              <a:ext cx="612376" cy="261610"/>
              <a:chOff x="3311552" y="2708920"/>
              <a:chExt cx="612376" cy="261610"/>
            </a:xfrm>
          </p:grpSpPr>
          <p:sp>
            <p:nvSpPr>
              <p:cNvPr id="431" name="Textfeld 430"/>
              <p:cNvSpPr txBox="1"/>
              <p:nvPr/>
            </p:nvSpPr>
            <p:spPr>
              <a:xfrm>
                <a:off x="3311552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32" name="Textfeld 431"/>
              <p:cNvSpPr txBox="1"/>
              <p:nvPr/>
            </p:nvSpPr>
            <p:spPr>
              <a:xfrm>
                <a:off x="3419872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33" name="Textfeld 432"/>
              <p:cNvSpPr txBox="1"/>
              <p:nvPr/>
            </p:nvSpPr>
            <p:spPr>
              <a:xfrm>
                <a:off x="3527576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434" name="Gruppieren 433"/>
            <p:cNvGrpSpPr/>
            <p:nvPr/>
          </p:nvGrpSpPr>
          <p:grpSpPr>
            <a:xfrm>
              <a:off x="5994000" y="3887470"/>
              <a:ext cx="618500" cy="333618"/>
              <a:chOff x="3311552" y="2754506"/>
              <a:chExt cx="612376" cy="333618"/>
            </a:xfrm>
          </p:grpSpPr>
          <p:sp>
            <p:nvSpPr>
              <p:cNvPr id="435" name="Textfeld 434"/>
              <p:cNvSpPr txBox="1"/>
              <p:nvPr/>
            </p:nvSpPr>
            <p:spPr>
              <a:xfrm>
                <a:off x="3311552" y="2826514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36" name="Textfeld 435"/>
              <p:cNvSpPr txBox="1"/>
              <p:nvPr/>
            </p:nvSpPr>
            <p:spPr>
              <a:xfrm>
                <a:off x="3419871" y="2826514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37" name="Textfeld 436"/>
              <p:cNvSpPr txBox="1"/>
              <p:nvPr/>
            </p:nvSpPr>
            <p:spPr>
              <a:xfrm>
                <a:off x="3527576" y="2754506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438" name="Gruppieren 437"/>
            <p:cNvGrpSpPr/>
            <p:nvPr/>
          </p:nvGrpSpPr>
          <p:grpSpPr>
            <a:xfrm>
              <a:off x="5364088" y="3887470"/>
              <a:ext cx="612376" cy="333618"/>
              <a:chOff x="3311552" y="2852936"/>
              <a:chExt cx="612376" cy="333618"/>
            </a:xfrm>
          </p:grpSpPr>
          <p:sp>
            <p:nvSpPr>
              <p:cNvPr id="439" name="Textfeld 438"/>
              <p:cNvSpPr txBox="1"/>
              <p:nvPr/>
            </p:nvSpPr>
            <p:spPr>
              <a:xfrm>
                <a:off x="3311552" y="2924944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40" name="Textfeld 439"/>
              <p:cNvSpPr txBox="1"/>
              <p:nvPr/>
            </p:nvSpPr>
            <p:spPr>
              <a:xfrm>
                <a:off x="3419872" y="2924944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41" name="Textfeld 440"/>
              <p:cNvSpPr txBox="1"/>
              <p:nvPr/>
            </p:nvSpPr>
            <p:spPr>
              <a:xfrm>
                <a:off x="3527576" y="2852936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442" name="Gruppieren 441"/>
            <p:cNvGrpSpPr/>
            <p:nvPr/>
          </p:nvGrpSpPr>
          <p:grpSpPr>
            <a:xfrm>
              <a:off x="6605824" y="3933056"/>
              <a:ext cx="630472" cy="288032"/>
              <a:chOff x="3293456" y="2800092"/>
              <a:chExt cx="630472" cy="288032"/>
            </a:xfrm>
          </p:grpSpPr>
          <p:sp>
            <p:nvSpPr>
              <p:cNvPr id="443" name="Textfeld 442"/>
              <p:cNvSpPr txBox="1"/>
              <p:nvPr/>
            </p:nvSpPr>
            <p:spPr>
              <a:xfrm>
                <a:off x="3293456" y="280009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44" name="Textfeld 443"/>
              <p:cNvSpPr txBox="1"/>
              <p:nvPr/>
            </p:nvSpPr>
            <p:spPr>
              <a:xfrm>
                <a:off x="3419872" y="2826514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45" name="Textfeld 444"/>
              <p:cNvSpPr txBox="1"/>
              <p:nvPr/>
            </p:nvSpPr>
            <p:spPr>
              <a:xfrm>
                <a:off x="3527576" y="2826514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446" name="Gruppieren 445"/>
            <p:cNvGrpSpPr/>
            <p:nvPr/>
          </p:nvGrpSpPr>
          <p:grpSpPr>
            <a:xfrm>
              <a:off x="5436096" y="4941159"/>
              <a:ext cx="504056" cy="261610"/>
              <a:chOff x="3419872" y="2708920"/>
              <a:chExt cx="504056" cy="261610"/>
            </a:xfrm>
          </p:grpSpPr>
          <p:sp>
            <p:nvSpPr>
              <p:cNvPr id="447" name="Textfeld 446"/>
              <p:cNvSpPr txBox="1"/>
              <p:nvPr/>
            </p:nvSpPr>
            <p:spPr>
              <a:xfrm>
                <a:off x="3419872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48" name="Textfeld 447"/>
              <p:cNvSpPr txBox="1"/>
              <p:nvPr/>
            </p:nvSpPr>
            <p:spPr>
              <a:xfrm>
                <a:off x="3527576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449" name="Gruppieren 448"/>
            <p:cNvGrpSpPr/>
            <p:nvPr/>
          </p:nvGrpSpPr>
          <p:grpSpPr>
            <a:xfrm>
              <a:off x="6066088" y="4941168"/>
              <a:ext cx="511464" cy="288028"/>
              <a:chOff x="3401792" y="2754510"/>
              <a:chExt cx="511464" cy="288028"/>
            </a:xfrm>
          </p:grpSpPr>
          <p:sp>
            <p:nvSpPr>
              <p:cNvPr id="450" name="Textfeld 449"/>
              <p:cNvSpPr txBox="1"/>
              <p:nvPr/>
            </p:nvSpPr>
            <p:spPr>
              <a:xfrm>
                <a:off x="3401792" y="278092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51" name="Textfeld 450"/>
              <p:cNvSpPr txBox="1"/>
              <p:nvPr/>
            </p:nvSpPr>
            <p:spPr>
              <a:xfrm>
                <a:off x="3516904" y="275451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452" name="Gruppieren 451"/>
            <p:cNvGrpSpPr/>
            <p:nvPr/>
          </p:nvGrpSpPr>
          <p:grpSpPr>
            <a:xfrm>
              <a:off x="6660232" y="4869160"/>
              <a:ext cx="540368" cy="360040"/>
              <a:chOff x="3347864" y="2924944"/>
              <a:chExt cx="540368" cy="360040"/>
            </a:xfrm>
          </p:grpSpPr>
          <p:sp>
            <p:nvSpPr>
              <p:cNvPr id="453" name="Textfeld 452"/>
              <p:cNvSpPr txBox="1"/>
              <p:nvPr/>
            </p:nvSpPr>
            <p:spPr>
              <a:xfrm>
                <a:off x="3347864" y="2924944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54" name="Textfeld 453"/>
              <p:cNvSpPr txBox="1"/>
              <p:nvPr/>
            </p:nvSpPr>
            <p:spPr>
              <a:xfrm>
                <a:off x="3491880" y="3023374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455" name="Gruppieren 454"/>
            <p:cNvGrpSpPr/>
            <p:nvPr/>
          </p:nvGrpSpPr>
          <p:grpSpPr>
            <a:xfrm>
              <a:off x="7254000" y="4941159"/>
              <a:ext cx="504056" cy="261610"/>
              <a:chOff x="3419872" y="2708920"/>
              <a:chExt cx="504056" cy="261610"/>
            </a:xfrm>
          </p:grpSpPr>
          <p:sp>
            <p:nvSpPr>
              <p:cNvPr id="456" name="Textfeld 455"/>
              <p:cNvSpPr txBox="1"/>
              <p:nvPr/>
            </p:nvSpPr>
            <p:spPr>
              <a:xfrm>
                <a:off x="3419872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57" name="Textfeld 456"/>
              <p:cNvSpPr txBox="1"/>
              <p:nvPr/>
            </p:nvSpPr>
            <p:spPr>
              <a:xfrm>
                <a:off x="3527576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458" name="Gruppieren 457"/>
            <p:cNvGrpSpPr/>
            <p:nvPr/>
          </p:nvGrpSpPr>
          <p:grpSpPr>
            <a:xfrm>
              <a:off x="7876904" y="4941159"/>
              <a:ext cx="504056" cy="261610"/>
              <a:chOff x="3419872" y="2708920"/>
              <a:chExt cx="504056" cy="261610"/>
            </a:xfrm>
          </p:grpSpPr>
          <p:sp>
            <p:nvSpPr>
              <p:cNvPr id="459" name="Textfeld 458"/>
              <p:cNvSpPr txBox="1"/>
              <p:nvPr/>
            </p:nvSpPr>
            <p:spPr>
              <a:xfrm>
                <a:off x="3419872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60" name="Textfeld 459"/>
              <p:cNvSpPr txBox="1"/>
              <p:nvPr/>
            </p:nvSpPr>
            <p:spPr>
              <a:xfrm>
                <a:off x="3527576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461" name="Gruppieren 460"/>
            <p:cNvGrpSpPr/>
            <p:nvPr/>
          </p:nvGrpSpPr>
          <p:grpSpPr>
            <a:xfrm>
              <a:off x="5364088" y="5975702"/>
              <a:ext cx="612376" cy="261610"/>
              <a:chOff x="3311552" y="2924944"/>
              <a:chExt cx="612376" cy="261610"/>
            </a:xfrm>
          </p:grpSpPr>
          <p:sp>
            <p:nvSpPr>
              <p:cNvPr id="462" name="Textfeld 461"/>
              <p:cNvSpPr txBox="1"/>
              <p:nvPr/>
            </p:nvSpPr>
            <p:spPr>
              <a:xfrm>
                <a:off x="3311552" y="2924944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63" name="Textfeld 462"/>
              <p:cNvSpPr txBox="1"/>
              <p:nvPr/>
            </p:nvSpPr>
            <p:spPr>
              <a:xfrm>
                <a:off x="3419872" y="2924944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64" name="Textfeld 463"/>
              <p:cNvSpPr txBox="1"/>
              <p:nvPr/>
            </p:nvSpPr>
            <p:spPr>
              <a:xfrm>
                <a:off x="3527576" y="2924944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465" name="Gruppieren 464"/>
            <p:cNvGrpSpPr/>
            <p:nvPr/>
          </p:nvGrpSpPr>
          <p:grpSpPr>
            <a:xfrm>
              <a:off x="5975848" y="5903694"/>
              <a:ext cx="630504" cy="333618"/>
              <a:chOff x="3311552" y="2924944"/>
              <a:chExt cx="630504" cy="333618"/>
            </a:xfrm>
          </p:grpSpPr>
          <p:sp>
            <p:nvSpPr>
              <p:cNvPr id="466" name="Textfeld 465"/>
              <p:cNvSpPr txBox="1"/>
              <p:nvPr/>
            </p:nvSpPr>
            <p:spPr>
              <a:xfrm>
                <a:off x="3311552" y="296125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67" name="Textfeld 466"/>
              <p:cNvSpPr txBox="1"/>
              <p:nvPr/>
            </p:nvSpPr>
            <p:spPr>
              <a:xfrm>
                <a:off x="3419872" y="299695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68" name="Textfeld 467"/>
              <p:cNvSpPr txBox="1"/>
              <p:nvPr/>
            </p:nvSpPr>
            <p:spPr>
              <a:xfrm>
                <a:off x="3545704" y="2924944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469" name="Gruppieren 468"/>
            <p:cNvGrpSpPr/>
            <p:nvPr/>
          </p:nvGrpSpPr>
          <p:grpSpPr>
            <a:xfrm>
              <a:off x="6732240" y="5949280"/>
              <a:ext cx="486112" cy="314760"/>
              <a:chOff x="3401792" y="2754200"/>
              <a:chExt cx="486112" cy="314760"/>
            </a:xfrm>
          </p:grpSpPr>
          <p:sp>
            <p:nvSpPr>
              <p:cNvPr id="470" name="Textfeld 469"/>
              <p:cNvSpPr txBox="1"/>
              <p:nvPr/>
            </p:nvSpPr>
            <p:spPr>
              <a:xfrm>
                <a:off x="3401792" y="280735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71" name="Textfeld 470"/>
              <p:cNvSpPr txBox="1"/>
              <p:nvPr/>
            </p:nvSpPr>
            <p:spPr>
              <a:xfrm>
                <a:off x="3491552" y="27542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472" name="Gruppieren 471"/>
            <p:cNvGrpSpPr/>
            <p:nvPr/>
          </p:nvGrpSpPr>
          <p:grpSpPr>
            <a:xfrm>
              <a:off x="7812360" y="5975691"/>
              <a:ext cx="612376" cy="261610"/>
              <a:chOff x="3311552" y="2708920"/>
              <a:chExt cx="612376" cy="261610"/>
            </a:xfrm>
          </p:grpSpPr>
          <p:sp>
            <p:nvSpPr>
              <p:cNvPr id="473" name="Textfeld 472"/>
              <p:cNvSpPr txBox="1"/>
              <p:nvPr/>
            </p:nvSpPr>
            <p:spPr>
              <a:xfrm>
                <a:off x="3311552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74" name="Textfeld 473"/>
              <p:cNvSpPr txBox="1"/>
              <p:nvPr/>
            </p:nvSpPr>
            <p:spPr>
              <a:xfrm>
                <a:off x="3419872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75" name="Textfeld 474"/>
              <p:cNvSpPr txBox="1"/>
              <p:nvPr/>
            </p:nvSpPr>
            <p:spPr>
              <a:xfrm>
                <a:off x="3527576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476" name="Gruppieren 475"/>
            <p:cNvGrpSpPr/>
            <p:nvPr/>
          </p:nvGrpSpPr>
          <p:grpSpPr>
            <a:xfrm>
              <a:off x="7199984" y="5975691"/>
              <a:ext cx="612376" cy="261610"/>
              <a:chOff x="3311552" y="2708920"/>
              <a:chExt cx="612376" cy="261610"/>
            </a:xfrm>
          </p:grpSpPr>
          <p:sp>
            <p:nvSpPr>
              <p:cNvPr id="477" name="Textfeld 476"/>
              <p:cNvSpPr txBox="1"/>
              <p:nvPr/>
            </p:nvSpPr>
            <p:spPr>
              <a:xfrm>
                <a:off x="3311552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78" name="Textfeld 477"/>
              <p:cNvSpPr txBox="1"/>
              <p:nvPr/>
            </p:nvSpPr>
            <p:spPr>
              <a:xfrm>
                <a:off x="3419872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79" name="Textfeld 478"/>
              <p:cNvSpPr txBox="1"/>
              <p:nvPr/>
            </p:nvSpPr>
            <p:spPr>
              <a:xfrm>
                <a:off x="3527576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sp>
          <p:nvSpPr>
            <p:cNvPr id="480" name="Rechteck 479"/>
            <p:cNvSpPr/>
            <p:nvPr/>
          </p:nvSpPr>
          <p:spPr>
            <a:xfrm>
              <a:off x="354996" y="404666"/>
              <a:ext cx="8064000" cy="100811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81" name="Rechteck 480"/>
            <p:cNvSpPr/>
            <p:nvPr/>
          </p:nvSpPr>
          <p:spPr>
            <a:xfrm>
              <a:off x="354996" y="1412776"/>
              <a:ext cx="8064000" cy="10080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82" name="Rechteck 481"/>
            <p:cNvSpPr/>
            <p:nvPr/>
          </p:nvSpPr>
          <p:spPr>
            <a:xfrm>
              <a:off x="354996" y="2420888"/>
              <a:ext cx="8064000" cy="10080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83" name="Rechteck 482"/>
            <p:cNvSpPr/>
            <p:nvPr/>
          </p:nvSpPr>
          <p:spPr>
            <a:xfrm>
              <a:off x="354996" y="3429000"/>
              <a:ext cx="8064000" cy="10080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84" name="Rechteck 483"/>
            <p:cNvSpPr/>
            <p:nvPr/>
          </p:nvSpPr>
          <p:spPr>
            <a:xfrm>
              <a:off x="354996" y="4437112"/>
              <a:ext cx="8064000" cy="10080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85" name="Rechteck 484"/>
            <p:cNvSpPr/>
            <p:nvPr/>
          </p:nvSpPr>
          <p:spPr>
            <a:xfrm>
              <a:off x="354996" y="5445224"/>
              <a:ext cx="8064000" cy="10080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86" name="Textfeld 485"/>
            <p:cNvSpPr txBox="1"/>
            <p:nvPr/>
          </p:nvSpPr>
          <p:spPr>
            <a:xfrm rot="16200000">
              <a:off x="-423882" y="1554145"/>
              <a:ext cx="129614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RMA2</a:t>
              </a:r>
            </a:p>
          </p:txBody>
        </p:sp>
        <p:sp>
          <p:nvSpPr>
            <p:cNvPr id="487" name="Textfeld 486"/>
            <p:cNvSpPr txBox="1"/>
            <p:nvPr/>
          </p:nvSpPr>
          <p:spPr>
            <a:xfrm>
              <a:off x="4788599" y="404664"/>
              <a:ext cx="2154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8" name="Textfeld 487"/>
            <p:cNvSpPr txBox="1"/>
            <p:nvPr/>
          </p:nvSpPr>
          <p:spPr>
            <a:xfrm>
              <a:off x="4788599" y="1412768"/>
              <a:ext cx="2154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</a:p>
          </p:txBody>
        </p:sp>
        <p:sp>
          <p:nvSpPr>
            <p:cNvPr id="489" name="Textfeld 488"/>
            <p:cNvSpPr txBox="1"/>
            <p:nvPr/>
          </p:nvSpPr>
          <p:spPr>
            <a:xfrm>
              <a:off x="4788599" y="2409527"/>
              <a:ext cx="2154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</a:p>
          </p:txBody>
        </p:sp>
        <p:sp>
          <p:nvSpPr>
            <p:cNvPr id="490" name="Textfeld 489"/>
            <p:cNvSpPr txBox="1"/>
            <p:nvPr/>
          </p:nvSpPr>
          <p:spPr>
            <a:xfrm>
              <a:off x="4788600" y="3416025"/>
              <a:ext cx="2154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j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1" name="Textfeld 490"/>
            <p:cNvSpPr txBox="1"/>
            <p:nvPr/>
          </p:nvSpPr>
          <p:spPr>
            <a:xfrm>
              <a:off x="4788600" y="4412732"/>
              <a:ext cx="2154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2" name="Textfeld 491"/>
            <p:cNvSpPr txBox="1"/>
            <p:nvPr/>
          </p:nvSpPr>
          <p:spPr>
            <a:xfrm>
              <a:off x="4788600" y="5435966"/>
              <a:ext cx="2154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3" name="Rechteck 492"/>
            <p:cNvSpPr/>
            <p:nvPr/>
          </p:nvSpPr>
          <p:spPr>
            <a:xfrm>
              <a:off x="35496" y="404664"/>
              <a:ext cx="319500" cy="1008104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94" name="Rechteck 493"/>
            <p:cNvSpPr/>
            <p:nvPr/>
          </p:nvSpPr>
          <p:spPr>
            <a:xfrm>
              <a:off x="35496" y="1412784"/>
              <a:ext cx="319500" cy="1008104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95" name="Rechteck 494"/>
            <p:cNvSpPr/>
            <p:nvPr/>
          </p:nvSpPr>
          <p:spPr>
            <a:xfrm>
              <a:off x="35496" y="2420888"/>
              <a:ext cx="319500" cy="1008104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96" name="Rechteck 495"/>
            <p:cNvSpPr/>
            <p:nvPr/>
          </p:nvSpPr>
          <p:spPr>
            <a:xfrm>
              <a:off x="35496" y="3429008"/>
              <a:ext cx="319500" cy="1008104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97" name="Rechteck 496"/>
            <p:cNvSpPr/>
            <p:nvPr/>
          </p:nvSpPr>
          <p:spPr>
            <a:xfrm>
              <a:off x="35496" y="4437120"/>
              <a:ext cx="319500" cy="1008104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98" name="Rechteck 497"/>
            <p:cNvSpPr/>
            <p:nvPr/>
          </p:nvSpPr>
          <p:spPr>
            <a:xfrm>
              <a:off x="35496" y="5445232"/>
              <a:ext cx="319500" cy="1008104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99" name="Textfeld 498"/>
            <p:cNvSpPr txBox="1"/>
            <p:nvPr/>
          </p:nvSpPr>
          <p:spPr>
            <a:xfrm>
              <a:off x="3250800" y="3492000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grpSp>
          <p:nvGrpSpPr>
            <p:cNvPr id="500" name="Gruppieren 499"/>
            <p:cNvGrpSpPr/>
            <p:nvPr/>
          </p:nvGrpSpPr>
          <p:grpSpPr>
            <a:xfrm>
              <a:off x="7812360" y="2951366"/>
              <a:ext cx="612376" cy="261610"/>
              <a:chOff x="2735488" y="4077072"/>
              <a:chExt cx="612376" cy="261610"/>
            </a:xfrm>
          </p:grpSpPr>
          <p:sp>
            <p:nvSpPr>
              <p:cNvPr id="501" name="Textfeld 500"/>
              <p:cNvSpPr txBox="1"/>
              <p:nvPr/>
            </p:nvSpPr>
            <p:spPr>
              <a:xfrm>
                <a:off x="2843192" y="407707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502" name="Textfeld 501"/>
              <p:cNvSpPr txBox="1"/>
              <p:nvPr/>
            </p:nvSpPr>
            <p:spPr>
              <a:xfrm>
                <a:off x="2951512" y="407707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503" name="Textfeld 502"/>
              <p:cNvSpPr txBox="1"/>
              <p:nvPr/>
            </p:nvSpPr>
            <p:spPr>
              <a:xfrm>
                <a:off x="2735488" y="407707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504" name="Gruppieren 503"/>
            <p:cNvGrpSpPr/>
            <p:nvPr/>
          </p:nvGrpSpPr>
          <p:grpSpPr>
            <a:xfrm>
              <a:off x="5364088" y="1988840"/>
              <a:ext cx="612376" cy="261610"/>
              <a:chOff x="2735488" y="4077072"/>
              <a:chExt cx="612376" cy="261610"/>
            </a:xfrm>
          </p:grpSpPr>
          <p:sp>
            <p:nvSpPr>
              <p:cNvPr id="505" name="Textfeld 504"/>
              <p:cNvSpPr txBox="1"/>
              <p:nvPr/>
            </p:nvSpPr>
            <p:spPr>
              <a:xfrm>
                <a:off x="2843192" y="407707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506" name="Textfeld 505"/>
              <p:cNvSpPr txBox="1"/>
              <p:nvPr/>
            </p:nvSpPr>
            <p:spPr>
              <a:xfrm>
                <a:off x="2951512" y="407707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507" name="Textfeld 506"/>
              <p:cNvSpPr txBox="1"/>
              <p:nvPr/>
            </p:nvSpPr>
            <p:spPr>
              <a:xfrm>
                <a:off x="2735488" y="407707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508" name="Gruppieren 507"/>
            <p:cNvGrpSpPr/>
            <p:nvPr/>
          </p:nvGrpSpPr>
          <p:grpSpPr>
            <a:xfrm>
              <a:off x="6598800" y="1772816"/>
              <a:ext cx="637496" cy="477634"/>
              <a:chOff x="3268352" y="2924944"/>
              <a:chExt cx="637496" cy="477634"/>
            </a:xfrm>
          </p:grpSpPr>
          <p:sp>
            <p:nvSpPr>
              <p:cNvPr id="509" name="Textfeld 508"/>
              <p:cNvSpPr txBox="1"/>
              <p:nvPr/>
            </p:nvSpPr>
            <p:spPr>
              <a:xfrm>
                <a:off x="3268352" y="2924944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510" name="Textfeld 509"/>
              <p:cNvSpPr txBox="1"/>
              <p:nvPr/>
            </p:nvSpPr>
            <p:spPr>
              <a:xfrm>
                <a:off x="3401792" y="314096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511" name="Textfeld 510"/>
              <p:cNvSpPr txBox="1"/>
              <p:nvPr/>
            </p:nvSpPr>
            <p:spPr>
              <a:xfrm>
                <a:off x="3509496" y="314096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512" name="Gruppieren 511"/>
            <p:cNvGrpSpPr/>
            <p:nvPr/>
          </p:nvGrpSpPr>
          <p:grpSpPr>
            <a:xfrm>
              <a:off x="7236296" y="1988840"/>
              <a:ext cx="612376" cy="261610"/>
              <a:chOff x="3311552" y="2708920"/>
              <a:chExt cx="612376" cy="261610"/>
            </a:xfrm>
          </p:grpSpPr>
          <p:sp>
            <p:nvSpPr>
              <p:cNvPr id="513" name="Textfeld 512"/>
              <p:cNvSpPr txBox="1"/>
              <p:nvPr/>
            </p:nvSpPr>
            <p:spPr>
              <a:xfrm>
                <a:off x="3311552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514" name="Textfeld 513"/>
              <p:cNvSpPr txBox="1"/>
              <p:nvPr/>
            </p:nvSpPr>
            <p:spPr>
              <a:xfrm>
                <a:off x="3419872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515" name="Textfeld 514"/>
              <p:cNvSpPr txBox="1"/>
              <p:nvPr/>
            </p:nvSpPr>
            <p:spPr>
              <a:xfrm>
                <a:off x="3527576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516" name="Gruppieren 515"/>
            <p:cNvGrpSpPr/>
            <p:nvPr/>
          </p:nvGrpSpPr>
          <p:grpSpPr>
            <a:xfrm>
              <a:off x="3707904" y="1772816"/>
              <a:ext cx="533152" cy="261610"/>
              <a:chOff x="1321200" y="1105580"/>
              <a:chExt cx="533152" cy="261610"/>
            </a:xfrm>
          </p:grpSpPr>
          <p:sp>
            <p:nvSpPr>
              <p:cNvPr id="517" name="Textfeld 516"/>
              <p:cNvSpPr txBox="1"/>
              <p:nvPr/>
            </p:nvSpPr>
            <p:spPr>
              <a:xfrm>
                <a:off x="1321200" y="110558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518" name="Textfeld 517"/>
              <p:cNvSpPr txBox="1"/>
              <p:nvPr/>
            </p:nvSpPr>
            <p:spPr>
              <a:xfrm>
                <a:off x="1458000" y="110558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519" name="Gruppieren 518"/>
            <p:cNvGrpSpPr/>
            <p:nvPr/>
          </p:nvGrpSpPr>
          <p:grpSpPr>
            <a:xfrm>
              <a:off x="1014512" y="935142"/>
              <a:ext cx="533152" cy="261610"/>
              <a:chOff x="1321200" y="1177588"/>
              <a:chExt cx="533152" cy="261610"/>
            </a:xfrm>
          </p:grpSpPr>
          <p:sp>
            <p:nvSpPr>
              <p:cNvPr id="520" name="Textfeld 519"/>
              <p:cNvSpPr txBox="1"/>
              <p:nvPr/>
            </p:nvSpPr>
            <p:spPr>
              <a:xfrm>
                <a:off x="1321200" y="117758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521" name="Textfeld 520"/>
              <p:cNvSpPr txBox="1"/>
              <p:nvPr/>
            </p:nvSpPr>
            <p:spPr>
              <a:xfrm>
                <a:off x="1458000" y="117758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sp>
          <p:nvSpPr>
            <p:cNvPr id="522" name="Textfeld 521"/>
            <p:cNvSpPr txBox="1"/>
            <p:nvPr/>
          </p:nvSpPr>
          <p:spPr>
            <a:xfrm>
              <a:off x="3834000" y="863134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sp>
          <p:nvSpPr>
            <p:cNvPr id="523" name="Textfeld 522"/>
            <p:cNvSpPr txBox="1"/>
            <p:nvPr/>
          </p:nvSpPr>
          <p:spPr>
            <a:xfrm>
              <a:off x="3715200" y="2519318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sp>
          <p:nvSpPr>
            <p:cNvPr id="525" name="Textfeld 524"/>
            <p:cNvSpPr txBox="1"/>
            <p:nvPr/>
          </p:nvSpPr>
          <p:spPr>
            <a:xfrm>
              <a:off x="3664800" y="3852000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sp>
          <p:nvSpPr>
            <p:cNvPr id="526" name="Textfeld 525"/>
            <p:cNvSpPr txBox="1"/>
            <p:nvPr/>
          </p:nvSpPr>
          <p:spPr>
            <a:xfrm>
              <a:off x="3733200" y="4428000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sp>
          <p:nvSpPr>
            <p:cNvPr id="527" name="Textfeld 526"/>
            <p:cNvSpPr txBox="1"/>
            <p:nvPr/>
          </p:nvSpPr>
          <p:spPr>
            <a:xfrm>
              <a:off x="3654000" y="5904000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sp>
          <p:nvSpPr>
            <p:cNvPr id="528" name="Textfeld 527"/>
            <p:cNvSpPr txBox="1"/>
            <p:nvPr/>
          </p:nvSpPr>
          <p:spPr>
            <a:xfrm>
              <a:off x="3780375" y="5580000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sp>
          <p:nvSpPr>
            <p:cNvPr id="529" name="Textfeld 528"/>
            <p:cNvSpPr txBox="1"/>
            <p:nvPr/>
          </p:nvSpPr>
          <p:spPr>
            <a:xfrm>
              <a:off x="7115128" y="6237312"/>
              <a:ext cx="1705344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endParaRPr lang="de-DE" sz="9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50000"/>
                </a:lnSpc>
              </a:pP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C      ADSC      MES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0" name="Rechteck 529"/>
            <p:cNvSpPr/>
            <p:nvPr/>
          </p:nvSpPr>
          <p:spPr>
            <a:xfrm>
              <a:off x="7542552" y="6563409"/>
              <a:ext cx="84756" cy="79200"/>
            </a:xfrm>
            <a:prstGeom prst="rect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531" name="Rechteck 530"/>
            <p:cNvSpPr/>
            <p:nvPr/>
          </p:nvSpPr>
          <p:spPr>
            <a:xfrm>
              <a:off x="7092280" y="6563409"/>
              <a:ext cx="84756" cy="79200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532" name="Rechteck 531"/>
            <p:cNvSpPr/>
            <p:nvPr/>
          </p:nvSpPr>
          <p:spPr>
            <a:xfrm>
              <a:off x="8028384" y="6563409"/>
              <a:ext cx="84756" cy="79200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</p:spTree>
    <p:extLst>
      <p:ext uri="{BB962C8B-B14F-4D97-AF65-F5344CB8AC3E}">
        <p14:creationId xmlns:p14="http://schemas.microsoft.com/office/powerpoint/2010/main" val="350414794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8</Words>
  <Application>Microsoft Office PowerPoint</Application>
  <PresentationFormat>Bildschirmpräsentation (4:3)</PresentationFormat>
  <Paragraphs>184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versitätsklinikum Erlang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eigand, Annika</dc:creator>
  <cp:lastModifiedBy>Weigand, Annika</cp:lastModifiedBy>
  <cp:revision>263</cp:revision>
  <cp:lastPrinted>2015-04-28T11:16:18Z</cp:lastPrinted>
  <dcterms:created xsi:type="dcterms:W3CDTF">2014-07-18T07:51:48Z</dcterms:created>
  <dcterms:modified xsi:type="dcterms:W3CDTF">2015-09-29T12:42:12Z</dcterms:modified>
</cp:coreProperties>
</file>